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notesSlides/notesSlide2.xml" ContentType="application/vnd.openxmlformats-officedocument.presentationml.notesSlid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charts/chart17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ppt/charts/chart18.xml" ContentType="application/vnd.openxmlformats-officedocument.drawingml.chart+xml"/>
  <Override PartName="/ppt/charts/style18.xml" ContentType="application/vnd.ms-office.chartstyle+xml"/>
  <Override PartName="/ppt/charts/colors18.xml" ContentType="application/vnd.ms-office.chartcolorstyle+xml"/>
  <Override PartName="/ppt/charts/chart19.xml" ContentType="application/vnd.openxmlformats-officedocument.drawingml.chart+xml"/>
  <Override PartName="/ppt/charts/style19.xml" ContentType="application/vnd.ms-office.chartstyle+xml"/>
  <Override PartName="/ppt/charts/colors19.xml" ContentType="application/vnd.ms-office.chartcolorstyle+xml"/>
  <Override PartName="/ppt/charts/chart20.xml" ContentType="application/vnd.openxmlformats-officedocument.drawingml.chart+xml"/>
  <Override PartName="/ppt/charts/style20.xml" ContentType="application/vnd.ms-office.chartstyle+xml"/>
  <Override PartName="/ppt/charts/colors20.xml" ContentType="application/vnd.ms-office.chartcolorstyle+xml"/>
  <Override PartName="/ppt/charts/chart21.xml" ContentType="application/vnd.openxmlformats-officedocument.drawingml.chart+xml"/>
  <Override PartName="/ppt/charts/style21.xml" ContentType="application/vnd.ms-office.chartstyle+xml"/>
  <Override PartName="/ppt/charts/colors21.xml" ContentType="application/vnd.ms-office.chartcolorstyle+xml"/>
  <Override PartName="/ppt/charts/chart22.xml" ContentType="application/vnd.openxmlformats-officedocument.drawingml.chart+xml"/>
  <Override PartName="/ppt/charts/style22.xml" ContentType="application/vnd.ms-office.chartstyle+xml"/>
  <Override PartName="/ppt/charts/colors22.xml" ContentType="application/vnd.ms-office.chartcolorstyle+xml"/>
  <Override PartName="/ppt/charts/chart23.xml" ContentType="application/vnd.openxmlformats-officedocument.drawingml.chart+xml"/>
  <Override PartName="/ppt/charts/style23.xml" ContentType="application/vnd.ms-office.chartstyle+xml"/>
  <Override PartName="/ppt/charts/colors23.xml" ContentType="application/vnd.ms-office.chartcolorstyle+xml"/>
  <Override PartName="/ppt/charts/chart24.xml" ContentType="application/vnd.openxmlformats-officedocument.drawingml.chart+xml"/>
  <Override PartName="/ppt/charts/style24.xml" ContentType="application/vnd.ms-office.chartstyle+xml"/>
  <Override PartName="/ppt/charts/colors24.xml" ContentType="application/vnd.ms-office.chartcolorstyle+xml"/>
  <Override PartName="/ppt/charts/chart25.xml" ContentType="application/vnd.openxmlformats-officedocument.drawingml.chart+xml"/>
  <Override PartName="/ppt/charts/style25.xml" ContentType="application/vnd.ms-office.chartstyle+xml"/>
  <Override PartName="/ppt/charts/colors25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3"/>
  </p:notesMasterIdLst>
  <p:sldIdLst>
    <p:sldId id="257" r:id="rId2"/>
    <p:sldId id="297" r:id="rId3"/>
    <p:sldId id="298" r:id="rId4"/>
    <p:sldId id="259" r:id="rId5"/>
    <p:sldId id="260" r:id="rId6"/>
    <p:sldId id="261" r:id="rId7"/>
    <p:sldId id="304" r:id="rId8"/>
    <p:sldId id="262" r:id="rId9"/>
    <p:sldId id="285" r:id="rId10"/>
    <p:sldId id="302" r:id="rId11"/>
    <p:sldId id="309" r:id="rId12"/>
    <p:sldId id="294" r:id="rId13"/>
    <p:sldId id="267" r:id="rId14"/>
    <p:sldId id="292" r:id="rId15"/>
    <p:sldId id="274" r:id="rId16"/>
    <p:sldId id="308" r:id="rId17"/>
    <p:sldId id="307" r:id="rId18"/>
    <p:sldId id="270" r:id="rId19"/>
    <p:sldId id="272" r:id="rId20"/>
    <p:sldId id="287" r:id="rId21"/>
    <p:sldId id="306" r:id="rId2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333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/>
    <p:restoredTop sz="94288" autoAdjust="0"/>
  </p:normalViewPr>
  <p:slideViewPr>
    <p:cSldViewPr snapToGrid="0">
      <p:cViewPr varScale="1">
        <p:scale>
          <a:sx n="82" d="100"/>
          <a:sy n="82" d="100"/>
        </p:scale>
        <p:origin x="702" y="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g\mine%20ex\ON%20GOING%20PROJECT\CO2%20&#44256;&#51221;\Data%20and%20Documents\protein%20concentration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g\mine%20ex\ON%20GOING%20PROJECT\CO2%20&#44256;&#51221;\Data%20and%20Documents\TM%20activity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g\mine%20ex\ON%20GOING%20PROJECT\CO2%20&#44256;&#51221;\Data%20and%20Documents\TM%20activity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g\mine%20ex\ON%20GOING%20PROJECT\CO2%20&#44256;&#51221;\Data%20and%20Documents\TM%20activity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g\mine%20ex\ON%20GOING%20PROJECT\CO2%20&#44256;&#51221;\Data%20and%20Documents\TM%20activity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g\mine%20ex\ON%20GOING%20PROJECT\CO2%20&#44256;&#51221;\Data%20and%20Documents\dls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g\mine%20ex\ON%20GOING%20PROJECT\CO2%20&#44256;&#51221;\Data%20and%20Documents\ROS.xlsx" TargetMode="External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g\mine%20ex\ON%20GOING%20PROJECT\CO2%20&#44256;&#51221;\Data%20and%20Documents\ROS.xlsx" TargetMode="External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g\mine%20ex\ON%20GOING%20PROJECT\CO2%20&#44256;&#51221;\Data%20and%20Documents\ROS.xlsx" TargetMode="External"/><Relationship Id="rId2" Type="http://schemas.microsoft.com/office/2011/relationships/chartColorStyle" Target="colors17.xml"/><Relationship Id="rId1" Type="http://schemas.microsoft.com/office/2011/relationships/chartStyle" Target="style17.xm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g\mine%20ex\ON%20GOING%20PROJECT\CO2%20&#44256;&#51221;\Data%20and%20Documents\TM%20activity.xlsx" TargetMode="External"/><Relationship Id="rId2" Type="http://schemas.microsoft.com/office/2011/relationships/chartColorStyle" Target="colors18.xml"/><Relationship Id="rId1" Type="http://schemas.microsoft.com/office/2011/relationships/chartStyle" Target="style18.xml"/></Relationships>
</file>

<file path=ppt/charts/_rels/chart1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g\mine%20ex\ON%20GOING%20PROJECT\CO2%20&#44256;&#51221;\Data%20and%20Documents\ROS.xlsx" TargetMode="External"/><Relationship Id="rId2" Type="http://schemas.microsoft.com/office/2011/relationships/chartColorStyle" Target="colors19.xml"/><Relationship Id="rId1" Type="http://schemas.microsoft.com/office/2011/relationships/chartStyle" Target="style19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g\mine%20ex\ON%20GOING%20PROJECT\CO2%20&#44256;&#51221;\Data%20and%20Documents\protein%20concentration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2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g\mine%20ex\ON%20GOING%20PROJECT\CO2%20&#44256;&#51221;\Data%20and%20Documents\ROS.xlsx" TargetMode="External"/><Relationship Id="rId2" Type="http://schemas.microsoft.com/office/2011/relationships/chartColorStyle" Target="colors20.xml"/><Relationship Id="rId1" Type="http://schemas.microsoft.com/office/2011/relationships/chartStyle" Target="style20.xml"/></Relationships>
</file>

<file path=ppt/charts/_rels/chart2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g\mine%20ex\ON%20GOING%20PROJECT\CO2%20&#44256;&#51221;\Data%20and%20Documents\ROS.xlsx" TargetMode="External"/><Relationship Id="rId2" Type="http://schemas.microsoft.com/office/2011/relationships/chartColorStyle" Target="colors21.xml"/><Relationship Id="rId1" Type="http://schemas.microsoft.com/office/2011/relationships/chartStyle" Target="style21.xml"/></Relationships>
</file>

<file path=ppt/charts/_rels/chart2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g\mine%20ex\ON%20GOING%20PROJECT\CO2%20&#44256;&#51221;\Data%20and%20Documents\ROS.xlsx" TargetMode="External"/><Relationship Id="rId2" Type="http://schemas.microsoft.com/office/2011/relationships/chartColorStyle" Target="colors22.xml"/><Relationship Id="rId1" Type="http://schemas.microsoft.com/office/2011/relationships/chartStyle" Target="style22.xml"/></Relationships>
</file>

<file path=ppt/charts/_rels/chart2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g\mine%20ex\ON%20GOING%20PROJECT\CO2%20&#44256;&#51221;\Data%20and%20Documents\ROS.xlsx" TargetMode="External"/><Relationship Id="rId2" Type="http://schemas.microsoft.com/office/2011/relationships/chartColorStyle" Target="colors23.xml"/><Relationship Id="rId1" Type="http://schemas.microsoft.com/office/2011/relationships/chartStyle" Target="style23.xml"/></Relationships>
</file>

<file path=ppt/charts/_rels/chart2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g\mine%20ex\ON%20GOING%20PROJECT\CO2%20&#44256;&#51221;\Data%20and%20Documents\enzyme%20activity.xlsx" TargetMode="External"/><Relationship Id="rId2" Type="http://schemas.microsoft.com/office/2011/relationships/chartColorStyle" Target="colors24.xml"/><Relationship Id="rId1" Type="http://schemas.microsoft.com/office/2011/relationships/chartStyle" Target="style24.xml"/></Relationships>
</file>

<file path=ppt/charts/_rels/chart2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g\mine%20ex\ON%20GOING%20PROJECT\CO2%20&#44256;&#51221;\Data%20and%20Documents\ROS.xlsx" TargetMode="External"/><Relationship Id="rId2" Type="http://schemas.microsoft.com/office/2011/relationships/chartColorStyle" Target="colors25.xml"/><Relationship Id="rId1" Type="http://schemas.microsoft.com/office/2011/relationships/chartStyle" Target="style25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Rhee%20Choi\Desktop\&#49892;&#54744;\&#54028;&#51060;&#50724;&#45768;&#50612;\Data\activity%20of%20TM\160415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g\mine%20ex\ON%20GOING%20PROJECT\CO2%20&#44256;&#51221;\Data%20and%20Documents\TM%20activity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g\mine%20ex\ON%20GOING%20PROJECT\CO2%20&#44256;&#51221;\Data%20and%20Documents\TM%20activity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g\mine%20ex\ON%20GOING%20PROJECT\CO2%20&#44256;&#51221;\Data%20and%20Documents\TM%20activity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g\mine%20ex\ON%20GOING%20PROJECT\CO2%20&#44256;&#51221;\Data%20and%20Documents\TM%20activity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g\mine%20ex\ON%20GOING%20PROJECT\CO2%20&#44256;&#51221;\Data%20and%20Documents\TM%20activity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g\mine%20ex\ON%20GOING%20PROJECT\CO2%20&#44256;&#51221;\Data%20and%20Documents\TM%20activity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084648257725181"/>
          <c:y val="4.7200558649946316E-2"/>
          <c:w val="0.77929815910585143"/>
          <c:h val="0.7336100837847257"/>
        </c:manualLayout>
      </c:layout>
      <c:scatterChart>
        <c:scatterStyle val="smoothMarker"/>
        <c:varyColors val="0"/>
        <c:ser>
          <c:idx val="1"/>
          <c:order val="0"/>
          <c:tx>
            <c:strRef>
              <c:f>Sheet5!$B$17</c:f>
              <c:strCache>
                <c:ptCount val="1"/>
                <c:pt idx="0">
                  <c:v>1,000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5!$C$15:$G$15</c:f>
              <c:numCache>
                <c:formatCode>General</c:formatCode>
                <c:ptCount val="5"/>
                <c:pt idx="0">
                  <c:v>0</c:v>
                </c:pt>
                <c:pt idx="1">
                  <c:v>3.0768999999999997</c:v>
                </c:pt>
                <c:pt idx="2">
                  <c:v>6.1537999999999995</c:v>
                </c:pt>
                <c:pt idx="3">
                  <c:v>12.307599999999999</c:v>
                </c:pt>
                <c:pt idx="4">
                  <c:v>24.615199999999998</c:v>
                </c:pt>
              </c:numCache>
            </c:numRef>
          </c:xVal>
          <c:yVal>
            <c:numRef>
              <c:f>Sheet5!$C$17:$G$17</c:f>
              <c:numCache>
                <c:formatCode>General</c:formatCode>
                <c:ptCount val="5"/>
                <c:pt idx="0">
                  <c:v>0</c:v>
                </c:pt>
                <c:pt idx="1">
                  <c:v>0.98890000000000011</c:v>
                </c:pt>
                <c:pt idx="2">
                  <c:v>1.9778000000000002</c:v>
                </c:pt>
                <c:pt idx="3">
                  <c:v>3.4916</c:v>
                </c:pt>
                <c:pt idx="4">
                  <c:v>3.735199999999999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DE5F-421C-B707-8D0562628004}"/>
            </c:ext>
          </c:extLst>
        </c:ser>
        <c:ser>
          <c:idx val="0"/>
          <c:order val="1"/>
          <c:tx>
            <c:strRef>
              <c:f>Sheet5!$B$16</c:f>
              <c:strCache>
                <c:ptCount val="1"/>
                <c:pt idx="0">
                  <c:v>500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triangl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5!$C$15:$G$15</c:f>
              <c:numCache>
                <c:formatCode>General</c:formatCode>
                <c:ptCount val="5"/>
                <c:pt idx="0">
                  <c:v>0</c:v>
                </c:pt>
                <c:pt idx="1">
                  <c:v>3.0768999999999997</c:v>
                </c:pt>
                <c:pt idx="2">
                  <c:v>6.1537999999999995</c:v>
                </c:pt>
                <c:pt idx="3">
                  <c:v>12.307599999999999</c:v>
                </c:pt>
                <c:pt idx="4">
                  <c:v>24.615199999999998</c:v>
                </c:pt>
              </c:numCache>
            </c:numRef>
          </c:xVal>
          <c:yVal>
            <c:numRef>
              <c:f>Sheet5!$C$16:$G$16</c:f>
              <c:numCache>
                <c:formatCode>General</c:formatCode>
                <c:ptCount val="5"/>
                <c:pt idx="0">
                  <c:v>0</c:v>
                </c:pt>
                <c:pt idx="1">
                  <c:v>0.90189999999999992</c:v>
                </c:pt>
                <c:pt idx="2">
                  <c:v>1.7458</c:v>
                </c:pt>
                <c:pt idx="3">
                  <c:v>1.8676000000000013</c:v>
                </c:pt>
                <c:pt idx="4">
                  <c:v>1.9371999999999971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1-DE5F-421C-B707-8D056262800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54099456"/>
        <c:axId val="-54086400"/>
      </c:scatterChart>
      <c:valAx>
        <c:axId val="-5409945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54086400"/>
        <c:crosses val="autoZero"/>
        <c:crossBetween val="midCat"/>
      </c:valAx>
      <c:valAx>
        <c:axId val="-54086400"/>
        <c:scaling>
          <c:orientation val="minMax"/>
        </c:scaling>
        <c:delete val="0"/>
        <c:axPos val="l"/>
        <c:numFmt formatCode="General" sourceLinked="1"/>
        <c:majorTickMark val="out"/>
        <c:minorTickMark val="in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54099456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3746201473336539"/>
          <c:y val="0.61981292375883579"/>
          <c:w val="0.27680692817725805"/>
          <c:h val="0.1248798379200247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 b="1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8130837755901"/>
          <c:y val="3.3416962992430098E-2"/>
          <c:w val="0.72715129924063204"/>
          <c:h val="0.8234426424763390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5!$E$210:$E$214</c:f>
                <c:numCache>
                  <c:formatCode>General</c:formatCode>
                  <c:ptCount val="5"/>
                  <c:pt idx="0">
                    <c:v>5.2030000000000003</c:v>
                  </c:pt>
                  <c:pt idx="1">
                    <c:v>2.09</c:v>
                  </c:pt>
                  <c:pt idx="2">
                    <c:v>3.52</c:v>
                  </c:pt>
                  <c:pt idx="3">
                    <c:v>1.98</c:v>
                  </c:pt>
                  <c:pt idx="4">
                    <c:v>1.65</c:v>
                  </c:pt>
                </c:numCache>
              </c:numRef>
            </c:plus>
            <c:minus>
              <c:numRef>
                <c:f>Sheet5!$E$210:$E$214</c:f>
                <c:numCache>
                  <c:formatCode>General</c:formatCode>
                  <c:ptCount val="5"/>
                  <c:pt idx="0">
                    <c:v>5.2030000000000003</c:v>
                  </c:pt>
                  <c:pt idx="1">
                    <c:v>2.09</c:v>
                  </c:pt>
                  <c:pt idx="2">
                    <c:v>3.52</c:v>
                  </c:pt>
                  <c:pt idx="3">
                    <c:v>1.98</c:v>
                  </c:pt>
                  <c:pt idx="4">
                    <c:v>1.6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5!$B$210:$B$214</c:f>
              <c:numCache>
                <c:formatCode>General</c:formatCode>
                <c:ptCount val="5"/>
                <c:pt idx="0">
                  <c:v>0</c:v>
                </c:pt>
                <c:pt idx="1">
                  <c:v>1</c:v>
                </c:pt>
                <c:pt idx="2">
                  <c:v>2.5</c:v>
                </c:pt>
                <c:pt idx="3">
                  <c:v>5</c:v>
                </c:pt>
                <c:pt idx="4">
                  <c:v>10</c:v>
                </c:pt>
              </c:numCache>
            </c:numRef>
          </c:cat>
          <c:val>
            <c:numRef>
              <c:f>Sheet5!$D$210:$D$214</c:f>
              <c:numCache>
                <c:formatCode>General</c:formatCode>
                <c:ptCount val="5"/>
                <c:pt idx="0">
                  <c:v>52.03</c:v>
                </c:pt>
                <c:pt idx="1">
                  <c:v>41.8</c:v>
                </c:pt>
                <c:pt idx="2">
                  <c:v>35.200000000000003</c:v>
                </c:pt>
                <c:pt idx="3">
                  <c:v>19.8</c:v>
                </c:pt>
                <c:pt idx="4">
                  <c:v>16.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6AFC-4DC8-86B2-DD2E828B9FD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3804320"/>
        <c:axId val="-3803776"/>
      </c:barChart>
      <c:catAx>
        <c:axId val="-38043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defRPr>
            </a:pPr>
            <a:endParaRPr lang="en-US"/>
          </a:p>
        </c:txPr>
        <c:crossAx val="-3803776"/>
        <c:crosses val="autoZero"/>
        <c:auto val="1"/>
        <c:lblAlgn val="ctr"/>
        <c:lblOffset val="100"/>
        <c:noMultiLvlLbl val="0"/>
      </c:catAx>
      <c:valAx>
        <c:axId val="-3803776"/>
        <c:scaling>
          <c:orientation val="minMax"/>
          <c:max val="60"/>
        </c:scaling>
        <c:delete val="0"/>
        <c:axPos val="l"/>
        <c:numFmt formatCode="General" sourceLinked="1"/>
        <c:majorTickMark val="out"/>
        <c:minorTickMark val="in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defRPr>
            </a:pPr>
            <a:endParaRPr lang="en-US"/>
          </a:p>
        </c:txPr>
        <c:crossAx val="-38043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 b="1">
          <a:solidFill>
            <a:schemeClr val="tx1"/>
          </a:solidFill>
          <a:latin typeface="Times New Roman" panose="02020603050405020304" pitchFamily="18" charset="0"/>
          <a:ea typeface="HY신명조" panose="02030600000101010101" pitchFamily="18" charset="-127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054374430697"/>
          <c:y val="5.5950733452025399E-2"/>
          <c:w val="0.70629582054687778"/>
          <c:h val="0.81951185924621694"/>
        </c:manualLayout>
      </c:layout>
      <c:barChart>
        <c:barDir val="col"/>
        <c:grouping val="clustered"/>
        <c:varyColors val="0"/>
        <c:ser>
          <c:idx val="1"/>
          <c:order val="1"/>
          <c:tx>
            <c:strRef>
              <c:f>Sheet6!$K$65</c:f>
              <c:strCache>
                <c:ptCount val="1"/>
                <c:pt idx="0">
                  <c:v>tCMV activity</c:v>
                </c:pt>
              </c:strCache>
            </c:strRef>
          </c:tx>
          <c:spPr>
            <a:noFill/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6!$B$75:$H$75</c:f>
                <c:numCache>
                  <c:formatCode>General</c:formatCode>
                  <c:ptCount val="7"/>
                  <c:pt idx="0">
                    <c:v>4.5833333333333233</c:v>
                  </c:pt>
                  <c:pt idx="1">
                    <c:v>3.7499999999999698</c:v>
                  </c:pt>
                  <c:pt idx="2">
                    <c:v>4.5833333333333233</c:v>
                  </c:pt>
                  <c:pt idx="3">
                    <c:v>3.7499999999999698</c:v>
                  </c:pt>
                  <c:pt idx="4">
                    <c:v>6.6666666666666581</c:v>
                  </c:pt>
                  <c:pt idx="5">
                    <c:v>2.0833333333333361</c:v>
                  </c:pt>
                  <c:pt idx="6">
                    <c:v>4.1666666666666634</c:v>
                  </c:pt>
                </c:numCache>
              </c:numRef>
            </c:plus>
            <c:minus>
              <c:numRef>
                <c:f>Sheet6!$B$75:$H$75</c:f>
                <c:numCache>
                  <c:formatCode>General</c:formatCode>
                  <c:ptCount val="7"/>
                  <c:pt idx="0">
                    <c:v>4.5833333333333233</c:v>
                  </c:pt>
                  <c:pt idx="1">
                    <c:v>3.7499999999999698</c:v>
                  </c:pt>
                  <c:pt idx="2">
                    <c:v>4.5833333333333233</c:v>
                  </c:pt>
                  <c:pt idx="3">
                    <c:v>3.7499999999999698</c:v>
                  </c:pt>
                  <c:pt idx="4">
                    <c:v>6.6666666666666581</c:v>
                  </c:pt>
                  <c:pt idx="5">
                    <c:v>2.0833333333333361</c:v>
                  </c:pt>
                  <c:pt idx="6">
                    <c:v>4.166666666666663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6!$L$63:$R$63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25</c:v>
                </c:pt>
                <c:pt idx="3">
                  <c:v>0.5</c:v>
                </c:pt>
                <c:pt idx="4">
                  <c:v>1</c:v>
                </c:pt>
                <c:pt idx="5">
                  <c:v>5</c:v>
                </c:pt>
                <c:pt idx="6">
                  <c:v>10</c:v>
                </c:pt>
              </c:numCache>
            </c:numRef>
          </c:cat>
          <c:val>
            <c:numRef>
              <c:f>Sheet6!$L$65:$R$65</c:f>
              <c:numCache>
                <c:formatCode>General</c:formatCode>
                <c:ptCount val="7"/>
                <c:pt idx="0">
                  <c:v>100</c:v>
                </c:pt>
                <c:pt idx="1">
                  <c:v>100</c:v>
                </c:pt>
                <c:pt idx="2">
                  <c:v>101.2077294685992</c:v>
                </c:pt>
                <c:pt idx="3">
                  <c:v>100</c:v>
                </c:pt>
                <c:pt idx="4">
                  <c:v>98.792270531400689</c:v>
                </c:pt>
                <c:pt idx="5">
                  <c:v>103.62318840579699</c:v>
                </c:pt>
                <c:pt idx="6">
                  <c:v>97.5845410628020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0CF7-4FA6-A13C-3C6A937AE81B}"/>
            </c:ext>
          </c:extLst>
        </c:ser>
        <c:ser>
          <c:idx val="2"/>
          <c:order val="2"/>
          <c:tx>
            <c:strRef>
              <c:f>Sheet6!$K$66</c:f>
              <c:strCache>
                <c:ptCount val="1"/>
                <c:pt idx="0">
                  <c:v>biosilicificated tCMV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numRef>
              <c:f>Sheet6!$L$63:$R$63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25</c:v>
                </c:pt>
                <c:pt idx="3">
                  <c:v>0.5</c:v>
                </c:pt>
                <c:pt idx="4">
                  <c:v>1</c:v>
                </c:pt>
                <c:pt idx="5">
                  <c:v>5</c:v>
                </c:pt>
                <c:pt idx="6">
                  <c:v>10</c:v>
                </c:pt>
              </c:numCache>
            </c:numRef>
          </c:cat>
          <c:val>
            <c:numRef>
              <c:f>Sheet6!$L$66:$R$66</c:f>
              <c:numCache>
                <c:formatCode>General</c:formatCode>
                <c:ptCount val="7"/>
                <c:pt idx="0">
                  <c:v>0</c:v>
                </c:pt>
                <c:pt idx="1">
                  <c:v>52.631578947368418</c:v>
                </c:pt>
                <c:pt idx="2">
                  <c:v>90.526315789473671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94.7368421052631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0CF7-4FA6-A13C-3C6A937AE81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3796160"/>
        <c:axId val="-3791808"/>
      </c:barChart>
      <c:barChart>
        <c:barDir val="col"/>
        <c:grouping val="clustered"/>
        <c:varyColors val="0"/>
        <c:ser>
          <c:idx val="0"/>
          <c:order val="0"/>
          <c:tx>
            <c:strRef>
              <c:f>Sheet6!$K$64</c:f>
              <c:strCache>
                <c:ptCount val="1"/>
                <c:pt idx="0">
                  <c:v>tCMV activity</c:v>
                </c:pt>
              </c:strCache>
            </c:strRef>
          </c:tx>
          <c:spPr>
            <a:noFill/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numRef>
              <c:f>Sheet6!$L$63:$R$63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25</c:v>
                </c:pt>
                <c:pt idx="3">
                  <c:v>0.5</c:v>
                </c:pt>
                <c:pt idx="4">
                  <c:v>1</c:v>
                </c:pt>
                <c:pt idx="5">
                  <c:v>5</c:v>
                </c:pt>
                <c:pt idx="6">
                  <c:v>10</c:v>
                </c:pt>
              </c:numCache>
            </c:numRef>
          </c:cat>
          <c:val>
            <c:numRef>
              <c:f>Sheet6!$L$64:$R$64</c:f>
              <c:numCache>
                <c:formatCode>General</c:formatCode>
                <c:ptCount val="7"/>
                <c:pt idx="0">
                  <c:v>100</c:v>
                </c:pt>
                <c:pt idx="1">
                  <c:v>100</c:v>
                </c:pt>
                <c:pt idx="2">
                  <c:v>101.2077294685992</c:v>
                </c:pt>
                <c:pt idx="3">
                  <c:v>100</c:v>
                </c:pt>
                <c:pt idx="4">
                  <c:v>98.792270531400689</c:v>
                </c:pt>
                <c:pt idx="5">
                  <c:v>103.62318840579699</c:v>
                </c:pt>
                <c:pt idx="6">
                  <c:v>97.5845410628020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0CF7-4FA6-A13C-3C6A937AE81B}"/>
            </c:ext>
          </c:extLst>
        </c:ser>
        <c:ser>
          <c:idx val="3"/>
          <c:order val="3"/>
          <c:tx>
            <c:strRef>
              <c:f>Sheet6!$K$67</c:f>
              <c:strCache>
                <c:ptCount val="1"/>
                <c:pt idx="0">
                  <c:v>biosilicificated tCMV</c:v>
                </c:pt>
              </c:strCache>
            </c:strRef>
          </c:tx>
          <c:spPr>
            <a:solidFill>
              <a:schemeClr val="accent3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6!$B$81:$H$81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2.6315789473684208</c:v>
                  </c:pt>
                  <c:pt idx="2">
                    <c:v>4.5263157894736841</c:v>
                  </c:pt>
                  <c:pt idx="3">
                    <c:v>5</c:v>
                  </c:pt>
                  <c:pt idx="4">
                    <c:v>5</c:v>
                  </c:pt>
                  <c:pt idx="5">
                    <c:v>5</c:v>
                  </c:pt>
                  <c:pt idx="6">
                    <c:v>4.7368421052631602</c:v>
                  </c:pt>
                </c:numCache>
              </c:numRef>
            </c:plus>
            <c:minus>
              <c:numRef>
                <c:f>Sheet6!$B$81:$H$81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2.6315789473684208</c:v>
                  </c:pt>
                  <c:pt idx="2">
                    <c:v>4.5263157894736841</c:v>
                  </c:pt>
                  <c:pt idx="3">
                    <c:v>5</c:v>
                  </c:pt>
                  <c:pt idx="4">
                    <c:v>5</c:v>
                  </c:pt>
                  <c:pt idx="5">
                    <c:v>5</c:v>
                  </c:pt>
                  <c:pt idx="6">
                    <c:v>4.736842105263160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6!$L$63:$R$63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25</c:v>
                </c:pt>
                <c:pt idx="3">
                  <c:v>0.5</c:v>
                </c:pt>
                <c:pt idx="4">
                  <c:v>1</c:v>
                </c:pt>
                <c:pt idx="5">
                  <c:v>5</c:v>
                </c:pt>
                <c:pt idx="6">
                  <c:v>10</c:v>
                </c:pt>
              </c:numCache>
            </c:numRef>
          </c:cat>
          <c:val>
            <c:numRef>
              <c:f>Sheet6!$L$67:$R$67</c:f>
              <c:numCache>
                <c:formatCode>General</c:formatCode>
                <c:ptCount val="7"/>
                <c:pt idx="0">
                  <c:v>0</c:v>
                </c:pt>
                <c:pt idx="1">
                  <c:v>52.631578947368418</c:v>
                </c:pt>
                <c:pt idx="2">
                  <c:v>90.526315789473671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94.7368421052631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0CF7-4FA6-A13C-3C6A937AE81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3791264"/>
        <c:axId val="-3795616"/>
      </c:barChart>
      <c:catAx>
        <c:axId val="-379616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3791808"/>
        <c:crosses val="autoZero"/>
        <c:auto val="1"/>
        <c:lblAlgn val="ctr"/>
        <c:lblOffset val="100"/>
        <c:noMultiLvlLbl val="0"/>
      </c:catAx>
      <c:valAx>
        <c:axId val="-3791808"/>
        <c:scaling>
          <c:orientation val="minMax"/>
          <c:max val="110"/>
          <c:min val="0"/>
        </c:scaling>
        <c:delete val="0"/>
        <c:axPos val="l"/>
        <c:numFmt formatCode="General" sourceLinked="1"/>
        <c:majorTickMark val="out"/>
        <c:minorTickMark val="in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3796160"/>
        <c:crosses val="autoZero"/>
        <c:crossBetween val="between"/>
      </c:valAx>
      <c:valAx>
        <c:axId val="-3795616"/>
        <c:scaling>
          <c:orientation val="minMax"/>
          <c:max val="110"/>
          <c:min val="0"/>
        </c:scaling>
        <c:delete val="0"/>
        <c:axPos val="r"/>
        <c:numFmt formatCode="General" sourceLinked="1"/>
        <c:majorTickMark val="out"/>
        <c:minorTickMark val="in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3791264"/>
        <c:crosses val="max"/>
        <c:crossBetween val="between"/>
      </c:valAx>
      <c:catAx>
        <c:axId val="-3791264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-3795616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 b="1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667510680459262"/>
          <c:y val="5.3593592193393803E-2"/>
          <c:w val="0.79117783692704857"/>
          <c:h val="0.78703022892840702"/>
        </c:manualLayout>
      </c:layout>
      <c:barChart>
        <c:barDir val="col"/>
        <c:grouping val="clustered"/>
        <c:varyColors val="0"/>
        <c:ser>
          <c:idx val="1"/>
          <c:order val="1"/>
          <c:tx>
            <c:strRef>
              <c:f>Sheet6!$N$17</c:f>
              <c:strCache>
                <c:ptCount val="1"/>
                <c:pt idx="0">
                  <c:v>tCMV activity</c:v>
                </c:pt>
              </c:strCache>
            </c:strRef>
          </c:tx>
          <c:spPr>
            <a:noFill/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6!$B$31:$K$31</c:f>
                <c:numCache>
                  <c:formatCode>General</c:formatCode>
                  <c:ptCount val="10"/>
                  <c:pt idx="0">
                    <c:v>2.875</c:v>
                  </c:pt>
                  <c:pt idx="1">
                    <c:v>4.791666666666667</c:v>
                  </c:pt>
                  <c:pt idx="2">
                    <c:v>1.930555555555556</c:v>
                  </c:pt>
                  <c:pt idx="3">
                    <c:v>3.8333333333333339</c:v>
                  </c:pt>
                  <c:pt idx="4">
                    <c:v>5.8333333333333339</c:v>
                  </c:pt>
                  <c:pt idx="5">
                    <c:v>1.9444444444444451</c:v>
                  </c:pt>
                  <c:pt idx="6">
                    <c:v>4.8611111111111116</c:v>
                  </c:pt>
                  <c:pt idx="7">
                    <c:v>4.8611111111111116</c:v>
                  </c:pt>
                  <c:pt idx="8">
                    <c:v>5</c:v>
                  </c:pt>
                  <c:pt idx="9">
                    <c:v>5</c:v>
                  </c:pt>
                </c:numCache>
              </c:numRef>
            </c:plus>
            <c:minus>
              <c:numRef>
                <c:f>Sheet6!$B$31:$K$31</c:f>
                <c:numCache>
                  <c:formatCode>General</c:formatCode>
                  <c:ptCount val="10"/>
                  <c:pt idx="0">
                    <c:v>2.875</c:v>
                  </c:pt>
                  <c:pt idx="1">
                    <c:v>4.791666666666667</c:v>
                  </c:pt>
                  <c:pt idx="2">
                    <c:v>1.930555555555556</c:v>
                  </c:pt>
                  <c:pt idx="3">
                    <c:v>3.8333333333333339</c:v>
                  </c:pt>
                  <c:pt idx="4">
                    <c:v>5.8333333333333339</c:v>
                  </c:pt>
                  <c:pt idx="5">
                    <c:v>1.9444444444444451</c:v>
                  </c:pt>
                  <c:pt idx="6">
                    <c:v>4.8611111111111116</c:v>
                  </c:pt>
                  <c:pt idx="7">
                    <c:v>4.8611111111111116</c:v>
                  </c:pt>
                  <c:pt idx="8">
                    <c:v>5</c:v>
                  </c:pt>
                  <c:pt idx="9">
                    <c:v>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6!$O$15:$X$15</c:f>
              <c:numCache>
                <c:formatCode>General</c:formatCode>
                <c:ptCount val="10"/>
                <c:pt idx="0">
                  <c:v>0</c:v>
                </c:pt>
                <c:pt idx="1">
                  <c:v>0.1</c:v>
                </c:pt>
                <c:pt idx="2">
                  <c:v>0.25</c:v>
                </c:pt>
                <c:pt idx="3">
                  <c:v>0.5</c:v>
                </c:pt>
                <c:pt idx="4">
                  <c:v>1</c:v>
                </c:pt>
                <c:pt idx="5">
                  <c:v>2.5</c:v>
                </c:pt>
                <c:pt idx="6">
                  <c:v>5</c:v>
                </c:pt>
                <c:pt idx="7">
                  <c:v>10</c:v>
                </c:pt>
                <c:pt idx="8">
                  <c:v>25</c:v>
                </c:pt>
                <c:pt idx="9">
                  <c:v>50</c:v>
                </c:pt>
              </c:numCache>
            </c:numRef>
          </c:cat>
          <c:val>
            <c:numRef>
              <c:f>Sheet6!$O$17:$X$17</c:f>
              <c:numCache>
                <c:formatCode>General</c:formatCode>
                <c:ptCount val="10"/>
                <c:pt idx="0">
                  <c:v>95.833333333333329</c:v>
                </c:pt>
                <c:pt idx="1">
                  <c:v>95.833333333333329</c:v>
                </c:pt>
                <c:pt idx="2">
                  <c:v>96.527777777777771</c:v>
                </c:pt>
                <c:pt idx="3">
                  <c:v>95.833333333333329</c:v>
                </c:pt>
                <c:pt idx="4">
                  <c:v>97.222222222222243</c:v>
                </c:pt>
                <c:pt idx="5">
                  <c:v>97.222222222222243</c:v>
                </c:pt>
                <c:pt idx="6">
                  <c:v>97.222222222222243</c:v>
                </c:pt>
                <c:pt idx="7">
                  <c:v>97.222222222222243</c:v>
                </c:pt>
                <c:pt idx="8">
                  <c:v>100</c:v>
                </c:pt>
                <c:pt idx="9">
                  <c:v>10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F4C8-4AF3-ABF8-17D8D4F8982D}"/>
            </c:ext>
          </c:extLst>
        </c:ser>
        <c:ser>
          <c:idx val="2"/>
          <c:order val="2"/>
          <c:tx>
            <c:strRef>
              <c:f>Sheet6!$N$18</c:f>
              <c:strCache>
                <c:ptCount val="1"/>
                <c:pt idx="0">
                  <c:v>biosilicificated tCMV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numRef>
              <c:f>Sheet6!$O$15:$X$15</c:f>
              <c:numCache>
                <c:formatCode>General</c:formatCode>
                <c:ptCount val="10"/>
                <c:pt idx="0">
                  <c:v>0</c:v>
                </c:pt>
                <c:pt idx="1">
                  <c:v>0.1</c:v>
                </c:pt>
                <c:pt idx="2">
                  <c:v>0.25</c:v>
                </c:pt>
                <c:pt idx="3">
                  <c:v>0.5</c:v>
                </c:pt>
                <c:pt idx="4">
                  <c:v>1</c:v>
                </c:pt>
                <c:pt idx="5">
                  <c:v>2.5</c:v>
                </c:pt>
                <c:pt idx="6">
                  <c:v>5</c:v>
                </c:pt>
                <c:pt idx="7">
                  <c:v>10</c:v>
                </c:pt>
                <c:pt idx="8">
                  <c:v>25</c:v>
                </c:pt>
                <c:pt idx="9">
                  <c:v>50</c:v>
                </c:pt>
              </c:numCache>
            </c:numRef>
          </c:cat>
          <c:val>
            <c:numRef>
              <c:f>Sheet6!$O$18:$X$18</c:f>
              <c:numCache>
                <c:formatCode>General</c:formatCode>
                <c:ptCount val="10"/>
                <c:pt idx="0">
                  <c:v>0</c:v>
                </c:pt>
                <c:pt idx="1">
                  <c:v>5.85299455535388</c:v>
                </c:pt>
                <c:pt idx="2">
                  <c:v>4.9455535390199667</c:v>
                </c:pt>
                <c:pt idx="3">
                  <c:v>7.6678765880217572</c:v>
                </c:pt>
                <c:pt idx="4">
                  <c:v>10.617059891107059</c:v>
                </c:pt>
                <c:pt idx="5">
                  <c:v>14.01996370235935</c:v>
                </c:pt>
                <c:pt idx="6">
                  <c:v>14.473684210526301</c:v>
                </c:pt>
                <c:pt idx="7">
                  <c:v>95.462794918330303</c:v>
                </c:pt>
                <c:pt idx="8">
                  <c:v>100</c:v>
                </c:pt>
                <c:pt idx="9">
                  <c:v>74.36479128856623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F4C8-4AF3-ABF8-17D8D4F8982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3794528"/>
        <c:axId val="-3802144"/>
      </c:barChart>
      <c:barChart>
        <c:barDir val="col"/>
        <c:grouping val="clustered"/>
        <c:varyColors val="0"/>
        <c:ser>
          <c:idx val="0"/>
          <c:order val="0"/>
          <c:tx>
            <c:strRef>
              <c:f>Sheet6!$N$16</c:f>
              <c:strCache>
                <c:ptCount val="1"/>
                <c:pt idx="0">
                  <c:v>tCMV activity</c:v>
                </c:pt>
              </c:strCache>
            </c:strRef>
          </c:tx>
          <c:spPr>
            <a:noFill/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numRef>
              <c:f>Sheet6!$O$15:$X$15</c:f>
              <c:numCache>
                <c:formatCode>General</c:formatCode>
                <c:ptCount val="10"/>
                <c:pt idx="0">
                  <c:v>0</c:v>
                </c:pt>
                <c:pt idx="1">
                  <c:v>0.1</c:v>
                </c:pt>
                <c:pt idx="2">
                  <c:v>0.25</c:v>
                </c:pt>
                <c:pt idx="3">
                  <c:v>0.5</c:v>
                </c:pt>
                <c:pt idx="4">
                  <c:v>1</c:v>
                </c:pt>
                <c:pt idx="5">
                  <c:v>2.5</c:v>
                </c:pt>
                <c:pt idx="6">
                  <c:v>5</c:v>
                </c:pt>
                <c:pt idx="7">
                  <c:v>10</c:v>
                </c:pt>
                <c:pt idx="8">
                  <c:v>25</c:v>
                </c:pt>
                <c:pt idx="9">
                  <c:v>50</c:v>
                </c:pt>
              </c:numCache>
            </c:numRef>
          </c:cat>
          <c:val>
            <c:numRef>
              <c:f>Sheet6!$O$16:$X$16</c:f>
              <c:numCache>
                <c:formatCode>General</c:formatCode>
                <c:ptCount val="10"/>
                <c:pt idx="0">
                  <c:v>95.833333333333329</c:v>
                </c:pt>
                <c:pt idx="1">
                  <c:v>95.833333333333329</c:v>
                </c:pt>
                <c:pt idx="2">
                  <c:v>96.527777777777771</c:v>
                </c:pt>
                <c:pt idx="3">
                  <c:v>95.833333333333329</c:v>
                </c:pt>
                <c:pt idx="4">
                  <c:v>97.222222222222243</c:v>
                </c:pt>
                <c:pt idx="5">
                  <c:v>97.222222222222243</c:v>
                </c:pt>
                <c:pt idx="6">
                  <c:v>97.222222222222243</c:v>
                </c:pt>
                <c:pt idx="7">
                  <c:v>97.222222222222243</c:v>
                </c:pt>
                <c:pt idx="8">
                  <c:v>100</c:v>
                </c:pt>
                <c:pt idx="9">
                  <c:v>10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F4C8-4AF3-ABF8-17D8D4F8982D}"/>
            </c:ext>
          </c:extLst>
        </c:ser>
        <c:ser>
          <c:idx val="3"/>
          <c:order val="3"/>
          <c:tx>
            <c:strRef>
              <c:f>Sheet6!$N$19</c:f>
              <c:strCache>
                <c:ptCount val="1"/>
                <c:pt idx="0">
                  <c:v>biosilicificated tCMV</c:v>
                </c:pt>
              </c:strCache>
            </c:strRef>
          </c:tx>
          <c:spPr>
            <a:solidFill>
              <a:schemeClr val="accent3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6!$B$27:$K$27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0.29264972776769399</c:v>
                  </c:pt>
                  <c:pt idx="2">
                    <c:v>0.247277676950998</c:v>
                  </c:pt>
                  <c:pt idx="3">
                    <c:v>0.38339382940108802</c:v>
                  </c:pt>
                  <c:pt idx="4">
                    <c:v>0.53085299455535295</c:v>
                  </c:pt>
                  <c:pt idx="5">
                    <c:v>0.70099818511796697</c:v>
                  </c:pt>
                  <c:pt idx="6">
                    <c:v>0.72368421052631504</c:v>
                  </c:pt>
                  <c:pt idx="7">
                    <c:v>4.7731397459165148</c:v>
                  </c:pt>
                  <c:pt idx="8">
                    <c:v>5</c:v>
                  </c:pt>
                  <c:pt idx="9">
                    <c:v>3.7182395644283122</c:v>
                  </c:pt>
                </c:numCache>
              </c:numRef>
            </c:plus>
            <c:minus>
              <c:numRef>
                <c:f>Sheet6!$B$27:$K$27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0.29264972776769399</c:v>
                  </c:pt>
                  <c:pt idx="2">
                    <c:v>0.247277676950998</c:v>
                  </c:pt>
                  <c:pt idx="3">
                    <c:v>0.38339382940108802</c:v>
                  </c:pt>
                  <c:pt idx="4">
                    <c:v>0.53085299455535295</c:v>
                  </c:pt>
                  <c:pt idx="5">
                    <c:v>0.70099818511796697</c:v>
                  </c:pt>
                  <c:pt idx="6">
                    <c:v>0.72368421052631504</c:v>
                  </c:pt>
                  <c:pt idx="7">
                    <c:v>4.7731397459165148</c:v>
                  </c:pt>
                  <c:pt idx="8">
                    <c:v>5</c:v>
                  </c:pt>
                  <c:pt idx="9">
                    <c:v>3.718239564428312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6!$O$15:$X$15</c:f>
              <c:numCache>
                <c:formatCode>General</c:formatCode>
                <c:ptCount val="10"/>
                <c:pt idx="0">
                  <c:v>0</c:v>
                </c:pt>
                <c:pt idx="1">
                  <c:v>0.1</c:v>
                </c:pt>
                <c:pt idx="2">
                  <c:v>0.25</c:v>
                </c:pt>
                <c:pt idx="3">
                  <c:v>0.5</c:v>
                </c:pt>
                <c:pt idx="4">
                  <c:v>1</c:v>
                </c:pt>
                <c:pt idx="5">
                  <c:v>2.5</c:v>
                </c:pt>
                <c:pt idx="6">
                  <c:v>5</c:v>
                </c:pt>
                <c:pt idx="7">
                  <c:v>10</c:v>
                </c:pt>
                <c:pt idx="8">
                  <c:v>25</c:v>
                </c:pt>
                <c:pt idx="9">
                  <c:v>50</c:v>
                </c:pt>
              </c:numCache>
            </c:numRef>
          </c:cat>
          <c:val>
            <c:numRef>
              <c:f>Sheet6!$O$19:$X$19</c:f>
              <c:numCache>
                <c:formatCode>General</c:formatCode>
                <c:ptCount val="10"/>
                <c:pt idx="0">
                  <c:v>0</c:v>
                </c:pt>
                <c:pt idx="1">
                  <c:v>5.85299455535388</c:v>
                </c:pt>
                <c:pt idx="2">
                  <c:v>4.9455535390199667</c:v>
                </c:pt>
                <c:pt idx="3">
                  <c:v>7.6678765880217572</c:v>
                </c:pt>
                <c:pt idx="4">
                  <c:v>10.617059891107059</c:v>
                </c:pt>
                <c:pt idx="5">
                  <c:v>14.01996370235935</c:v>
                </c:pt>
                <c:pt idx="6">
                  <c:v>14.473684210526301</c:v>
                </c:pt>
                <c:pt idx="7">
                  <c:v>95.462794918330303</c:v>
                </c:pt>
                <c:pt idx="8">
                  <c:v>100</c:v>
                </c:pt>
                <c:pt idx="9">
                  <c:v>74.36479128856623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F4C8-4AF3-ABF8-17D8D4F8982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7"/>
        <c:overlap val="-27"/>
        <c:axId val="-3790720"/>
        <c:axId val="-3798880"/>
      </c:barChart>
      <c:catAx>
        <c:axId val="-37945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3802144"/>
        <c:crosses val="autoZero"/>
        <c:auto val="1"/>
        <c:lblAlgn val="ctr"/>
        <c:lblOffset val="100"/>
        <c:noMultiLvlLbl val="0"/>
      </c:catAx>
      <c:valAx>
        <c:axId val="-3802144"/>
        <c:scaling>
          <c:orientation val="minMax"/>
          <c:max val="110"/>
          <c:min val="0"/>
        </c:scaling>
        <c:delete val="0"/>
        <c:axPos val="l"/>
        <c:numFmt formatCode="General" sourceLinked="1"/>
        <c:majorTickMark val="out"/>
        <c:minorTickMark val="in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3794528"/>
        <c:crosses val="autoZero"/>
        <c:crossBetween val="between"/>
      </c:valAx>
      <c:valAx>
        <c:axId val="-3798880"/>
        <c:scaling>
          <c:orientation val="minMax"/>
          <c:max val="110"/>
          <c:min val="0"/>
        </c:scaling>
        <c:delete val="0"/>
        <c:axPos val="r"/>
        <c:numFmt formatCode="General" sourceLinked="1"/>
        <c:majorTickMark val="out"/>
        <c:minorTickMark val="in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3790720"/>
        <c:crosses val="max"/>
        <c:crossBetween val="between"/>
      </c:valAx>
      <c:catAx>
        <c:axId val="-3790720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-3798880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 b="1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6378017374598"/>
          <c:y val="6.03737621223394E-2"/>
          <c:w val="0.75455663571901799"/>
          <c:h val="0.8286492023019329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3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6!$C$97:$G$97</c:f>
                <c:numCache>
                  <c:formatCode>General</c:formatCode>
                  <c:ptCount val="5"/>
                  <c:pt idx="0">
                    <c:v>0.8</c:v>
                  </c:pt>
                  <c:pt idx="1">
                    <c:v>1.264</c:v>
                  </c:pt>
                  <c:pt idx="2">
                    <c:v>2.4079999999999999</c:v>
                  </c:pt>
                  <c:pt idx="3">
                    <c:v>2.4</c:v>
                  </c:pt>
                  <c:pt idx="4">
                    <c:v>6.8939999999999992</c:v>
                  </c:pt>
                </c:numCache>
              </c:numRef>
            </c:plus>
            <c:minus>
              <c:numRef>
                <c:f>Sheet6!$C$97:$G$97</c:f>
                <c:numCache>
                  <c:formatCode>General</c:formatCode>
                  <c:ptCount val="5"/>
                  <c:pt idx="0">
                    <c:v>0.8</c:v>
                  </c:pt>
                  <c:pt idx="1">
                    <c:v>1.264</c:v>
                  </c:pt>
                  <c:pt idx="2">
                    <c:v>2.4079999999999999</c:v>
                  </c:pt>
                  <c:pt idx="3">
                    <c:v>2.4</c:v>
                  </c:pt>
                  <c:pt idx="4">
                    <c:v>6.893999999999999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6!$C$94:$G$94</c:f>
              <c:numCache>
                <c:formatCode>General</c:formatCode>
                <c:ptCount val="5"/>
                <c:pt idx="0">
                  <c:v>5</c:v>
                </c:pt>
                <c:pt idx="1">
                  <c:v>10</c:v>
                </c:pt>
                <c:pt idx="2">
                  <c:v>20</c:v>
                </c:pt>
                <c:pt idx="3">
                  <c:v>40</c:v>
                </c:pt>
                <c:pt idx="4">
                  <c:v>80</c:v>
                </c:pt>
              </c:numCache>
            </c:numRef>
          </c:cat>
          <c:val>
            <c:numRef>
              <c:f>Sheet6!$C$96:$G$96</c:f>
              <c:numCache>
                <c:formatCode>General</c:formatCode>
                <c:ptCount val="5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9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CA0D-498C-A5F6-A5300EA0D27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3805408"/>
        <c:axId val="-3799424"/>
      </c:barChart>
      <c:catAx>
        <c:axId val="-38054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3799424"/>
        <c:crosses val="autoZero"/>
        <c:auto val="1"/>
        <c:lblAlgn val="ctr"/>
        <c:lblOffset val="100"/>
        <c:noMultiLvlLbl val="0"/>
      </c:catAx>
      <c:valAx>
        <c:axId val="-3799424"/>
        <c:scaling>
          <c:orientation val="minMax"/>
          <c:max val="110"/>
          <c:min val="0"/>
        </c:scaling>
        <c:delete val="0"/>
        <c:axPos val="l"/>
        <c:numFmt formatCode="General" sourceLinked="1"/>
        <c:majorTickMark val="out"/>
        <c:minorTickMark val="in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38054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 b="1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7!$D$22:$F$22</c:f>
                <c:numCache>
                  <c:formatCode>General</c:formatCode>
                  <c:ptCount val="3"/>
                  <c:pt idx="0">
                    <c:v>2.7812866726670848</c:v>
                  </c:pt>
                  <c:pt idx="1">
                    <c:v>1.0960231141114949</c:v>
                  </c:pt>
                  <c:pt idx="2">
                    <c:v>1.099999999999999</c:v>
                  </c:pt>
                </c:numCache>
              </c:numRef>
            </c:plus>
            <c:minus>
              <c:numRef>
                <c:f>Sheet7!$D$22:$F$22</c:f>
                <c:numCache>
                  <c:formatCode>General</c:formatCode>
                  <c:ptCount val="3"/>
                  <c:pt idx="0">
                    <c:v>2.7812866726670848</c:v>
                  </c:pt>
                  <c:pt idx="1">
                    <c:v>1.0960231141114949</c:v>
                  </c:pt>
                  <c:pt idx="2">
                    <c:v>1.0999999999999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7!$D$20:$F$20</c:f>
              <c:numCache>
                <c:formatCode>General</c:formatCode>
                <c:ptCount val="3"/>
              </c:numCache>
            </c:numRef>
          </c:cat>
          <c:val>
            <c:numRef>
              <c:f>Sheet7!$D$21:$F$21</c:f>
              <c:numCache>
                <c:formatCode>General</c:formatCode>
                <c:ptCount val="3"/>
                <c:pt idx="0">
                  <c:v>-23.833333333333321</c:v>
                </c:pt>
                <c:pt idx="1">
                  <c:v>-7.4749999999999996</c:v>
                </c:pt>
                <c:pt idx="2">
                  <c:v>-17.66666666666667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9DF0-4469-B742-3E2B83E1485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3804864"/>
        <c:axId val="-3799968"/>
      </c:barChart>
      <c:catAx>
        <c:axId val="-38048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3799968"/>
        <c:crosses val="autoZero"/>
        <c:auto val="1"/>
        <c:lblAlgn val="ctr"/>
        <c:lblOffset val="100"/>
        <c:noMultiLvlLbl val="0"/>
      </c:catAx>
      <c:valAx>
        <c:axId val="-3799968"/>
        <c:scaling>
          <c:orientation val="minMax"/>
        </c:scaling>
        <c:delete val="0"/>
        <c:axPos val="l"/>
        <c:numFmt formatCode="General" sourceLinked="1"/>
        <c:majorTickMark val="out"/>
        <c:minorTickMark val="in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38048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 b="1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1"/>
          <c:order val="0"/>
          <c:spPr>
            <a:noFill/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C$80:$E$80</c:f>
                <c:numCache>
                  <c:formatCode>General</c:formatCode>
                  <c:ptCount val="3"/>
                  <c:pt idx="0">
                    <c:v>2368</c:v>
                  </c:pt>
                  <c:pt idx="1">
                    <c:v>7555</c:v>
                  </c:pt>
                  <c:pt idx="2">
                    <c:v>454.5</c:v>
                  </c:pt>
                </c:numCache>
              </c:numRef>
            </c:plus>
            <c:minus>
              <c:numRef>
                <c:f>Sheet2!$C$80:$E$80</c:f>
                <c:numCache>
                  <c:formatCode>General</c:formatCode>
                  <c:ptCount val="3"/>
                  <c:pt idx="0">
                    <c:v>2368</c:v>
                  </c:pt>
                  <c:pt idx="1">
                    <c:v>7555</c:v>
                  </c:pt>
                  <c:pt idx="2">
                    <c:v>454.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2!$C$73:$E$73</c:f>
              <c:numCache>
                <c:formatCode>General</c:formatCode>
                <c:ptCount val="3"/>
                <c:pt idx="0">
                  <c:v>0</c:v>
                </c:pt>
                <c:pt idx="1">
                  <c:v>32</c:v>
                </c:pt>
                <c:pt idx="2">
                  <c:v>64</c:v>
                </c:pt>
              </c:numCache>
            </c:numRef>
          </c:cat>
          <c:val>
            <c:numRef>
              <c:f>Sheet2!$C$79:$E$79</c:f>
              <c:numCache>
                <c:formatCode>General</c:formatCode>
                <c:ptCount val="3"/>
                <c:pt idx="0">
                  <c:v>114625</c:v>
                </c:pt>
                <c:pt idx="1">
                  <c:v>191244</c:v>
                </c:pt>
                <c:pt idx="2">
                  <c:v>18996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0625-4003-BE87-7CDBB2C258F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9"/>
        <c:overlap val="-27"/>
        <c:axId val="-3801600"/>
        <c:axId val="-3793984"/>
      </c:barChart>
      <c:catAx>
        <c:axId val="-38016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3793984"/>
        <c:crossesAt val="0"/>
        <c:auto val="1"/>
        <c:lblAlgn val="ctr"/>
        <c:lblOffset val="100"/>
        <c:noMultiLvlLbl val="0"/>
      </c:catAx>
      <c:valAx>
        <c:axId val="-3793984"/>
        <c:scaling>
          <c:orientation val="minMax"/>
        </c:scaling>
        <c:delete val="0"/>
        <c:axPos val="l"/>
        <c:numFmt formatCode="General" sourceLinked="1"/>
        <c:majorTickMark val="out"/>
        <c:minorTickMark val="in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3801600"/>
        <c:crosses val="autoZero"/>
        <c:crossBetween val="between"/>
        <c:dispUnits>
          <c:builtInUnit val="tenThousands"/>
        </c:dispUnits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 b="1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2581196144729"/>
          <c:y val="5.81089788926085E-2"/>
          <c:w val="0.70341737398605597"/>
          <c:h val="0.7676395241014035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2!$AK$25</c:f>
              <c:strCache>
                <c:ptCount val="1"/>
                <c:pt idx="0">
                  <c:v>pTMe</c:v>
                </c:pt>
              </c:strCache>
            </c:strRef>
          </c:tx>
          <c:spPr>
            <a:noFill/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AL$26:$AO$26</c:f>
                <c:numCache>
                  <c:formatCode>General</c:formatCode>
                  <c:ptCount val="4"/>
                  <c:pt idx="0">
                    <c:v>8625</c:v>
                  </c:pt>
                  <c:pt idx="1">
                    <c:v>2387.5</c:v>
                  </c:pt>
                  <c:pt idx="2">
                    <c:v>15960</c:v>
                  </c:pt>
                  <c:pt idx="3">
                    <c:v>29067.5</c:v>
                  </c:pt>
                </c:numCache>
              </c:numRef>
            </c:plus>
            <c:minus>
              <c:numRef>
                <c:f>Sheet2!$AL$26:$AO$26</c:f>
                <c:numCache>
                  <c:formatCode>General</c:formatCode>
                  <c:ptCount val="4"/>
                  <c:pt idx="0">
                    <c:v>8625</c:v>
                  </c:pt>
                  <c:pt idx="1">
                    <c:v>2387.5</c:v>
                  </c:pt>
                  <c:pt idx="2">
                    <c:v>15960</c:v>
                  </c:pt>
                  <c:pt idx="3">
                    <c:v>29067.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2!$AL$21:$AO$21</c:f>
              <c:numCache>
                <c:formatCode>General</c:formatCode>
                <c:ptCount val="4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8</c:v>
                </c:pt>
              </c:numCache>
            </c:numRef>
          </c:cat>
          <c:val>
            <c:numRef>
              <c:f>Sheet2!$AL$25:$AO$25</c:f>
              <c:numCache>
                <c:formatCode>General</c:formatCode>
                <c:ptCount val="4"/>
                <c:pt idx="0">
                  <c:v>198188</c:v>
                </c:pt>
                <c:pt idx="1">
                  <c:v>233562</c:v>
                </c:pt>
                <c:pt idx="2">
                  <c:v>278760</c:v>
                </c:pt>
                <c:pt idx="3">
                  <c:v>27668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2446-4A83-8108-F3397B621B27}"/>
            </c:ext>
          </c:extLst>
        </c:ser>
        <c:ser>
          <c:idx val="1"/>
          <c:order val="1"/>
          <c:tx>
            <c:strRef>
              <c:f>Sheet2!$AK$27</c:f>
              <c:strCache>
                <c:ptCount val="1"/>
                <c:pt idx="0">
                  <c:v>b-pTMe</c:v>
                </c:pt>
              </c:strCache>
            </c:strRef>
          </c:tx>
          <c:spPr>
            <a:solidFill>
              <a:schemeClr val="accent3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AL$28:$AO$28</c:f>
                <c:numCache>
                  <c:formatCode>General</c:formatCode>
                  <c:ptCount val="4"/>
                  <c:pt idx="0">
                    <c:v>3450</c:v>
                  </c:pt>
                  <c:pt idx="1">
                    <c:v>955</c:v>
                  </c:pt>
                  <c:pt idx="2">
                    <c:v>6384</c:v>
                  </c:pt>
                  <c:pt idx="3">
                    <c:v>11627</c:v>
                  </c:pt>
                </c:numCache>
              </c:numRef>
            </c:plus>
            <c:minus>
              <c:numRef>
                <c:f>Sheet2!$AL$28:$AO$28</c:f>
                <c:numCache>
                  <c:formatCode>General</c:formatCode>
                  <c:ptCount val="4"/>
                  <c:pt idx="0">
                    <c:v>3450</c:v>
                  </c:pt>
                  <c:pt idx="1">
                    <c:v>955</c:v>
                  </c:pt>
                  <c:pt idx="2">
                    <c:v>6384</c:v>
                  </c:pt>
                  <c:pt idx="3">
                    <c:v>1162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2!$AL$27:$AO$27</c:f>
              <c:numCache>
                <c:formatCode>General</c:formatCode>
                <c:ptCount val="4"/>
                <c:pt idx="0">
                  <c:v>205088</c:v>
                </c:pt>
                <c:pt idx="1">
                  <c:v>235472</c:v>
                </c:pt>
                <c:pt idx="2">
                  <c:v>291528</c:v>
                </c:pt>
                <c:pt idx="3">
                  <c:v>29994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2446-4A83-8108-F3397B621B2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3797248"/>
        <c:axId val="-3798336"/>
      </c:barChart>
      <c:catAx>
        <c:axId val="-37972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3798336"/>
        <c:crosses val="autoZero"/>
        <c:auto val="1"/>
        <c:lblAlgn val="ctr"/>
        <c:lblOffset val="100"/>
        <c:noMultiLvlLbl val="0"/>
      </c:catAx>
      <c:valAx>
        <c:axId val="-3798336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in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3797248"/>
        <c:crosses val="autoZero"/>
        <c:crossBetween val="between"/>
        <c:dispUnits>
          <c:builtInUnit val="tenThousands"/>
        </c:dispUnits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22363510651450566"/>
          <c:y val="8.9250632593081539E-2"/>
          <c:w val="0.36675574232251601"/>
          <c:h val="0.13786600028289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1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 b="1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1685325048655"/>
          <c:y val="5.0783225353537201E-2"/>
          <c:w val="0.74290856500080404"/>
          <c:h val="0.82828875726301698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3!$C$36</c:f>
              <c:strCache>
                <c:ptCount val="1"/>
                <c:pt idx="0">
                  <c:v>No CL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Sheet3!$D$39:$F$39</c:f>
                <c:numCache>
                  <c:formatCode>General</c:formatCode>
                  <c:ptCount val="3"/>
                  <c:pt idx="0">
                    <c:v>25</c:v>
                  </c:pt>
                  <c:pt idx="1">
                    <c:v>31</c:v>
                  </c:pt>
                  <c:pt idx="2">
                    <c:v>3</c:v>
                  </c:pt>
                </c:numCache>
              </c:numRef>
            </c:plus>
            <c:minus>
              <c:numRef>
                <c:f>Sheet3!$D$39:$F$39</c:f>
                <c:numCache>
                  <c:formatCode>General</c:formatCode>
                  <c:ptCount val="3"/>
                  <c:pt idx="0">
                    <c:v>25</c:v>
                  </c:pt>
                  <c:pt idx="1">
                    <c:v>31</c:v>
                  </c:pt>
                  <c:pt idx="2">
                    <c:v>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noEndCap val="0"/>
            <c:val val="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3!$D$35:$F$35</c:f>
              <c:numCache>
                <c:formatCode>General</c:formatCode>
                <c:ptCount val="3"/>
                <c:pt idx="0">
                  <c:v>27.5</c:v>
                </c:pt>
                <c:pt idx="1">
                  <c:v>55</c:v>
                </c:pt>
                <c:pt idx="2">
                  <c:v>220</c:v>
                </c:pt>
              </c:numCache>
            </c:numRef>
          </c:xVal>
          <c:yVal>
            <c:numRef>
              <c:f>Sheet3!$D$36:$F$36</c:f>
              <c:numCache>
                <c:formatCode>General</c:formatCode>
                <c:ptCount val="3"/>
                <c:pt idx="0">
                  <c:v>53.5</c:v>
                </c:pt>
                <c:pt idx="1">
                  <c:v>84.5</c:v>
                </c:pt>
                <c:pt idx="2">
                  <c:v>50.5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5487-4DAA-8D18-FE2862BF47C6}"/>
            </c:ext>
          </c:extLst>
        </c:ser>
        <c:ser>
          <c:idx val="1"/>
          <c:order val="1"/>
          <c:tx>
            <c:strRef>
              <c:f>Sheet3!$C$37</c:f>
              <c:strCache>
                <c:ptCount val="1"/>
                <c:pt idx="0">
                  <c:v>32 µg CL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2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Sheet3!$D$40:$F$40</c:f>
                <c:numCache>
                  <c:formatCode>General</c:formatCode>
                  <c:ptCount val="3"/>
                  <c:pt idx="0">
                    <c:v>55</c:v>
                  </c:pt>
                  <c:pt idx="1">
                    <c:v>8.5</c:v>
                  </c:pt>
                  <c:pt idx="2">
                    <c:v>99</c:v>
                  </c:pt>
                </c:numCache>
              </c:numRef>
            </c:plus>
            <c:minus>
              <c:numRef>
                <c:f>Sheet3!$D$40:$F$40</c:f>
                <c:numCache>
                  <c:formatCode>General</c:formatCode>
                  <c:ptCount val="3"/>
                  <c:pt idx="0">
                    <c:v>55</c:v>
                  </c:pt>
                  <c:pt idx="1">
                    <c:v>8.5</c:v>
                  </c:pt>
                  <c:pt idx="2">
                    <c:v>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noEndCap val="0"/>
            <c:val val="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3!$D$35:$F$35</c:f>
              <c:numCache>
                <c:formatCode>General</c:formatCode>
                <c:ptCount val="3"/>
                <c:pt idx="0">
                  <c:v>27.5</c:v>
                </c:pt>
                <c:pt idx="1">
                  <c:v>55</c:v>
                </c:pt>
                <c:pt idx="2">
                  <c:v>220</c:v>
                </c:pt>
              </c:numCache>
            </c:numRef>
          </c:xVal>
          <c:yVal>
            <c:numRef>
              <c:f>Sheet3!$D$37:$F$37</c:f>
              <c:numCache>
                <c:formatCode>General</c:formatCode>
                <c:ptCount val="3"/>
                <c:pt idx="0">
                  <c:v>312</c:v>
                </c:pt>
                <c:pt idx="1">
                  <c:v>469</c:v>
                </c:pt>
                <c:pt idx="2">
                  <c:v>896.5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5487-4DAA-8D18-FE2862BF47C6}"/>
            </c:ext>
          </c:extLst>
        </c:ser>
        <c:ser>
          <c:idx val="2"/>
          <c:order val="2"/>
          <c:tx>
            <c:strRef>
              <c:f>Sheet3!$C$38</c:f>
              <c:strCache>
                <c:ptCount val="1"/>
                <c:pt idx="0">
                  <c:v>64 µg CL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3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Sheet3!$D$41:$F$41</c:f>
                <c:numCache>
                  <c:formatCode>General</c:formatCode>
                  <c:ptCount val="3"/>
                  <c:pt idx="0">
                    <c:v>25</c:v>
                  </c:pt>
                  <c:pt idx="1">
                    <c:v>29.5</c:v>
                  </c:pt>
                  <c:pt idx="2">
                    <c:v>21.5</c:v>
                  </c:pt>
                </c:numCache>
              </c:numRef>
            </c:plus>
            <c:minus>
              <c:numRef>
                <c:f>Sheet3!$D$41:$F$41</c:f>
                <c:numCache>
                  <c:formatCode>General</c:formatCode>
                  <c:ptCount val="3"/>
                  <c:pt idx="0">
                    <c:v>25</c:v>
                  </c:pt>
                  <c:pt idx="1">
                    <c:v>29.5</c:v>
                  </c:pt>
                  <c:pt idx="2">
                    <c:v>21.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noEndCap val="0"/>
            <c:val val="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3!$D$35:$F$35</c:f>
              <c:numCache>
                <c:formatCode>General</c:formatCode>
                <c:ptCount val="3"/>
                <c:pt idx="0">
                  <c:v>27.5</c:v>
                </c:pt>
                <c:pt idx="1">
                  <c:v>55</c:v>
                </c:pt>
                <c:pt idx="2">
                  <c:v>220</c:v>
                </c:pt>
              </c:numCache>
            </c:numRef>
          </c:xVal>
          <c:yVal>
            <c:numRef>
              <c:f>Sheet3!$D$38:$F$38</c:f>
              <c:numCache>
                <c:formatCode>General</c:formatCode>
                <c:ptCount val="3"/>
                <c:pt idx="0">
                  <c:v>897</c:v>
                </c:pt>
                <c:pt idx="1">
                  <c:v>1169</c:v>
                </c:pt>
                <c:pt idx="2">
                  <c:v>2144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5487-4DAA-8D18-FE2862BF47C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3801056"/>
        <c:axId val="-3803232"/>
      </c:scatterChart>
      <c:valAx>
        <c:axId val="-3801056"/>
        <c:scaling>
          <c:orientation val="minMax"/>
          <c:max val="25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3803232"/>
        <c:crosses val="autoZero"/>
        <c:crossBetween val="midCat"/>
        <c:majorUnit val="50"/>
      </c:valAx>
      <c:valAx>
        <c:axId val="-3803232"/>
        <c:scaling>
          <c:orientation val="minMax"/>
        </c:scaling>
        <c:delete val="0"/>
        <c:axPos val="l"/>
        <c:numFmt formatCode="General" sourceLinked="1"/>
        <c:majorTickMark val="out"/>
        <c:minorTickMark val="in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3801056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egendEntry>
        <c:idx val="3"/>
        <c:delete val="1"/>
      </c:legendEntry>
      <c:legendEntry>
        <c:idx val="4"/>
        <c:delete val="1"/>
      </c:legendEntry>
      <c:legendEntry>
        <c:idx val="5"/>
        <c:delete val="1"/>
      </c:legendEntry>
      <c:layout>
        <c:manualLayout>
          <c:xMode val="edge"/>
          <c:yMode val="edge"/>
          <c:x val="0.20824468370025201"/>
          <c:y val="5.4118291519866399E-2"/>
          <c:w val="0.297261413751853"/>
          <c:h val="0.2262544842849240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1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 b="1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202384785504399"/>
          <c:y val="3.3640394913938797E-2"/>
          <c:w val="0.80420356700733198"/>
          <c:h val="0.82724830900420898"/>
        </c:manualLayout>
      </c:layout>
      <c:barChart>
        <c:barDir val="col"/>
        <c:grouping val="clustered"/>
        <c:varyColors val="0"/>
        <c:ser>
          <c:idx val="1"/>
          <c:order val="0"/>
          <c:tx>
            <c:v>NADPH</c:v>
          </c:tx>
          <c:spPr>
            <a:noFill/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CHCL3!$B$19:$E$19</c:f>
                <c:numCache>
                  <c:formatCode>General</c:formatCode>
                  <c:ptCount val="4"/>
                  <c:pt idx="0">
                    <c:v>2.4115755627009792</c:v>
                  </c:pt>
                  <c:pt idx="1">
                    <c:v>3.2154340836012731</c:v>
                  </c:pt>
                  <c:pt idx="2">
                    <c:v>1.446945337620579</c:v>
                  </c:pt>
                </c:numCache>
              </c:numRef>
            </c:plus>
            <c:minus>
              <c:numRef>
                <c:f>CHCL3!$B$19:$E$19</c:f>
                <c:numCache>
                  <c:formatCode>General</c:formatCode>
                  <c:ptCount val="4"/>
                  <c:pt idx="0">
                    <c:v>2.4115755627009792</c:v>
                  </c:pt>
                  <c:pt idx="1">
                    <c:v>3.2154340836012731</c:v>
                  </c:pt>
                  <c:pt idx="2">
                    <c:v>1.44694533762057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CHCL3!$B$3:$E$3</c:f>
              <c:numCache>
                <c:formatCode>General</c:formatCode>
                <c:ptCount val="4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8</c:v>
                </c:pt>
              </c:numCache>
            </c:numRef>
          </c:cat>
          <c:val>
            <c:numRef>
              <c:f>CHCL3!$B$14:$E$14</c:f>
              <c:numCache>
                <c:formatCode>General</c:formatCode>
                <c:ptCount val="4"/>
                <c:pt idx="0">
                  <c:v>100</c:v>
                </c:pt>
                <c:pt idx="1">
                  <c:v>22.70114942528738</c:v>
                </c:pt>
                <c:pt idx="2">
                  <c:v>9.1954022988505848</c:v>
                </c:pt>
                <c:pt idx="3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D1EC-4A01-B488-6F241A076DB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3793440"/>
        <c:axId val="-3797792"/>
      </c:barChart>
      <c:catAx>
        <c:axId val="-379344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3797792"/>
        <c:crosses val="autoZero"/>
        <c:auto val="1"/>
        <c:lblAlgn val="ctr"/>
        <c:lblOffset val="100"/>
        <c:noMultiLvlLbl val="0"/>
      </c:catAx>
      <c:valAx>
        <c:axId val="-3797792"/>
        <c:scaling>
          <c:orientation val="minMax"/>
          <c:max val="110"/>
          <c:min val="0"/>
        </c:scaling>
        <c:delete val="0"/>
        <c:axPos val="l"/>
        <c:numFmt formatCode="General" sourceLinked="1"/>
        <c:majorTickMark val="out"/>
        <c:minorTickMark val="in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37934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 b="1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798805470218999"/>
          <c:y val="4.4451911901111502E-2"/>
          <c:w val="0.64262918422974402"/>
          <c:h val="0.60204810069330195"/>
        </c:manualLayout>
      </c:layout>
      <c:barChart>
        <c:barDir val="col"/>
        <c:grouping val="clustered"/>
        <c:varyColors val="0"/>
        <c:ser>
          <c:idx val="0"/>
          <c:order val="0"/>
          <c:spPr>
            <a:noFill/>
            <a:ln>
              <a:solidFill>
                <a:sysClr val="windowText" lastClr="000000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accent3"/>
              </a:solidFill>
              <a:ln>
                <a:solidFill>
                  <a:sysClr val="windowText" lastClr="000000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0-B0C3-4EF2-9EED-3A57C47303FC}"/>
              </c:ext>
            </c:extLst>
          </c:dPt>
          <c:errBars>
            <c:errBarType val="both"/>
            <c:errValType val="cust"/>
            <c:noEndCap val="0"/>
            <c:plus>
              <c:numRef>
                <c:f>Sheet2!$F$44:$G$44</c:f>
                <c:numCache>
                  <c:formatCode>General</c:formatCode>
                  <c:ptCount val="2"/>
                  <c:pt idx="0">
                    <c:v>3005.5</c:v>
                  </c:pt>
                  <c:pt idx="1">
                    <c:v>9872.5</c:v>
                  </c:pt>
                </c:numCache>
              </c:numRef>
            </c:plus>
            <c:minus>
              <c:numRef>
                <c:f>Sheet2!$F$44:$G$44</c:f>
                <c:numCache>
                  <c:formatCode>General</c:formatCode>
                  <c:ptCount val="2"/>
                  <c:pt idx="0">
                    <c:v>3005.5</c:v>
                  </c:pt>
                  <c:pt idx="1">
                    <c:v>9872.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F$42:$G$42</c:f>
              <c:strCache>
                <c:ptCount val="2"/>
                <c:pt idx="0">
                  <c:v>pTMe</c:v>
                </c:pt>
                <c:pt idx="1">
                  <c:v>b-pTMe</c:v>
                </c:pt>
              </c:strCache>
            </c:strRef>
          </c:cat>
          <c:val>
            <c:numRef>
              <c:f>Sheet2!$F$43:$G$43</c:f>
              <c:numCache>
                <c:formatCode>General</c:formatCode>
                <c:ptCount val="2"/>
                <c:pt idx="0">
                  <c:v>289806</c:v>
                </c:pt>
                <c:pt idx="1">
                  <c:v>27408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7027-4599-BDD9-EABC1093292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3792896"/>
        <c:axId val="-3792352"/>
      </c:barChart>
      <c:catAx>
        <c:axId val="-37928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3792352"/>
        <c:crosses val="autoZero"/>
        <c:auto val="1"/>
        <c:lblAlgn val="ctr"/>
        <c:lblOffset val="100"/>
        <c:noMultiLvlLbl val="0"/>
      </c:catAx>
      <c:valAx>
        <c:axId val="-3792352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in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3792896"/>
        <c:crosses val="autoZero"/>
        <c:crossBetween val="between"/>
        <c:dispUnits>
          <c:builtInUnit val="tenThousands"/>
        </c:dispUnits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 b="1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5169568376864"/>
          <c:y val="5.1291584326330603E-2"/>
          <c:w val="0.73590730110635705"/>
          <c:h val="0.77659004389948705"/>
        </c:manualLayout>
      </c:layout>
      <c:scatterChart>
        <c:scatterStyle val="smoothMarker"/>
        <c:varyColors val="0"/>
        <c:ser>
          <c:idx val="1"/>
          <c:order val="0"/>
          <c:tx>
            <c:strRef>
              <c:f>Sheet4!$I$36</c:f>
              <c:strCache>
                <c:ptCount val="1"/>
                <c:pt idx="0">
                  <c:v>400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4!$J$34:$N$34</c:f>
              <c:numCache>
                <c:formatCode>General</c:formatCode>
                <c:ptCount val="5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8</c:v>
                </c:pt>
                <c:pt idx="4">
                  <c:v>16</c:v>
                </c:pt>
              </c:numCache>
            </c:numRef>
          </c:xVal>
          <c:yVal>
            <c:numRef>
              <c:f>Sheet4!$J$36:$N$36</c:f>
              <c:numCache>
                <c:formatCode>General</c:formatCode>
                <c:ptCount val="5"/>
                <c:pt idx="0">
                  <c:v>0</c:v>
                </c:pt>
                <c:pt idx="1">
                  <c:v>0.13919999999999999</c:v>
                </c:pt>
                <c:pt idx="2">
                  <c:v>0.25984000000000002</c:v>
                </c:pt>
                <c:pt idx="3">
                  <c:v>0.46400000000000002</c:v>
                </c:pt>
                <c:pt idx="4">
                  <c:v>0.51039999999999996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BE84-4ED4-8558-C90411012E72}"/>
            </c:ext>
          </c:extLst>
        </c:ser>
        <c:ser>
          <c:idx val="0"/>
          <c:order val="1"/>
          <c:tx>
            <c:strRef>
              <c:f>Sheet4!$I$35</c:f>
              <c:strCache>
                <c:ptCount val="1"/>
                <c:pt idx="0">
                  <c:v>200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triangl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4!$J$34:$N$34</c:f>
              <c:numCache>
                <c:formatCode>General</c:formatCode>
                <c:ptCount val="5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8</c:v>
                </c:pt>
                <c:pt idx="4">
                  <c:v>16</c:v>
                </c:pt>
              </c:numCache>
            </c:numRef>
          </c:xVal>
          <c:yVal>
            <c:numRef>
              <c:f>Sheet4!$J$35:$N$35</c:f>
              <c:numCache>
                <c:formatCode>General</c:formatCode>
                <c:ptCount val="5"/>
                <c:pt idx="0">
                  <c:v>0</c:v>
                </c:pt>
                <c:pt idx="1">
                  <c:v>0.12528</c:v>
                </c:pt>
                <c:pt idx="2">
                  <c:v>0.23200000000000001</c:v>
                </c:pt>
                <c:pt idx="3">
                  <c:v>0.23200000000000001</c:v>
                </c:pt>
                <c:pt idx="4">
                  <c:v>0.23663999999999999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1-BE84-4ED4-8558-C90411012E7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54095648"/>
        <c:axId val="-54090208"/>
      </c:scatterChart>
      <c:valAx>
        <c:axId val="-540956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54090208"/>
        <c:crosses val="autoZero"/>
        <c:crossBetween val="midCat"/>
      </c:valAx>
      <c:valAx>
        <c:axId val="-54090208"/>
        <c:scaling>
          <c:orientation val="minMax"/>
        </c:scaling>
        <c:delete val="0"/>
        <c:axPos val="l"/>
        <c:numFmt formatCode="General" sourceLinked="1"/>
        <c:majorTickMark val="out"/>
        <c:minorTickMark val="in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54095648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57997962720714002"/>
          <c:y val="0.66411846439125999"/>
          <c:w val="0.25197472353870498"/>
          <c:h val="0.1204374854980100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 b="1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40176991150442"/>
          <c:y val="5.6093638584194298E-2"/>
          <c:w val="0.69060562783257695"/>
          <c:h val="0.736468700210128"/>
        </c:manualLayout>
      </c:layout>
      <c:barChart>
        <c:barDir val="col"/>
        <c:grouping val="clustered"/>
        <c:varyColors val="0"/>
        <c:ser>
          <c:idx val="0"/>
          <c:order val="0"/>
          <c:spPr>
            <a:noFill/>
            <a:ln>
              <a:solidFill>
                <a:sysClr val="windowText" lastClr="000000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accent3"/>
              </a:solidFill>
              <a:ln>
                <a:solidFill>
                  <a:sysClr val="windowText" lastClr="000000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0-FC19-4D34-945E-E64FE037E92E}"/>
              </c:ext>
            </c:extLst>
          </c:dPt>
          <c:errBars>
            <c:errBarType val="both"/>
            <c:errValType val="cust"/>
            <c:noEndCap val="0"/>
            <c:plus>
              <c:numRef>
                <c:f>Sheet2!$D$37:$E$37</c:f>
                <c:numCache>
                  <c:formatCode>General</c:formatCode>
                  <c:ptCount val="2"/>
                  <c:pt idx="0">
                    <c:v>232</c:v>
                  </c:pt>
                  <c:pt idx="1">
                    <c:v>269</c:v>
                  </c:pt>
                </c:numCache>
              </c:numRef>
            </c:plus>
            <c:minus>
              <c:numRef>
                <c:f>Sheet2!$D$37:$E$37</c:f>
                <c:numCache>
                  <c:formatCode>General</c:formatCode>
                  <c:ptCount val="2"/>
                  <c:pt idx="0">
                    <c:v>232</c:v>
                  </c:pt>
                  <c:pt idx="1">
                    <c:v>26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B$35:$C$35</c:f>
              <c:strCache>
                <c:ptCount val="2"/>
                <c:pt idx="0">
                  <c:v>pTMe</c:v>
                </c:pt>
                <c:pt idx="1">
                  <c:v>b-pTMe</c:v>
                </c:pt>
              </c:strCache>
            </c:strRef>
          </c:cat>
          <c:val>
            <c:numRef>
              <c:f>Sheet2!$B$38:$C$38</c:f>
              <c:numCache>
                <c:formatCode>General</c:formatCode>
                <c:ptCount val="2"/>
                <c:pt idx="0">
                  <c:v>5426.5</c:v>
                </c:pt>
                <c:pt idx="1">
                  <c:v>3889.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A2F0-4897-9973-6A74B98904A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024715488"/>
        <c:axId val="-2024708416"/>
      </c:barChart>
      <c:catAx>
        <c:axId val="-20247154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2024708416"/>
        <c:crosses val="autoZero"/>
        <c:auto val="1"/>
        <c:lblAlgn val="ctr"/>
        <c:lblOffset val="100"/>
        <c:noMultiLvlLbl val="0"/>
      </c:catAx>
      <c:valAx>
        <c:axId val="-2024708416"/>
        <c:scaling>
          <c:orientation val="minMax"/>
        </c:scaling>
        <c:delete val="0"/>
        <c:axPos val="l"/>
        <c:numFmt formatCode="General" sourceLinked="1"/>
        <c:majorTickMark val="out"/>
        <c:minorTickMark val="in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2024715488"/>
        <c:crosses val="autoZero"/>
        <c:crossBetween val="between"/>
        <c:dispUnits>
          <c:builtInUnit val="tenThousands"/>
        </c:dispUnits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 b="1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5214366841925401"/>
          <c:y val="4.4774562304410202E-2"/>
          <c:w val="0.69962853897751598"/>
          <c:h val="0.71953270077793796"/>
        </c:manualLayout>
      </c:layout>
      <c:barChart>
        <c:barDir val="col"/>
        <c:grouping val="clustered"/>
        <c:varyColors val="0"/>
        <c:ser>
          <c:idx val="0"/>
          <c:order val="0"/>
          <c:spPr>
            <a:noFill/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P$50:$T$50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</c:v>
                  </c:pt>
                  <c:pt idx="2">
                    <c:v>3.6233766233766151</c:v>
                  </c:pt>
                  <c:pt idx="3">
                    <c:v>1.9480519480519509</c:v>
                  </c:pt>
                  <c:pt idx="4">
                    <c:v>2.571428571428573</c:v>
                  </c:pt>
                </c:numCache>
              </c:numRef>
            </c:plus>
            <c:minus>
              <c:numRef>
                <c:f>Sheet1!$P$50:$T$50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</c:v>
                  </c:pt>
                  <c:pt idx="2">
                    <c:v>3.6233766233766151</c:v>
                  </c:pt>
                  <c:pt idx="3">
                    <c:v>1.9480519480519509</c:v>
                  </c:pt>
                  <c:pt idx="4">
                    <c:v>2.57142857142857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P$48:$T$48</c:f>
              <c:strCache>
                <c:ptCount val="5"/>
                <c:pt idx="0">
                  <c:v>0</c:v>
                </c:pt>
                <c:pt idx="1">
                  <c:v>1</c:v>
                </c:pt>
                <c:pt idx="2">
                  <c:v>5</c:v>
                </c:pt>
                <c:pt idx="3">
                  <c:v>25</c:v>
                </c:pt>
                <c:pt idx="4">
                  <c:v>his</c:v>
                </c:pt>
              </c:strCache>
            </c:strRef>
          </c:cat>
          <c:val>
            <c:numRef>
              <c:f>Sheet1!$P$49:$T$49</c:f>
              <c:numCache>
                <c:formatCode>General</c:formatCode>
                <c:ptCount val="5"/>
                <c:pt idx="0">
                  <c:v>0.01</c:v>
                </c:pt>
                <c:pt idx="1">
                  <c:v>0.01</c:v>
                </c:pt>
                <c:pt idx="2">
                  <c:v>59.74025974025983</c:v>
                </c:pt>
                <c:pt idx="3">
                  <c:v>61.038961038960998</c:v>
                </c:pt>
                <c:pt idx="4">
                  <c:v>35.71428571428568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2BC6-4C58-8DA2-EC0735E3C3A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78"/>
        <c:overlap val="-27"/>
        <c:axId val="-2024707872"/>
        <c:axId val="-2024705152"/>
      </c:barChart>
      <c:catAx>
        <c:axId val="-2024707872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2024705152"/>
        <c:crosses val="autoZero"/>
        <c:auto val="1"/>
        <c:lblAlgn val="ctr"/>
        <c:lblOffset val="100"/>
        <c:noMultiLvlLbl val="0"/>
      </c:catAx>
      <c:valAx>
        <c:axId val="-2024705152"/>
        <c:scaling>
          <c:orientation val="minMax"/>
          <c:max val="11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ko-KR"/>
                  <a:t>Inhibition</a:t>
                </a:r>
                <a:r>
                  <a:rPr lang="en-US" altLang="ko-KR" baseline="0"/>
                  <a:t> (%)</a:t>
                </a:r>
                <a:endParaRPr lang="ko-KR" altLang="en-US"/>
              </a:p>
            </c:rich>
          </c:tx>
          <c:layout>
            <c:manualLayout>
              <c:xMode val="edge"/>
              <c:yMode val="edge"/>
              <c:x val="4.8227792603230603E-2"/>
              <c:y val="0.2355380700690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in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20247078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 b="1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5388015717092"/>
          <c:y val="4.5303462162253602E-2"/>
          <c:w val="0.71958906352324803"/>
          <c:h val="0.77653591501528396"/>
        </c:manualLayout>
      </c:layout>
      <c:barChart>
        <c:barDir val="col"/>
        <c:grouping val="clustered"/>
        <c:varyColors val="0"/>
        <c:ser>
          <c:idx val="0"/>
          <c:order val="0"/>
          <c:spPr>
            <a:noFill/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J$117:$Q$117</c:f>
                <c:numCache>
                  <c:formatCode>General</c:formatCode>
                  <c:ptCount val="8"/>
                  <c:pt idx="0">
                    <c:v>0</c:v>
                  </c:pt>
                  <c:pt idx="4">
                    <c:v>0.19626168224298501</c:v>
                  </c:pt>
                  <c:pt idx="5">
                    <c:v>0.121495327102807</c:v>
                  </c:pt>
                  <c:pt idx="6">
                    <c:v>0.26168224299066201</c:v>
                  </c:pt>
                  <c:pt idx="7">
                    <c:v>4.9564270152505463</c:v>
                  </c:pt>
                </c:numCache>
              </c:numRef>
            </c:plus>
            <c:minus>
              <c:numRef>
                <c:f>Sheet1!$J$117:$Q$117</c:f>
                <c:numCache>
                  <c:formatCode>General</c:formatCode>
                  <c:ptCount val="8"/>
                  <c:pt idx="0">
                    <c:v>0</c:v>
                  </c:pt>
                  <c:pt idx="4">
                    <c:v>0.19626168224298501</c:v>
                  </c:pt>
                  <c:pt idx="5">
                    <c:v>0.121495327102807</c:v>
                  </c:pt>
                  <c:pt idx="6">
                    <c:v>0.26168224299066201</c:v>
                  </c:pt>
                  <c:pt idx="7">
                    <c:v>4.956427015250546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J$115:$Q$115</c:f>
              <c:strCache>
                <c:ptCount val="8"/>
                <c:pt idx="0">
                  <c:v>0</c:v>
                </c:pt>
                <c:pt idx="1">
                  <c:v>1</c:v>
                </c:pt>
                <c:pt idx="2">
                  <c:v>5</c:v>
                </c:pt>
                <c:pt idx="3">
                  <c:v>25</c:v>
                </c:pt>
                <c:pt idx="4">
                  <c:v>40</c:v>
                </c:pt>
                <c:pt idx="5">
                  <c:v>80</c:v>
                </c:pt>
                <c:pt idx="6">
                  <c:v>200</c:v>
                </c:pt>
                <c:pt idx="7">
                  <c:v>SOD</c:v>
                </c:pt>
              </c:strCache>
            </c:strRef>
          </c:cat>
          <c:val>
            <c:numRef>
              <c:f>Sheet1!$J$116:$Q$116</c:f>
              <c:numCache>
                <c:formatCode>General</c:formatCode>
                <c:ptCount val="8"/>
                <c:pt idx="0">
                  <c:v>0.01</c:v>
                </c:pt>
                <c:pt idx="1">
                  <c:v>0.1</c:v>
                </c:pt>
                <c:pt idx="2">
                  <c:v>0.1</c:v>
                </c:pt>
                <c:pt idx="3">
                  <c:v>0.1</c:v>
                </c:pt>
                <c:pt idx="4">
                  <c:v>0.21786492374727701</c:v>
                </c:pt>
                <c:pt idx="5">
                  <c:v>5.4466230936819242</c:v>
                </c:pt>
                <c:pt idx="6">
                  <c:v>6.9716775599128624</c:v>
                </c:pt>
                <c:pt idx="7">
                  <c:v>99.12854030501087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3F6B-472A-82A0-03F84FC351B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024708960"/>
        <c:axId val="-2024714400"/>
      </c:barChart>
      <c:catAx>
        <c:axId val="-202470896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2024714400"/>
        <c:crosses val="autoZero"/>
        <c:auto val="1"/>
        <c:lblAlgn val="ctr"/>
        <c:lblOffset val="100"/>
        <c:noMultiLvlLbl val="0"/>
      </c:catAx>
      <c:valAx>
        <c:axId val="-2024714400"/>
        <c:scaling>
          <c:orientation val="minMax"/>
          <c:max val="11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dirty="0"/>
                  <a:t>Inhibition (%)</a:t>
                </a:r>
                <a:endParaRPr lang="ko-KR" dirty="0"/>
              </a:p>
            </c:rich>
          </c:tx>
          <c:layout>
            <c:manualLayout>
              <c:xMode val="edge"/>
              <c:yMode val="edge"/>
              <c:x val="2.7401292639087201E-2"/>
              <c:y val="0.2467654499457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in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20247089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 b="1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891475306941292"/>
          <c:y val="3.2512626051222154E-2"/>
          <c:w val="0.77755421023327964"/>
          <c:h val="0.7287657645650818"/>
        </c:manualLayout>
      </c:layout>
      <c:barChart>
        <c:barDir val="col"/>
        <c:grouping val="clustered"/>
        <c:varyColors val="0"/>
        <c:ser>
          <c:idx val="0"/>
          <c:order val="0"/>
          <c:spPr>
            <a:noFill/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6!$H$423:$O$423</c:f>
                <c:numCache>
                  <c:formatCode>General</c:formatCode>
                  <c:ptCount val="8"/>
                  <c:pt idx="0">
                    <c:v>0.01</c:v>
                  </c:pt>
                  <c:pt idx="1">
                    <c:v>0.01</c:v>
                  </c:pt>
                  <c:pt idx="2">
                    <c:v>0.01</c:v>
                  </c:pt>
                  <c:pt idx="3">
                    <c:v>0.01</c:v>
                  </c:pt>
                  <c:pt idx="4">
                    <c:v>0.4</c:v>
                  </c:pt>
                  <c:pt idx="5">
                    <c:v>0.05</c:v>
                  </c:pt>
                  <c:pt idx="6">
                    <c:v>0.4</c:v>
                  </c:pt>
                  <c:pt idx="7">
                    <c:v>3.4107402031930358</c:v>
                  </c:pt>
                </c:numCache>
              </c:numRef>
            </c:plus>
            <c:minus>
              <c:numRef>
                <c:f>Sheet6!$H$423:$O$423</c:f>
                <c:numCache>
                  <c:formatCode>General</c:formatCode>
                  <c:ptCount val="8"/>
                  <c:pt idx="0">
                    <c:v>0.01</c:v>
                  </c:pt>
                  <c:pt idx="1">
                    <c:v>0.01</c:v>
                  </c:pt>
                  <c:pt idx="2">
                    <c:v>0.01</c:v>
                  </c:pt>
                  <c:pt idx="3">
                    <c:v>0.01</c:v>
                  </c:pt>
                  <c:pt idx="4">
                    <c:v>0.4</c:v>
                  </c:pt>
                  <c:pt idx="5">
                    <c:v>0.05</c:v>
                  </c:pt>
                  <c:pt idx="6">
                    <c:v>0.4</c:v>
                  </c:pt>
                  <c:pt idx="7">
                    <c:v>3.410740203193035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6!$H$421:$O$421</c:f>
              <c:strCache>
                <c:ptCount val="8"/>
                <c:pt idx="0">
                  <c:v>0</c:v>
                </c:pt>
                <c:pt idx="1">
                  <c:v>1</c:v>
                </c:pt>
                <c:pt idx="2">
                  <c:v>5</c:v>
                </c:pt>
                <c:pt idx="3">
                  <c:v>25</c:v>
                </c:pt>
                <c:pt idx="4">
                  <c:v>40</c:v>
                </c:pt>
                <c:pt idx="5">
                  <c:v>80</c:v>
                </c:pt>
                <c:pt idx="6">
                  <c:v>200</c:v>
                </c:pt>
                <c:pt idx="7">
                  <c:v>Catalase</c:v>
                </c:pt>
              </c:strCache>
            </c:strRef>
          </c:cat>
          <c:val>
            <c:numRef>
              <c:f>Sheet6!$H$422:$O$422</c:f>
              <c:numCache>
                <c:formatCode>General</c:formatCode>
                <c:ptCount val="8"/>
                <c:pt idx="0">
                  <c:v>3.6700000000000003E-2</c:v>
                </c:pt>
                <c:pt idx="1">
                  <c:v>5.8700000000000002E-2</c:v>
                </c:pt>
                <c:pt idx="2">
                  <c:v>4.6899999999999997E-2</c:v>
                </c:pt>
                <c:pt idx="3">
                  <c:v>0.109</c:v>
                </c:pt>
                <c:pt idx="4">
                  <c:v>2.104499274310605</c:v>
                </c:pt>
                <c:pt idx="5">
                  <c:v>4.499274310595073</c:v>
                </c:pt>
                <c:pt idx="6">
                  <c:v>4.4267053701016028</c:v>
                </c:pt>
                <c:pt idx="7">
                  <c:v>89.55007256894047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A4DD-4988-855A-5CC36D48335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024704608"/>
        <c:axId val="-2024707328"/>
      </c:barChart>
      <c:catAx>
        <c:axId val="-20247046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2024707328"/>
        <c:crosses val="autoZero"/>
        <c:auto val="1"/>
        <c:lblAlgn val="ctr"/>
        <c:lblOffset val="100"/>
        <c:noMultiLvlLbl val="0"/>
      </c:catAx>
      <c:valAx>
        <c:axId val="-2024707328"/>
        <c:scaling>
          <c:orientation val="minMax"/>
          <c:max val="110"/>
          <c:min val="0"/>
        </c:scaling>
        <c:delete val="0"/>
        <c:axPos val="l"/>
        <c:numFmt formatCode="General" sourceLinked="1"/>
        <c:majorTickMark val="out"/>
        <c:minorTickMark val="in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20247046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 b="1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6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backward val="0.2"/>
            <c:dispRSqr val="0"/>
            <c:dispEq val="0"/>
          </c:trendline>
          <c:xVal>
            <c:numRef>
              <c:f>Sheet4!$J$73:$O$73</c:f>
              <c:numCache>
                <c:formatCode>General</c:formatCode>
                <c:ptCount val="6"/>
                <c:pt idx="0">
                  <c:v>0.5</c:v>
                </c:pt>
                <c:pt idx="1">
                  <c:v>0.25</c:v>
                </c:pt>
                <c:pt idx="2">
                  <c:v>8.3333333333333301E-2</c:v>
                </c:pt>
                <c:pt idx="3">
                  <c:v>0.05</c:v>
                </c:pt>
                <c:pt idx="4">
                  <c:v>3.3333333333333298E-2</c:v>
                </c:pt>
                <c:pt idx="5">
                  <c:v>2.5000000000000001E-2</c:v>
                </c:pt>
              </c:numCache>
            </c:numRef>
          </c:xVal>
          <c:yVal>
            <c:numRef>
              <c:f>Sheet4!$J$75:$O$75</c:f>
              <c:numCache>
                <c:formatCode>General</c:formatCode>
                <c:ptCount val="6"/>
                <c:pt idx="0">
                  <c:v>1.5511221945137159</c:v>
                </c:pt>
                <c:pt idx="1">
                  <c:v>0.65336134453781503</c:v>
                </c:pt>
                <c:pt idx="2">
                  <c:v>0.27743086529883998</c:v>
                </c:pt>
                <c:pt idx="3">
                  <c:v>0.206028486253726</c:v>
                </c:pt>
                <c:pt idx="4">
                  <c:v>0.18013321749203601</c:v>
                </c:pt>
                <c:pt idx="5">
                  <c:v>0.169491525423729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24FB-4C97-A657-BA4B31A1CE3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24714944"/>
        <c:axId val="-2024702976"/>
      </c:scatterChart>
      <c:valAx>
        <c:axId val="-2024714944"/>
        <c:scaling>
          <c:orientation val="minMax"/>
          <c:max val="0.6"/>
          <c:min val="-0.2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2024702976"/>
        <c:crosses val="autoZero"/>
        <c:crossBetween val="midCat"/>
        <c:majorUnit val="0.2"/>
      </c:valAx>
      <c:valAx>
        <c:axId val="-2024702976"/>
        <c:scaling>
          <c:orientation val="minMax"/>
          <c:min val="-0.5"/>
        </c:scaling>
        <c:delete val="0"/>
        <c:axPos val="l"/>
        <c:numFmt formatCode="General" sourceLinked="1"/>
        <c:majorTickMark val="out"/>
        <c:minorTickMark val="in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202471494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 b="1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7!$C$30:$J$30</c:f>
                <c:numCache>
                  <c:formatCode>General</c:formatCode>
                  <c:ptCount val="8"/>
                  <c:pt idx="0">
                    <c:v>1595.5</c:v>
                  </c:pt>
                  <c:pt idx="1">
                    <c:v>11423.25</c:v>
                  </c:pt>
                  <c:pt idx="2">
                    <c:v>7093</c:v>
                  </c:pt>
                  <c:pt idx="3">
                    <c:v>4657</c:v>
                  </c:pt>
                  <c:pt idx="4">
                    <c:v>3865.5</c:v>
                  </c:pt>
                  <c:pt idx="5">
                    <c:v>4815</c:v>
                  </c:pt>
                  <c:pt idx="6">
                    <c:v>212</c:v>
                  </c:pt>
                  <c:pt idx="7">
                    <c:v>2980.5</c:v>
                  </c:pt>
                </c:numCache>
              </c:numRef>
            </c:plus>
            <c:minus>
              <c:numRef>
                <c:f>Sheet7!$C$30:$J$30</c:f>
                <c:numCache>
                  <c:formatCode>General</c:formatCode>
                  <c:ptCount val="8"/>
                  <c:pt idx="0">
                    <c:v>1595.5</c:v>
                  </c:pt>
                  <c:pt idx="1">
                    <c:v>11423.25</c:v>
                  </c:pt>
                  <c:pt idx="2">
                    <c:v>7093</c:v>
                  </c:pt>
                  <c:pt idx="3">
                    <c:v>4657</c:v>
                  </c:pt>
                  <c:pt idx="4">
                    <c:v>3865.5</c:v>
                  </c:pt>
                  <c:pt idx="5">
                    <c:v>4815</c:v>
                  </c:pt>
                  <c:pt idx="6">
                    <c:v>212</c:v>
                  </c:pt>
                  <c:pt idx="7">
                    <c:v>2980.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7!$C$22:$G$22</c:f>
              <c:strCache>
                <c:ptCount val="5"/>
                <c:pt idx="0">
                  <c:v>None</c:v>
                </c:pt>
                <c:pt idx="1">
                  <c:v>1S</c:v>
                </c:pt>
                <c:pt idx="2">
                  <c:v>2S</c:v>
                </c:pt>
                <c:pt idx="3">
                  <c:v>1C</c:v>
                </c:pt>
                <c:pt idx="4">
                  <c:v>2C</c:v>
                </c:pt>
              </c:strCache>
            </c:strRef>
          </c:cat>
          <c:val>
            <c:numRef>
              <c:f>Sheet7!$C$23:$G$23</c:f>
              <c:numCache>
                <c:formatCode>General</c:formatCode>
                <c:ptCount val="5"/>
                <c:pt idx="0">
                  <c:v>245887.56756756754</c:v>
                </c:pt>
                <c:pt idx="1">
                  <c:v>247406.04395604396</c:v>
                </c:pt>
                <c:pt idx="2">
                  <c:v>246932.5</c:v>
                </c:pt>
                <c:pt idx="3">
                  <c:v>104518.24324324324</c:v>
                </c:pt>
                <c:pt idx="4">
                  <c:v>101767.7631578947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4EDD-4D4B-A212-3BDD9241080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024718208"/>
        <c:axId val="-2024713856"/>
      </c:barChart>
      <c:catAx>
        <c:axId val="-20247182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2024713856"/>
        <c:crosses val="autoZero"/>
        <c:auto val="1"/>
        <c:lblAlgn val="ctr"/>
        <c:lblOffset val="100"/>
        <c:noMultiLvlLbl val="0"/>
      </c:catAx>
      <c:valAx>
        <c:axId val="-2024713856"/>
        <c:scaling>
          <c:orientation val="minMax"/>
        </c:scaling>
        <c:delete val="0"/>
        <c:axPos val="l"/>
        <c:numFmt formatCode="General" sourceLinked="1"/>
        <c:majorTickMark val="out"/>
        <c:minorTickMark val="in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2024718208"/>
        <c:crosses val="autoZero"/>
        <c:crossBetween val="between"/>
        <c:dispUnits>
          <c:builtInUnit val="tenThousands"/>
        </c:dispUnits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 b="1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7309674651958201"/>
          <c:y val="4.2477004193514398E-2"/>
          <c:w val="0.73733541144051895"/>
          <c:h val="0.78067923157599595"/>
        </c:manualLayout>
      </c:layout>
      <c:scatterChart>
        <c:scatterStyle val="lineMarker"/>
        <c:varyColors val="0"/>
        <c:ser>
          <c:idx val="0"/>
          <c:order val="0"/>
          <c:tx>
            <c:strRef>
              <c:f>ATP!$M$25</c:f>
              <c:strCache>
                <c:ptCount val="1"/>
                <c:pt idx="0">
                  <c:v>Light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ATP!$R$26:$R$30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986660624911462</c:v>
                  </c:pt>
                  <c:pt idx="2">
                    <c:v>1.315547499881947</c:v>
                  </c:pt>
                  <c:pt idx="3">
                    <c:v>0.65777374994098603</c:v>
                  </c:pt>
                  <c:pt idx="4">
                    <c:v>0.65777374994098603</c:v>
                  </c:pt>
                </c:numCache>
              </c:numRef>
            </c:plus>
            <c:minus>
              <c:numRef>
                <c:f>ATP!$R$26:$R$30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986660624911462</c:v>
                  </c:pt>
                  <c:pt idx="2">
                    <c:v>1.315547499881947</c:v>
                  </c:pt>
                  <c:pt idx="3">
                    <c:v>0.65777374994098603</c:v>
                  </c:pt>
                  <c:pt idx="4">
                    <c:v>0.6577737499409860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ATP!$L$26:$L$30</c:f>
              <c:numCache>
                <c:formatCode>General</c:formatCode>
                <c:ptCount val="5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</c:numCache>
            </c:numRef>
          </c:xVal>
          <c:yVal>
            <c:numRef>
              <c:f>ATP!$O$12:$O$15</c:f>
              <c:numCache>
                <c:formatCode>General</c:formatCode>
                <c:ptCount val="4"/>
                <c:pt idx="0">
                  <c:v>0</c:v>
                </c:pt>
                <c:pt idx="1">
                  <c:v>10.930232558139529</c:v>
                </c:pt>
                <c:pt idx="2">
                  <c:v>16.744186046511629</c:v>
                </c:pt>
                <c:pt idx="3">
                  <c:v>18.25581395348838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2B13-4580-8364-DD1131B7A9D5}"/>
            </c:ext>
          </c:extLst>
        </c:ser>
        <c:ser>
          <c:idx val="1"/>
          <c:order val="1"/>
          <c:tx>
            <c:strRef>
              <c:f>ATP!$N$25</c:f>
              <c:strCache>
                <c:ptCount val="1"/>
                <c:pt idx="0">
                  <c:v>Dark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ATP!$S$26:$S$30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65777374994097604</c:v>
                  </c:pt>
                  <c:pt idx="2">
                    <c:v>1.644434374852441</c:v>
                  </c:pt>
                  <c:pt idx="3">
                    <c:v>0.32888687497049302</c:v>
                  </c:pt>
                  <c:pt idx="4">
                    <c:v>0.32888687497048502</c:v>
                  </c:pt>
                </c:numCache>
              </c:numRef>
            </c:plus>
            <c:minus>
              <c:numRef>
                <c:f>ATP!$S$26:$S$30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65777374994097604</c:v>
                  </c:pt>
                  <c:pt idx="2">
                    <c:v>1.644434374852441</c:v>
                  </c:pt>
                  <c:pt idx="3">
                    <c:v>0.32888687497049302</c:v>
                  </c:pt>
                  <c:pt idx="4">
                    <c:v>0.3288868749704850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ATP!$L$26:$L$30</c:f>
              <c:numCache>
                <c:formatCode>General</c:formatCode>
                <c:ptCount val="5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</c:numCache>
            </c:numRef>
          </c:xVal>
          <c:yVal>
            <c:numRef>
              <c:f>ATP!$P$12:$P$15</c:f>
              <c:numCache>
                <c:formatCode>General</c:formatCode>
                <c:ptCount val="4"/>
                <c:pt idx="0">
                  <c:v>0</c:v>
                </c:pt>
                <c:pt idx="1">
                  <c:v>1.5116279069767451</c:v>
                </c:pt>
                <c:pt idx="2">
                  <c:v>4.5348837209302246</c:v>
                </c:pt>
                <c:pt idx="3">
                  <c:v>5.930232558139540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2B13-4580-8364-DD1131B7A9D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54094016"/>
        <c:axId val="-54093472"/>
      </c:scatterChart>
      <c:valAx>
        <c:axId val="-540940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54093472"/>
        <c:crosses val="autoZero"/>
        <c:crossBetween val="midCat"/>
        <c:majorUnit val="20"/>
      </c:valAx>
      <c:valAx>
        <c:axId val="-5409347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dirty="0"/>
                  <a:t>ATP (</a:t>
                </a:r>
                <a:r>
                  <a:rPr lang="el-GR" dirty="0"/>
                  <a:t>μ</a:t>
                </a:r>
                <a:r>
                  <a:rPr lang="en-US" dirty="0"/>
                  <a:t>M)</a:t>
                </a:r>
                <a:endParaRPr lang="ko-KR" dirty="0"/>
              </a:p>
            </c:rich>
          </c:tx>
          <c:layout>
            <c:manualLayout>
              <c:xMode val="edge"/>
              <c:yMode val="edge"/>
              <c:x val="2.0693579502197499E-2"/>
              <c:y val="0.2985424984590739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in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54094016"/>
        <c:crosses val="autoZero"/>
        <c:crossBetween val="midCat"/>
      </c:valAx>
      <c:spPr>
        <a:noFill/>
        <a:ln w="9525">
          <a:noFill/>
        </a:ln>
        <a:effectLst/>
      </c:spPr>
    </c:plotArea>
    <c:legend>
      <c:legendPos val="r"/>
      <c:layout>
        <c:manualLayout>
          <c:xMode val="edge"/>
          <c:yMode val="edge"/>
          <c:x val="0.18372861162826701"/>
          <c:y val="4.9177579550205901E-2"/>
          <c:w val="0.22546533393625201"/>
          <c:h val="0.10009749496808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513641998649101"/>
          <c:y val="3.4583103788854402E-2"/>
          <c:w val="0.73331581282477798"/>
          <c:h val="0.70702755102927295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4!$Q$18</c:f>
              <c:strCache>
                <c:ptCount val="1"/>
                <c:pt idx="0">
                  <c:v>Light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S$19:$S$23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34974</c:v>
                  </c:pt>
                  <c:pt idx="2">
                    <c:v>1.1644600000000001</c:v>
                  </c:pt>
                  <c:pt idx="3">
                    <c:v>0.78725000000000001</c:v>
                  </c:pt>
                  <c:pt idx="4">
                    <c:v>0.34759600000000002</c:v>
                  </c:pt>
                </c:numCache>
              </c:numRef>
            </c:plus>
            <c:minus>
              <c:numRef>
                <c:f>Sheet4!$S$19:$S$23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34974</c:v>
                  </c:pt>
                  <c:pt idx="2">
                    <c:v>1.1644600000000001</c:v>
                  </c:pt>
                  <c:pt idx="3">
                    <c:v>0.78725000000000001</c:v>
                  </c:pt>
                  <c:pt idx="4">
                    <c:v>0.3475960000000000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noEndCap val="0"/>
            <c:val val="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4!$P$19:$P$23</c:f>
              <c:numCache>
                <c:formatCode>General</c:formatCode>
                <c:ptCount val="5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</c:numCache>
            </c:numRef>
          </c:xVal>
          <c:yVal>
            <c:numRef>
              <c:f>Sheet4!$Q$19:$Q$23</c:f>
              <c:numCache>
                <c:formatCode>General</c:formatCode>
                <c:ptCount val="5"/>
                <c:pt idx="0">
                  <c:v>0</c:v>
                </c:pt>
                <c:pt idx="1">
                  <c:v>6.9947999999999997</c:v>
                </c:pt>
                <c:pt idx="2">
                  <c:v>11.644600000000001</c:v>
                </c:pt>
                <c:pt idx="3">
                  <c:v>15.744999999999999</c:v>
                </c:pt>
                <c:pt idx="4">
                  <c:v>17.3798000000000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C8C7-414D-9686-7B79BA66DD76}"/>
            </c:ext>
          </c:extLst>
        </c:ser>
        <c:ser>
          <c:idx val="1"/>
          <c:order val="1"/>
          <c:tx>
            <c:strRef>
              <c:f>Sheet4!$R$18</c:f>
              <c:strCache>
                <c:ptCount val="1"/>
                <c:pt idx="0">
                  <c:v>Dark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T$19:$T$23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1</c:v>
                  </c:pt>
                  <c:pt idx="2">
                    <c:v>0.24</c:v>
                  </c:pt>
                  <c:pt idx="3">
                    <c:v>0.6</c:v>
                  </c:pt>
                  <c:pt idx="4">
                    <c:v>1.9E-2</c:v>
                  </c:pt>
                </c:numCache>
              </c:numRef>
            </c:plus>
            <c:minus>
              <c:numRef>
                <c:f>Sheet4!$T$19:$T$23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1</c:v>
                  </c:pt>
                  <c:pt idx="2">
                    <c:v>0.24</c:v>
                  </c:pt>
                  <c:pt idx="3">
                    <c:v>0.6</c:v>
                  </c:pt>
                  <c:pt idx="4">
                    <c:v>1.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noEndCap val="0"/>
            <c:val val="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4!$P$19:$P$23</c:f>
              <c:numCache>
                <c:formatCode>General</c:formatCode>
                <c:ptCount val="5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</c:numCache>
            </c:numRef>
          </c:xVal>
          <c:yVal>
            <c:numRef>
              <c:f>Sheet4!$R$19:$R$23</c:f>
              <c:numCache>
                <c:formatCode>General</c:formatCode>
                <c:ptCount val="5"/>
                <c:pt idx="0">
                  <c:v>0</c:v>
                </c:pt>
                <c:pt idx="1">
                  <c:v>0</c:v>
                </c:pt>
                <c:pt idx="2">
                  <c:v>1.2</c:v>
                </c:pt>
                <c:pt idx="3">
                  <c:v>2</c:v>
                </c:pt>
                <c:pt idx="4">
                  <c:v>1.9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C8C7-414D-9686-7B79BA66DD7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54085856"/>
        <c:axId val="-54098368"/>
      </c:scatterChart>
      <c:valAx>
        <c:axId val="-54085856"/>
        <c:scaling>
          <c:orientation val="minMax"/>
          <c:max val="12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54098368"/>
        <c:crosses val="autoZero"/>
        <c:crossBetween val="midCat"/>
        <c:majorUnit val="20"/>
      </c:valAx>
      <c:valAx>
        <c:axId val="-54098368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dirty="0"/>
                  <a:t>NADPH (µM)</a:t>
                </a:r>
                <a:endParaRPr lang="ko-KR" dirty="0"/>
              </a:p>
            </c:rich>
          </c:tx>
          <c:layout>
            <c:manualLayout>
              <c:xMode val="edge"/>
              <c:yMode val="edge"/>
              <c:x val="3.7136649431012698E-2"/>
              <c:y val="0.2437341472014450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in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54085856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39601846041738"/>
          <c:y val="5.38117545433403E-2"/>
          <c:w val="0.34594761451733702"/>
          <c:h val="9.729160437223829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 b="1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970926042224299"/>
          <c:y val="5.9632771802754697E-2"/>
          <c:w val="0.80676228730869903"/>
          <c:h val="0.79212700955889004"/>
        </c:manualLayout>
      </c:layout>
      <c:barChart>
        <c:barDir val="col"/>
        <c:grouping val="clustered"/>
        <c:varyColors val="0"/>
        <c:ser>
          <c:idx val="1"/>
          <c:order val="0"/>
          <c:spPr>
            <a:noFill/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5!$E$143:$E$149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1.500000000000002</c:v>
                  </c:pt>
                  <c:pt idx="2">
                    <c:v>0.83333333333334403</c:v>
                  </c:pt>
                  <c:pt idx="3">
                    <c:v>0.58333333333333404</c:v>
                  </c:pt>
                  <c:pt idx="4">
                    <c:v>0.66666666666666696</c:v>
                  </c:pt>
                  <c:pt idx="5">
                    <c:v>0.33333333333333398</c:v>
                  </c:pt>
                  <c:pt idx="6">
                    <c:v>8.3333333333333204E-2</c:v>
                  </c:pt>
                </c:numCache>
              </c:numRef>
            </c:plus>
            <c:minus>
              <c:numRef>
                <c:f>Sheet5!$E$143:$E$149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1.500000000000002</c:v>
                  </c:pt>
                  <c:pt idx="2">
                    <c:v>0.83333333333334403</c:v>
                  </c:pt>
                  <c:pt idx="3">
                    <c:v>0.58333333333333404</c:v>
                  </c:pt>
                  <c:pt idx="4">
                    <c:v>0.66666666666666696</c:v>
                  </c:pt>
                  <c:pt idx="5">
                    <c:v>0.33333333333333398</c:v>
                  </c:pt>
                  <c:pt idx="6">
                    <c:v>8.333333333333320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5!$B$143:$B$149</c:f>
              <c:numCache>
                <c:formatCode>General</c:formatCode>
                <c:ptCount val="7"/>
                <c:pt idx="0">
                  <c:v>0</c:v>
                </c:pt>
                <c:pt idx="1">
                  <c:v>0</c:v>
                </c:pt>
                <c:pt idx="2">
                  <c:v>1</c:v>
                </c:pt>
                <c:pt idx="3">
                  <c:v>5</c:v>
                </c:pt>
                <c:pt idx="4">
                  <c:v>10</c:v>
                </c:pt>
                <c:pt idx="5">
                  <c:v>20</c:v>
                </c:pt>
                <c:pt idx="6">
                  <c:v>50</c:v>
                </c:pt>
              </c:numCache>
            </c:numRef>
          </c:cat>
          <c:val>
            <c:numRef>
              <c:f>Sheet5!$S$133:$S$139</c:f>
              <c:numCache>
                <c:formatCode>General</c:formatCode>
                <c:ptCount val="7"/>
                <c:pt idx="0">
                  <c:v>15.297439126784241</c:v>
                </c:pt>
                <c:pt idx="1">
                  <c:v>15.936604018768371</c:v>
                </c:pt>
                <c:pt idx="2">
                  <c:v>19.558559477579362</c:v>
                </c:pt>
                <c:pt idx="3">
                  <c:v>29.99831344709342</c:v>
                </c:pt>
                <c:pt idx="4">
                  <c:v>34.580660715344777</c:v>
                </c:pt>
                <c:pt idx="5">
                  <c:v>17.641053646444131</c:v>
                </c:pt>
                <c:pt idx="6">
                  <c:v>12.31464855995736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A3E-4FCF-9841-3138035AF32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75"/>
        <c:overlap val="-27"/>
        <c:axId val="-54096736"/>
        <c:axId val="-54095104"/>
      </c:barChart>
      <c:catAx>
        <c:axId val="-540967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54095104"/>
        <c:crosses val="autoZero"/>
        <c:auto val="1"/>
        <c:lblAlgn val="ctr"/>
        <c:lblOffset val="100"/>
        <c:noMultiLvlLbl val="0"/>
      </c:catAx>
      <c:valAx>
        <c:axId val="-54095104"/>
        <c:scaling>
          <c:orientation val="minMax"/>
          <c:max val="50"/>
        </c:scaling>
        <c:delete val="0"/>
        <c:axPos val="l"/>
        <c:numFmt formatCode="General" sourceLinked="1"/>
        <c:majorTickMark val="out"/>
        <c:minorTickMark val="in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540967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 b="1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114705897539001"/>
          <c:y val="4.95786845981964E-2"/>
          <c:w val="0.76327935521028401"/>
          <c:h val="0.84367267770444399"/>
        </c:manualLayout>
      </c:layout>
      <c:barChart>
        <c:barDir val="col"/>
        <c:grouping val="clustered"/>
        <c:varyColors val="0"/>
        <c:ser>
          <c:idx val="0"/>
          <c:order val="0"/>
          <c:spPr>
            <a:noFill/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5!$T$162:$T$165</c:f>
                <c:numCache>
                  <c:formatCode>General</c:formatCode>
                  <c:ptCount val="4"/>
                  <c:pt idx="0">
                    <c:v>0.500000000000001</c:v>
                  </c:pt>
                  <c:pt idx="1">
                    <c:v>1.5000000000000011</c:v>
                  </c:pt>
                  <c:pt idx="2">
                    <c:v>1.0000000000000011</c:v>
                  </c:pt>
                  <c:pt idx="3">
                    <c:v>1.9999999999999769</c:v>
                  </c:pt>
                </c:numCache>
              </c:numRef>
            </c:plus>
            <c:minus>
              <c:numRef>
                <c:f>Sheet5!$T$162:$T$165</c:f>
                <c:numCache>
                  <c:formatCode>General</c:formatCode>
                  <c:ptCount val="4"/>
                  <c:pt idx="0">
                    <c:v>0.500000000000001</c:v>
                  </c:pt>
                  <c:pt idx="1">
                    <c:v>1.5000000000000011</c:v>
                  </c:pt>
                  <c:pt idx="2">
                    <c:v>1.0000000000000011</c:v>
                  </c:pt>
                  <c:pt idx="3">
                    <c:v>1.999999999999976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5!$A$162:$A$165</c:f>
              <c:numCache>
                <c:formatCode>General</c:formatCode>
                <c:ptCount val="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5</c:v>
                </c:pt>
              </c:numCache>
            </c:numRef>
          </c:cat>
          <c:val>
            <c:numRef>
              <c:f>Sheet5!$U$162:$U$165</c:f>
              <c:numCache>
                <c:formatCode>General</c:formatCode>
                <c:ptCount val="4"/>
                <c:pt idx="0">
                  <c:v>33.916843141119998</c:v>
                </c:pt>
                <c:pt idx="1">
                  <c:v>35.435507759379099</c:v>
                </c:pt>
                <c:pt idx="2">
                  <c:v>35.435507759379092</c:v>
                </c:pt>
                <c:pt idx="3">
                  <c:v>32.59308735087275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A8ED-45CA-9380-C53490FF747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38"/>
        <c:axId val="-54092928"/>
        <c:axId val="-114360048"/>
      </c:barChart>
      <c:catAx>
        <c:axId val="-540929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114360048"/>
        <c:crosses val="autoZero"/>
        <c:auto val="1"/>
        <c:lblAlgn val="ctr"/>
        <c:lblOffset val="100"/>
        <c:noMultiLvlLbl val="1"/>
      </c:catAx>
      <c:valAx>
        <c:axId val="-114360048"/>
        <c:scaling>
          <c:orientation val="minMax"/>
          <c:max val="50"/>
          <c:min val="0"/>
        </c:scaling>
        <c:delete val="0"/>
        <c:axPos val="l"/>
        <c:numFmt formatCode="General" sourceLinked="1"/>
        <c:majorTickMark val="out"/>
        <c:minorTickMark val="in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540929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 b="1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95"/>
          <c:y val="5.3109612102895297E-2"/>
          <c:w val="0.77938888888888902"/>
          <c:h val="0.81955544957797299"/>
        </c:manualLayout>
      </c:layout>
      <c:barChart>
        <c:barDir val="col"/>
        <c:grouping val="clustered"/>
        <c:varyColors val="0"/>
        <c:ser>
          <c:idx val="1"/>
          <c:order val="0"/>
          <c:spPr>
            <a:noFill/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5!$S$115:$S$119</c:f>
                <c:numCache>
                  <c:formatCode>General</c:formatCode>
                  <c:ptCount val="5"/>
                  <c:pt idx="0">
                    <c:v>0.58333333333333404</c:v>
                  </c:pt>
                  <c:pt idx="1">
                    <c:v>0.66666666666666696</c:v>
                  </c:pt>
                  <c:pt idx="2">
                    <c:v>0.500000000000001</c:v>
                  </c:pt>
                  <c:pt idx="3">
                    <c:v>0.41666666666666702</c:v>
                  </c:pt>
                  <c:pt idx="4">
                    <c:v>0.83333333333332904</c:v>
                  </c:pt>
                </c:numCache>
              </c:numRef>
            </c:plus>
            <c:minus>
              <c:numRef>
                <c:f>Sheet5!$S$115:$S$119</c:f>
                <c:numCache>
                  <c:formatCode>General</c:formatCode>
                  <c:ptCount val="5"/>
                  <c:pt idx="0">
                    <c:v>0.58333333333333404</c:v>
                  </c:pt>
                  <c:pt idx="1">
                    <c:v>0.66666666666666696</c:v>
                  </c:pt>
                  <c:pt idx="2">
                    <c:v>0.500000000000001</c:v>
                  </c:pt>
                  <c:pt idx="3">
                    <c:v>0.41666666666666702</c:v>
                  </c:pt>
                  <c:pt idx="4">
                    <c:v>0.8333333333333290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5!$A$115:$A$119</c:f>
              <c:numCache>
                <c:formatCode>General</c:formatCode>
                <c:ptCount val="5"/>
                <c:pt idx="0">
                  <c:v>0</c:v>
                </c:pt>
                <c:pt idx="1">
                  <c:v>1</c:v>
                </c:pt>
                <c:pt idx="2">
                  <c:v>2.5</c:v>
                </c:pt>
                <c:pt idx="3">
                  <c:v>5</c:v>
                </c:pt>
                <c:pt idx="4">
                  <c:v>10</c:v>
                </c:pt>
              </c:numCache>
            </c:numRef>
          </c:cat>
          <c:val>
            <c:numRef>
              <c:f>Sheet5!$U$115:$U$119</c:f>
              <c:numCache>
                <c:formatCode>General</c:formatCode>
                <c:ptCount val="5"/>
                <c:pt idx="0">
                  <c:v>34.25</c:v>
                </c:pt>
                <c:pt idx="1">
                  <c:v>35</c:v>
                </c:pt>
                <c:pt idx="2">
                  <c:v>41.034482758620697</c:v>
                </c:pt>
                <c:pt idx="3">
                  <c:v>45.632183908045953</c:v>
                </c:pt>
                <c:pt idx="4">
                  <c:v>43.9080459770114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847B-4D42-AD55-8B9250E7743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114357328"/>
        <c:axId val="-3796704"/>
      </c:barChart>
      <c:catAx>
        <c:axId val="-1143573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3796704"/>
        <c:crosses val="autoZero"/>
        <c:auto val="1"/>
        <c:lblAlgn val="ctr"/>
        <c:lblOffset val="100"/>
        <c:noMultiLvlLbl val="0"/>
      </c:catAx>
      <c:valAx>
        <c:axId val="-3796704"/>
        <c:scaling>
          <c:orientation val="minMax"/>
        </c:scaling>
        <c:delete val="0"/>
        <c:axPos val="l"/>
        <c:numFmt formatCode="General" sourceLinked="1"/>
        <c:majorTickMark val="out"/>
        <c:minorTickMark val="in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1143573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 b="1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482123586086043"/>
          <c:y val="5.4224854292611528E-2"/>
          <c:w val="0.82177411246782628"/>
          <c:h val="0.84370517682878543"/>
        </c:manualLayout>
      </c:layout>
      <c:barChart>
        <c:barDir val="col"/>
        <c:grouping val="clustered"/>
        <c:varyColors val="0"/>
        <c:ser>
          <c:idx val="1"/>
          <c:order val="0"/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2!$F$48:$F$52</c:f>
                <c:numCache>
                  <c:formatCode>General</c:formatCode>
                  <c:ptCount val="5"/>
                  <c:pt idx="0">
                    <c:v>1.5269999999999999</c:v>
                  </c:pt>
                  <c:pt idx="1">
                    <c:v>2.1289800000000003</c:v>
                  </c:pt>
                  <c:pt idx="2">
                    <c:v>1.3974000000000002</c:v>
                  </c:pt>
                  <c:pt idx="3">
                    <c:v>1.87416</c:v>
                  </c:pt>
                  <c:pt idx="4">
                    <c:v>0.59595000000000009</c:v>
                  </c:pt>
                </c:numCache>
              </c:numRef>
            </c:plus>
            <c:minus>
              <c:numRef>
                <c:f>Sheet12!$F$48:$F$52</c:f>
                <c:numCache>
                  <c:formatCode>General</c:formatCode>
                  <c:ptCount val="5"/>
                  <c:pt idx="0">
                    <c:v>1.5269999999999999</c:v>
                  </c:pt>
                  <c:pt idx="1">
                    <c:v>2.1289800000000003</c:v>
                  </c:pt>
                  <c:pt idx="2">
                    <c:v>1.3974000000000002</c:v>
                  </c:pt>
                  <c:pt idx="3">
                    <c:v>1.87416</c:v>
                  </c:pt>
                  <c:pt idx="4">
                    <c:v>0.5959500000000000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2!$C$48:$C$52</c:f>
              <c:numCache>
                <c:formatCode>General</c:formatCode>
                <c:ptCount val="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5</c:v>
                </c:pt>
                <c:pt idx="4">
                  <c:v>10</c:v>
                </c:pt>
              </c:numCache>
            </c:numRef>
          </c:cat>
          <c:val>
            <c:numRef>
              <c:f>Sheet12!$E$48:$E$52</c:f>
              <c:numCache>
                <c:formatCode>General</c:formatCode>
                <c:ptCount val="5"/>
                <c:pt idx="0">
                  <c:v>50.9</c:v>
                </c:pt>
                <c:pt idx="1">
                  <c:v>30.414000000000001</c:v>
                </c:pt>
                <c:pt idx="2">
                  <c:v>23.290000000000003</c:v>
                </c:pt>
                <c:pt idx="3">
                  <c:v>20.824000000000002</c:v>
                </c:pt>
                <c:pt idx="4">
                  <c:v>19.86500000000000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8346-4F6C-B42D-FE0C4209D0A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3800512"/>
        <c:axId val="-3790176"/>
      </c:barChart>
      <c:catAx>
        <c:axId val="-38005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3790176"/>
        <c:crosses val="autoZero"/>
        <c:auto val="1"/>
        <c:lblAlgn val="ctr"/>
        <c:lblOffset val="100"/>
        <c:noMultiLvlLbl val="0"/>
      </c:catAx>
      <c:valAx>
        <c:axId val="-3790176"/>
        <c:scaling>
          <c:orientation val="minMax"/>
        </c:scaling>
        <c:delete val="0"/>
        <c:axPos val="l"/>
        <c:numFmt formatCode="General" sourceLinked="1"/>
        <c:majorTickMark val="out"/>
        <c:minorTickMark val="in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38005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 b="1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428747176483"/>
          <c:y val="7.9387543074687497E-2"/>
          <c:w val="0.68300131774697004"/>
          <c:h val="0.69476824762534495"/>
        </c:manualLayout>
      </c:layout>
      <c:barChart>
        <c:barDir val="col"/>
        <c:grouping val="clustered"/>
        <c:varyColors val="0"/>
        <c:ser>
          <c:idx val="1"/>
          <c:order val="0"/>
          <c:spPr>
            <a:noFill/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5!$R$212:$R$216</c:f>
                <c:numCache>
                  <c:formatCode>General</c:formatCode>
                  <c:ptCount val="5"/>
                  <c:pt idx="0">
                    <c:v>0.83333333333333404</c:v>
                  </c:pt>
                  <c:pt idx="1">
                    <c:v>0.55555555555555702</c:v>
                  </c:pt>
                  <c:pt idx="2">
                    <c:v>2.2222222222222241</c:v>
                  </c:pt>
                  <c:pt idx="3">
                    <c:v>0.27777777777777901</c:v>
                  </c:pt>
                  <c:pt idx="4">
                    <c:v>1.1111111111110961</c:v>
                  </c:pt>
                </c:numCache>
              </c:numRef>
            </c:plus>
            <c:minus>
              <c:numRef>
                <c:f>Sheet5!$R$212:$R$216</c:f>
                <c:numCache>
                  <c:formatCode>General</c:formatCode>
                  <c:ptCount val="5"/>
                  <c:pt idx="0">
                    <c:v>0.83333333333333404</c:v>
                  </c:pt>
                  <c:pt idx="1">
                    <c:v>0.55555555555555702</c:v>
                  </c:pt>
                  <c:pt idx="2">
                    <c:v>2.2222222222222241</c:v>
                  </c:pt>
                  <c:pt idx="3">
                    <c:v>0.27777777777777901</c:v>
                  </c:pt>
                  <c:pt idx="4">
                    <c:v>1.111111111111096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5!$B$212:$B$216</c:f>
              <c:numCache>
                <c:formatCode>General</c:formatCode>
                <c:ptCount val="5"/>
                <c:pt idx="0">
                  <c:v>0</c:v>
                </c:pt>
                <c:pt idx="1">
                  <c:v>1</c:v>
                </c:pt>
                <c:pt idx="2">
                  <c:v>2.5</c:v>
                </c:pt>
                <c:pt idx="3">
                  <c:v>5</c:v>
                </c:pt>
                <c:pt idx="4">
                  <c:v>10</c:v>
                </c:pt>
              </c:numCache>
            </c:numRef>
          </c:cat>
          <c:val>
            <c:numRef>
              <c:f>Sheet5!$Q$212:$Q$216</c:f>
              <c:numCache>
                <c:formatCode>General</c:formatCode>
                <c:ptCount val="5"/>
                <c:pt idx="0">
                  <c:v>41.883333333333297</c:v>
                </c:pt>
                <c:pt idx="1">
                  <c:v>54.13333333333334</c:v>
                </c:pt>
                <c:pt idx="2">
                  <c:v>56.466666666666633</c:v>
                </c:pt>
                <c:pt idx="3">
                  <c:v>46.549999999999983</c:v>
                </c:pt>
                <c:pt idx="4">
                  <c:v>35.46666666666666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76AB-4BC9-A4A3-C41FC65C14B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3802688"/>
        <c:axId val="-3795072"/>
      </c:barChart>
      <c:catAx>
        <c:axId val="-38026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3795072"/>
        <c:crosses val="autoZero"/>
        <c:auto val="1"/>
        <c:lblAlgn val="ctr"/>
        <c:lblOffset val="100"/>
        <c:noMultiLvlLbl val="0"/>
      </c:catAx>
      <c:valAx>
        <c:axId val="-3795072"/>
        <c:scaling>
          <c:orientation val="minMax"/>
          <c:max val="60"/>
        </c:scaling>
        <c:delete val="0"/>
        <c:axPos val="l"/>
        <c:numFmt formatCode="General" sourceLinked="1"/>
        <c:majorTickMark val="out"/>
        <c:minorTickMark val="in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38026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 b="1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73B1C01-9373-4B84-813C-CB35CE1B8B95}" type="datetimeFigureOut">
              <a:rPr lang="en-US" smtClean="0"/>
              <a:t>5/21/2022</a:t>
            </a:fld>
            <a:endParaRPr 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05A1991-D90C-40CD-94A0-EA0B6F20DB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2390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05A1991-D90C-40CD-94A0-EA0B6F20DBD5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772079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EC6827F-5C01-4B0B-9460-9FDDC48EE462}" type="slidenum">
              <a:rPr lang="en-US" smtClean="0"/>
              <a:t>1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029454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0B972-916D-428F-B278-F0C9AE6395A5}" type="datetimeFigureOut">
              <a:rPr lang="en-US" smtClean="0"/>
              <a:t>5/21/2022</a:t>
            </a:fld>
            <a:endParaRPr 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A603F-3859-4A56-992F-EAEB8FE092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6818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0B972-916D-428F-B278-F0C9AE6395A5}" type="datetimeFigureOut">
              <a:rPr lang="en-US" smtClean="0"/>
              <a:t>5/21/2022</a:t>
            </a:fld>
            <a:endParaRPr 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A603F-3859-4A56-992F-EAEB8FE092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99192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0B972-916D-428F-B278-F0C9AE6395A5}" type="datetimeFigureOut">
              <a:rPr lang="en-US" smtClean="0"/>
              <a:t>5/21/2022</a:t>
            </a:fld>
            <a:endParaRPr 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A603F-3859-4A56-992F-EAEB8FE092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20024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0B972-916D-428F-B278-F0C9AE6395A5}" type="datetimeFigureOut">
              <a:rPr lang="en-US" smtClean="0"/>
              <a:t>5/21/2022</a:t>
            </a:fld>
            <a:endParaRPr 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A603F-3859-4A56-992F-EAEB8FE092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38126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0B972-916D-428F-B278-F0C9AE6395A5}" type="datetimeFigureOut">
              <a:rPr lang="en-US" smtClean="0"/>
              <a:t>5/21/2022</a:t>
            </a:fld>
            <a:endParaRPr 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A603F-3859-4A56-992F-EAEB8FE092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88979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0B972-916D-428F-B278-F0C9AE6395A5}" type="datetimeFigureOut">
              <a:rPr lang="en-US" smtClean="0"/>
              <a:t>5/21/2022</a:t>
            </a:fld>
            <a:endParaRPr 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A603F-3859-4A56-992F-EAEB8FE092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73939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0B972-916D-428F-B278-F0C9AE6395A5}" type="datetimeFigureOut">
              <a:rPr lang="en-US" smtClean="0"/>
              <a:t>5/21/2022</a:t>
            </a:fld>
            <a:endParaRPr 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A603F-3859-4A56-992F-EAEB8FE092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2344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0B972-916D-428F-B278-F0C9AE6395A5}" type="datetimeFigureOut">
              <a:rPr lang="en-US" smtClean="0"/>
              <a:t>5/21/2022</a:t>
            </a:fld>
            <a:endParaRPr 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A603F-3859-4A56-992F-EAEB8FE092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00733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0B972-916D-428F-B278-F0C9AE6395A5}" type="datetimeFigureOut">
              <a:rPr lang="en-US" smtClean="0"/>
              <a:t>5/21/2022</a:t>
            </a:fld>
            <a:endParaRPr 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A603F-3859-4A56-992F-EAEB8FE092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6187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0B972-916D-428F-B278-F0C9AE6395A5}" type="datetimeFigureOut">
              <a:rPr lang="en-US" smtClean="0"/>
              <a:t>5/21/2022</a:t>
            </a:fld>
            <a:endParaRPr 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A603F-3859-4A56-992F-EAEB8FE092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86449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0B972-916D-428F-B278-F0C9AE6395A5}" type="datetimeFigureOut">
              <a:rPr lang="en-US" smtClean="0"/>
              <a:t>5/21/2022</a:t>
            </a:fld>
            <a:endParaRPr 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A603F-3859-4A56-992F-EAEB8FE092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47553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A0B972-916D-428F-B278-F0C9AE6395A5}" type="datetimeFigureOut">
              <a:rPr lang="en-US" smtClean="0"/>
              <a:t>5/21/2022</a:t>
            </a:fld>
            <a:endParaRPr 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0A603F-3859-4A56-992F-EAEB8FE092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96302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microsoft.com/office/2007/relationships/hdphoto" Target="../media/hdphoto8.wdp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5" Type="http://schemas.microsoft.com/office/2007/relationships/hdphoto" Target="../media/hdphoto9.wdp"/><Relationship Id="rId4" Type="http://schemas.openxmlformats.org/officeDocument/2006/relationships/image" Target="../media/image9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2.xml"/><Relationship Id="rId2" Type="http://schemas.openxmlformats.org/officeDocument/2006/relationships/chart" Target="../charts/chart1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13.xml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3" Type="http://schemas.microsoft.com/office/2007/relationships/hdphoto" Target="../media/hdphoto10.wdp"/><Relationship Id="rId7" Type="http://schemas.microsoft.com/office/2007/relationships/hdphoto" Target="../media/hdphoto12.wdp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5" Type="http://schemas.microsoft.com/office/2007/relationships/hdphoto" Target="../media/hdphoto11.wdp"/><Relationship Id="rId4" Type="http://schemas.openxmlformats.org/officeDocument/2006/relationships/image" Target="../media/image11.png"/><Relationship Id="rId9" Type="http://schemas.microsoft.com/office/2007/relationships/hdphoto" Target="../media/hdphoto13.wdp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4.xml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13" Type="http://schemas.microsoft.com/office/2007/relationships/hdphoto" Target="../media/hdphoto19.wdp"/><Relationship Id="rId3" Type="http://schemas.microsoft.com/office/2007/relationships/hdphoto" Target="../media/hdphoto14.wdp"/><Relationship Id="rId7" Type="http://schemas.microsoft.com/office/2007/relationships/hdphoto" Target="../media/hdphoto16.wdp"/><Relationship Id="rId12" Type="http://schemas.openxmlformats.org/officeDocument/2006/relationships/image" Target="../media/image19.png"/><Relationship Id="rId2" Type="http://schemas.openxmlformats.org/officeDocument/2006/relationships/image" Target="../media/image14.png"/><Relationship Id="rId16" Type="http://schemas.openxmlformats.org/officeDocument/2006/relationships/image" Target="../media/image2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png"/><Relationship Id="rId11" Type="http://schemas.microsoft.com/office/2007/relationships/hdphoto" Target="../media/hdphoto18.wdp"/><Relationship Id="rId5" Type="http://schemas.microsoft.com/office/2007/relationships/hdphoto" Target="../media/hdphoto15.wdp"/><Relationship Id="rId15" Type="http://schemas.microsoft.com/office/2007/relationships/hdphoto" Target="../media/hdphoto20.wdp"/><Relationship Id="rId10" Type="http://schemas.openxmlformats.org/officeDocument/2006/relationships/image" Target="../media/image18.png"/><Relationship Id="rId4" Type="http://schemas.openxmlformats.org/officeDocument/2006/relationships/image" Target="../media/image15.png"/><Relationship Id="rId9" Type="http://schemas.microsoft.com/office/2007/relationships/hdphoto" Target="../media/hdphoto17.wdp"/><Relationship Id="rId14" Type="http://schemas.openxmlformats.org/officeDocument/2006/relationships/image" Target="../media/image20.png"/></Relationships>
</file>

<file path=ppt/slides/_rels/slide15.xml.rels><?xml version="1.0" encoding="UTF-8" standalone="yes"?>
<Relationships xmlns="http://schemas.openxmlformats.org/package/2006/relationships"><Relationship Id="rId8" Type="http://schemas.microsoft.com/office/2007/relationships/hdphoto" Target="../media/hdphoto23.wdp"/><Relationship Id="rId3" Type="http://schemas.openxmlformats.org/officeDocument/2006/relationships/image" Target="../media/image22.png"/><Relationship Id="rId7" Type="http://schemas.openxmlformats.org/officeDocument/2006/relationships/image" Target="../media/image2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microsoft.com/office/2007/relationships/hdphoto" Target="../media/hdphoto22.wdp"/><Relationship Id="rId11" Type="http://schemas.openxmlformats.org/officeDocument/2006/relationships/image" Target="../media/image26.png"/><Relationship Id="rId5" Type="http://schemas.openxmlformats.org/officeDocument/2006/relationships/image" Target="../media/image23.png"/><Relationship Id="rId10" Type="http://schemas.microsoft.com/office/2007/relationships/hdphoto" Target="../media/hdphoto24.wdp"/><Relationship Id="rId4" Type="http://schemas.microsoft.com/office/2007/relationships/hdphoto" Target="../media/hdphoto21.wdp"/><Relationship Id="rId9" Type="http://schemas.openxmlformats.org/officeDocument/2006/relationships/image" Target="../media/image25.pn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6.xml"/><Relationship Id="rId2" Type="http://schemas.openxmlformats.org/officeDocument/2006/relationships/chart" Target="../charts/chart15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18.xml"/><Relationship Id="rId4" Type="http://schemas.openxmlformats.org/officeDocument/2006/relationships/chart" Target="../charts/chart17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0.xml"/><Relationship Id="rId2" Type="http://schemas.openxmlformats.org/officeDocument/2006/relationships/chart" Target="../charts/chart19.xml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2.xml"/><Relationship Id="rId2" Type="http://schemas.openxmlformats.org/officeDocument/2006/relationships/chart" Target="../charts/chart2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23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4.xml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5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7.xml"/></Relationships>
</file>

<file path=ppt/slides/_rels/slide7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chart" Target="../charts/chart8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8" Type="http://schemas.microsoft.com/office/2007/relationships/hdphoto" Target="../media/hdphoto5.wdp"/><Relationship Id="rId13" Type="http://schemas.openxmlformats.org/officeDocument/2006/relationships/chart" Target="../charts/chart10.xml"/><Relationship Id="rId3" Type="http://schemas.openxmlformats.org/officeDocument/2006/relationships/image" Target="../media/image3.png"/><Relationship Id="rId7" Type="http://schemas.openxmlformats.org/officeDocument/2006/relationships/image" Target="../media/image5.png"/><Relationship Id="rId12" Type="http://schemas.microsoft.com/office/2007/relationships/hdphoto" Target="../media/hdphoto7.wdp"/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7.xml"/><Relationship Id="rId6" Type="http://schemas.microsoft.com/office/2007/relationships/hdphoto" Target="../media/hdphoto4.wdp"/><Relationship Id="rId11" Type="http://schemas.openxmlformats.org/officeDocument/2006/relationships/image" Target="../media/image7.png"/><Relationship Id="rId5" Type="http://schemas.openxmlformats.org/officeDocument/2006/relationships/image" Target="../media/image4.png"/><Relationship Id="rId10" Type="http://schemas.microsoft.com/office/2007/relationships/hdphoto" Target="../media/hdphoto6.wdp"/><Relationship Id="rId4" Type="http://schemas.microsoft.com/office/2007/relationships/hdphoto" Target="../media/hdphoto3.wdp"/><Relationship Id="rId9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134188" y="2850776"/>
            <a:ext cx="16658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Additional file 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5356656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그림 7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501" t="50305" r="54267" b="42309"/>
          <a:stretch/>
        </p:blipFill>
        <p:spPr>
          <a:xfrm>
            <a:off x="5278193" y="2594845"/>
            <a:ext cx="1323776" cy="578123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9" name="그림 8"/>
          <p:cNvPicPr>
            <a:picLocks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aturation sat="0"/>
                    </a14:imgEffect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3368" t="50693" r="23347" b="41532"/>
          <a:stretch/>
        </p:blipFill>
        <p:spPr>
          <a:xfrm>
            <a:off x="5278193" y="3487939"/>
            <a:ext cx="1323775" cy="576072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13" name="TextBox 12"/>
          <p:cNvSpPr txBox="1"/>
          <p:nvPr/>
        </p:nvSpPr>
        <p:spPr>
          <a:xfrm rot="-2700000">
            <a:off x="5177094" y="1753492"/>
            <a:ext cx="18082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Me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026277" y="2681156"/>
            <a:ext cx="13354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lophycocyanin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180457" y="3644323"/>
            <a:ext cx="12334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ycocyanin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 rot="-2700000">
            <a:off x="5481782" y="1520692"/>
            <a:ext cx="25253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Me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5-fold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BS reconstitution)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직사각형 2"/>
          <p:cNvSpPr/>
          <p:nvPr/>
        </p:nvSpPr>
        <p:spPr>
          <a:xfrm>
            <a:off x="220255" y="5442470"/>
            <a:ext cx="11543359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sz="11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. S7. Determination of PBS contents of </a:t>
            </a:r>
            <a:r>
              <a:rPr lang="en-US" altLang="zh-CN" sz="11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M treated with </a:t>
            </a:r>
            <a:r>
              <a:rPr lang="en-US" altLang="ko-KR" sz="11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0 </a:t>
            </a:r>
            <a:r>
              <a:rPr lang="en-US" altLang="ko-KR" sz="1100" b="1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M</a:t>
            </a:r>
            <a:r>
              <a:rPr lang="en-US" altLang="ko-KR" sz="11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EDTA (</a:t>
            </a:r>
            <a:r>
              <a:rPr lang="en-US" sz="1100" b="1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Me</a:t>
            </a:r>
            <a:r>
              <a:rPr lang="en-US" sz="11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, and </a:t>
            </a:r>
            <a:r>
              <a:rPr lang="en-US" altLang="ko-KR" sz="1100" b="1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Me</a:t>
            </a:r>
            <a:r>
              <a:rPr lang="en-US" altLang="ko-KR" sz="11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reconstituted for PBS (</a:t>
            </a:r>
            <a:r>
              <a:rPr lang="en-US" sz="1100" b="1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TMe</a:t>
            </a:r>
            <a:r>
              <a:rPr lang="en-US" sz="11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. 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BS contents of </a:t>
            </a:r>
            <a:r>
              <a:rPr lang="en-US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M</a:t>
            </a:r>
            <a:r>
              <a:rPr lang="en-US" altLang="zh-CN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e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nd </a:t>
            </a:r>
            <a:r>
              <a:rPr lang="en-US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TMe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were examined by western immunoblot analysis using antibodies against </a:t>
            </a:r>
            <a:r>
              <a:rPr lang="el-G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α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subunits of </a:t>
            </a:r>
            <a:r>
              <a:rPr lang="en-US" sz="1100" dirty="0" err="1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llophycocyanin</a:t>
            </a:r>
            <a:r>
              <a:rPr lang="en-US" sz="110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nd </a:t>
            </a:r>
            <a:r>
              <a:rPr lang="en-US" sz="1100" dirty="0" err="1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hycocyanin</a:t>
            </a:r>
            <a:r>
              <a:rPr lang="en-US" sz="110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lang="en-US" sz="1100" dirty="0" smtClean="0">
                <a:solidFill>
                  <a:srgbClr val="00B0F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amples were adjusted to the same amounts of </a:t>
            </a:r>
            <a:r>
              <a:rPr lang="en-US" altLang="ko-KR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hl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ko-KR" sz="1100" i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(3 µg) before </a:t>
            </a:r>
            <a:r>
              <a:rPr lang="en-US" altLang="zh-CN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eparation by 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5% SDS-PAGE. The other </a:t>
            </a:r>
            <a:r>
              <a:rPr lang="el-GR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β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subunit </a:t>
            </a:r>
            <a:r>
              <a:rPr lang="en-US" altLang="ko-KR" sz="110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of </a:t>
            </a:r>
            <a:r>
              <a:rPr lang="en-US" altLang="ko-KR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hycocyanin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was also detected 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due to the cross reactivity of </a:t>
            </a:r>
            <a:r>
              <a:rPr lang="el-GR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α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subunit </a:t>
            </a:r>
            <a:r>
              <a:rPr lang="en-US" sz="110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ntibody (see Fig. S4 legend). The </a:t>
            </a:r>
            <a:r>
              <a:rPr lang="en-US" sz="1100" dirty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relative band intensities of the western immunoblot </a:t>
            </a:r>
            <a:r>
              <a:rPr lang="en-US" altLang="zh-CN" sz="1100" dirty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were</a:t>
            </a:r>
            <a:r>
              <a:rPr lang="en-US" sz="1100" dirty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 measured and shown under each lane in comparison with those of </a:t>
            </a:r>
            <a:r>
              <a:rPr lang="en-US" altLang="ko-KR" sz="1100" dirty="0" err="1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TMe</a:t>
            </a:r>
            <a:r>
              <a:rPr lang="en-US" altLang="ko-KR" sz="1100" dirty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.</a:t>
            </a:r>
            <a:endParaRPr lang="en-US" altLang="ko-KR" sz="11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3" name="TextBox 19"/>
          <p:cNvSpPr txBox="1"/>
          <p:nvPr/>
        </p:nvSpPr>
        <p:spPr>
          <a:xfrm rot="18900000">
            <a:off x="5960578" y="1589988"/>
            <a:ext cx="23106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Me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10-fold PBS reconstitution)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6511296" y="2833025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5206473" y="4321760"/>
            <a:ext cx="128592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: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nspecific band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5251392" y="3229037"/>
            <a:ext cx="15953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0.1          0.5         0.9         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5251391" y="4093085"/>
            <a:ext cx="1531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0.1        0.8         1.0       </a:t>
            </a:r>
          </a:p>
        </p:txBody>
      </p:sp>
      <p:cxnSp>
        <p:nvCxnSpPr>
          <p:cNvPr id="30" name="직선 화살표 연결선 29"/>
          <p:cNvCxnSpPr/>
          <p:nvPr/>
        </p:nvCxnSpPr>
        <p:spPr>
          <a:xfrm rot="-600000" flipV="1">
            <a:off x="6626054" y="3733782"/>
            <a:ext cx="144000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직선 화살표 연결선 30"/>
          <p:cNvCxnSpPr/>
          <p:nvPr/>
        </p:nvCxnSpPr>
        <p:spPr>
          <a:xfrm rot="600000" flipV="1">
            <a:off x="6630380" y="3867530"/>
            <a:ext cx="144000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6737081" y="3737624"/>
            <a:ext cx="2584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6734033" y="3544301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331063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차트 3"/>
          <p:cNvGraphicFramePr>
            <a:graphicFrameLocks/>
          </p:cNvGraphicFramePr>
          <p:nvPr>
            <p:extLst/>
          </p:nvPr>
        </p:nvGraphicFramePr>
        <p:xfrm>
          <a:off x="1001578" y="1208140"/>
          <a:ext cx="3019797" cy="26432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2012554" y="3733157"/>
            <a:ext cx="10134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5 (mg ml</a:t>
            </a:r>
            <a:r>
              <a:rPr lang="en-US" sz="12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7" name="TextBox 6"/>
          <p:cNvSpPr txBox="1"/>
          <p:nvPr/>
        </p:nvSpPr>
        <p:spPr>
          <a:xfrm rot="16200000">
            <a:off x="-171162" y="2290496"/>
            <a:ext cx="205056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NADPH generation</a:t>
            </a:r>
          </a:p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tivity (open bar, %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78144" y="1061207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4298898" y="1061215"/>
            <a:ext cx="32092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8928036" y="1061489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graphicFrame>
        <p:nvGraphicFramePr>
          <p:cNvPr id="13" name="차트 12"/>
          <p:cNvGraphicFramePr>
            <a:graphicFrameLocks/>
          </p:cNvGraphicFramePr>
          <p:nvPr>
            <p:extLst/>
          </p:nvPr>
        </p:nvGraphicFramePr>
        <p:xfrm>
          <a:off x="4790649" y="1198904"/>
          <a:ext cx="3818584" cy="27595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4" name="TextBox 13"/>
          <p:cNvSpPr txBox="1"/>
          <p:nvPr/>
        </p:nvSpPr>
        <p:spPr>
          <a:xfrm rot="16200000">
            <a:off x="3491220" y="2333970"/>
            <a:ext cx="237657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NADPH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ration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vity (open bar, %)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6222876" y="3731277"/>
            <a:ext cx="10534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OS (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graphicFrame>
        <p:nvGraphicFramePr>
          <p:cNvPr id="18" name="차트 17"/>
          <p:cNvGraphicFramePr>
            <a:graphicFrameLocks/>
          </p:cNvGraphicFramePr>
          <p:nvPr>
            <p:extLst/>
          </p:nvPr>
        </p:nvGraphicFramePr>
        <p:xfrm>
          <a:off x="9271937" y="1189667"/>
          <a:ext cx="2365177" cy="26233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9" name="TextBox 18"/>
          <p:cNvSpPr txBox="1"/>
          <p:nvPr/>
        </p:nvSpPr>
        <p:spPr>
          <a:xfrm rot="16200000">
            <a:off x="8188986" y="2333111"/>
            <a:ext cx="20617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osilicification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%)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10046745" y="3733358"/>
            <a:ext cx="11833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l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µg ml</a:t>
            </a:r>
            <a:r>
              <a:rPr lang="en-US" sz="12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23" name="직사각형 22"/>
          <p:cNvSpPr/>
          <p:nvPr/>
        </p:nvSpPr>
        <p:spPr>
          <a:xfrm>
            <a:off x="235854" y="4543039"/>
            <a:ext cx="11666136" cy="186974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1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. S8. Optimization of R5 and TMOS for the </a:t>
            </a:r>
            <a:r>
              <a:rPr lang="en-US" sz="1100" b="1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biosilicification</a:t>
            </a:r>
            <a:r>
              <a:rPr lang="en-US" sz="11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of </a:t>
            </a:r>
            <a:r>
              <a:rPr lang="en-US" sz="1100" b="1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TMe</a:t>
            </a:r>
            <a:r>
              <a:rPr lang="en-US" sz="11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A) Varying levels of R5 were 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ixed with </a:t>
            </a:r>
            <a:r>
              <a:rPr lang="en-US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TMe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(</a:t>
            </a:r>
            <a:r>
              <a:rPr lang="en-US" altLang="zh-CN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0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l-GR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g </a:t>
            </a:r>
            <a:r>
              <a:rPr lang="en-US" altLang="ko-KR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hl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ko-KR" sz="1100" i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ml</a:t>
            </a:r>
            <a:r>
              <a:rPr lang="en-US" altLang="ko-KR" sz="1100" baseline="30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1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, followed by incubation</a:t>
            </a:r>
            <a:r>
              <a:rPr lang="ko-KR" alt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t room temperature 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or 5 min. TMOS (10 </a:t>
            </a:r>
            <a:r>
              <a:rPr lang="en-US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M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 was added, and the reaction mixture was incubated at room temperature for 30 min. </a:t>
            </a:r>
            <a:r>
              <a:rPr lang="en-US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Biosilicified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TMe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b-</a:t>
            </a:r>
            <a:r>
              <a:rPr lang="en-US" altLang="ko-KR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TMe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 was easily precipitated by centrifugation at 3,000 g at room temperature for 1 min. b-</a:t>
            </a:r>
            <a:r>
              <a:rPr lang="en-US" altLang="ko-KR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TMe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was washed three times by centrifugation using TM buffer before measurement of 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NADPH generation </a:t>
            </a:r>
            <a:r>
              <a:rPr lang="en-US" altLang="ko-KR" sz="110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ctivity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hich 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was measured in TM-NADP</a:t>
            </a:r>
            <a:r>
              <a:rPr lang="en-US" altLang="ko-KR" sz="1100" baseline="30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buffer as described in Fig. S6 and represented as the relative percentage of that obtained without </a:t>
            </a:r>
            <a:r>
              <a:rPr lang="en-US" altLang="ko-KR" sz="1100" dirty="0" err="1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biosilicification</a:t>
            </a:r>
            <a:r>
              <a:rPr lang="en-US" altLang="ko-KR" sz="110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lang="en-US" sz="110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hl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100" i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contents 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of b-</a:t>
            </a:r>
            <a:r>
              <a:rPr lang="en-US" altLang="ko-KR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TMe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were compared with </a:t>
            </a:r>
            <a:r>
              <a:rPr lang="en-US" altLang="ko-KR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TMe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(</a:t>
            </a:r>
            <a:r>
              <a:rPr lang="en-US" altLang="zh-CN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0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l-GR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g </a:t>
            </a:r>
            <a:r>
              <a:rPr lang="en-US" altLang="ko-KR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hl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ko-KR" sz="1100" i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ml</a:t>
            </a:r>
            <a:r>
              <a:rPr lang="en-US" altLang="ko-KR" sz="1100" baseline="30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1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 and expressed as the relative </a:t>
            </a:r>
            <a:r>
              <a:rPr lang="en-US" altLang="ko-KR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biosilicification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ko-KR" sz="110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%. 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B) Varying levels of TMOS were added to </a:t>
            </a:r>
            <a:r>
              <a:rPr lang="en-US" altLang="ko-KR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TMe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pretreated with R5 (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0.5 mg ml</a:t>
            </a:r>
            <a:r>
              <a:rPr lang="en-US" sz="1100" baseline="30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1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 to determine optimal TMOS concentration. NADPH generation </a:t>
            </a:r>
            <a:r>
              <a:rPr lang="en-US" sz="110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nd 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relative </a:t>
            </a:r>
            <a:r>
              <a:rPr lang="en-US" altLang="ko-KR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biosilicification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% </a:t>
            </a:r>
            <a:r>
              <a:rPr lang="en-US" sz="110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were 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easured in the same way as described in (A). (C) It was determined how much </a:t>
            </a:r>
            <a:r>
              <a:rPr lang="en-US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TMe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can be </a:t>
            </a:r>
            <a:r>
              <a:rPr lang="en-US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biosilicified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using 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R5 (0.5 mg ml</a:t>
            </a:r>
            <a:r>
              <a:rPr lang="en-US" sz="1100" baseline="30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1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 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with 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MOS (10 </a:t>
            </a:r>
            <a:r>
              <a:rPr lang="en-US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M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. </a:t>
            </a:r>
            <a:r>
              <a:rPr lang="en-US" altLang="ko-KR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hl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ko-KR" sz="1100" i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contents of b-</a:t>
            </a:r>
            <a:r>
              <a:rPr lang="en-US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TMe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were determined and represented as the relative percentage of that of the initial </a:t>
            </a:r>
            <a:r>
              <a:rPr lang="en-US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TMe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before </a:t>
            </a:r>
            <a:r>
              <a:rPr lang="en-US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biosilicification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 </a:t>
            </a:r>
          </a:p>
        </p:txBody>
      </p:sp>
      <p:sp>
        <p:nvSpPr>
          <p:cNvPr id="25" name="TextBox 24"/>
          <p:cNvSpPr txBox="1"/>
          <p:nvPr/>
        </p:nvSpPr>
        <p:spPr>
          <a:xfrm rot="16200000">
            <a:off x="3211390" y="2287120"/>
            <a:ext cx="17668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osilicification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grey bar, %)</a:t>
            </a:r>
          </a:p>
        </p:txBody>
      </p:sp>
      <p:sp>
        <p:nvSpPr>
          <p:cNvPr id="32" name="TextBox 31"/>
          <p:cNvSpPr txBox="1"/>
          <p:nvPr/>
        </p:nvSpPr>
        <p:spPr>
          <a:xfrm rot="16200000">
            <a:off x="7843804" y="2291296"/>
            <a:ext cx="17668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osilicification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grey bar, %)</a:t>
            </a:r>
          </a:p>
        </p:txBody>
      </p:sp>
    </p:spTree>
    <p:extLst>
      <p:ext uri="{BB962C8B-B14F-4D97-AF65-F5344CB8AC3E}">
        <p14:creationId xmlns:p14="http://schemas.microsoft.com/office/powerpoint/2010/main" val="385978288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그룹 10"/>
          <p:cNvGrpSpPr/>
          <p:nvPr/>
        </p:nvGrpSpPr>
        <p:grpSpPr>
          <a:xfrm>
            <a:off x="6395946" y="1108210"/>
            <a:ext cx="2582476" cy="2203699"/>
            <a:chOff x="5381948" y="2450591"/>
            <a:chExt cx="2582476" cy="2203699"/>
          </a:xfrm>
        </p:grpSpPr>
        <p:pic>
          <p:nvPicPr>
            <p:cNvPr id="12" name="그림 11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2489" r="34404" b="1"/>
            <a:stretch/>
          </p:blipFill>
          <p:spPr>
            <a:xfrm>
              <a:off x="5381948" y="2450591"/>
              <a:ext cx="2582476" cy="2176269"/>
            </a:xfrm>
            <a:prstGeom prst="rect">
              <a:avLst/>
            </a:prstGeom>
          </p:spPr>
        </p:pic>
        <p:cxnSp>
          <p:nvCxnSpPr>
            <p:cNvPr id="13" name="직선 연결선 12"/>
            <p:cNvCxnSpPr/>
            <p:nvPr/>
          </p:nvCxnSpPr>
          <p:spPr>
            <a:xfrm>
              <a:off x="5645316" y="4317409"/>
              <a:ext cx="231672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" name="TextBox 13"/>
            <p:cNvSpPr txBox="1"/>
            <p:nvPr/>
          </p:nvSpPr>
          <p:spPr>
            <a:xfrm>
              <a:off x="5520024" y="4288036"/>
              <a:ext cx="611525" cy="3662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chemeClr val="bg1"/>
                  </a:solidFill>
                </a:rPr>
                <a:t>2 µm</a:t>
              </a:r>
            </a:p>
          </p:txBody>
        </p:sp>
      </p:grpSp>
      <p:grpSp>
        <p:nvGrpSpPr>
          <p:cNvPr id="15" name="그룹 14"/>
          <p:cNvGrpSpPr/>
          <p:nvPr/>
        </p:nvGrpSpPr>
        <p:grpSpPr>
          <a:xfrm>
            <a:off x="3326867" y="1108209"/>
            <a:ext cx="2621927" cy="2200924"/>
            <a:chOff x="2678629" y="2450592"/>
            <a:chExt cx="2140259" cy="1666692"/>
          </a:xfrm>
        </p:grpSpPr>
        <p:pic>
          <p:nvPicPr>
            <p:cNvPr id="16" name="그림 15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1" t="31553" r="33588" b="1"/>
            <a:stretch/>
          </p:blipFill>
          <p:spPr>
            <a:xfrm>
              <a:off x="2678629" y="2450592"/>
              <a:ext cx="2140259" cy="1648023"/>
            </a:xfrm>
            <a:prstGeom prst="rect">
              <a:avLst/>
            </a:prstGeom>
          </p:spPr>
        </p:pic>
        <p:cxnSp>
          <p:nvCxnSpPr>
            <p:cNvPr id="17" name="직선 연결선 16"/>
            <p:cNvCxnSpPr/>
            <p:nvPr/>
          </p:nvCxnSpPr>
          <p:spPr>
            <a:xfrm>
              <a:off x="2835532" y="3862473"/>
              <a:ext cx="192024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8" name="TextBox 17"/>
            <p:cNvSpPr txBox="1"/>
            <p:nvPr/>
          </p:nvSpPr>
          <p:spPr>
            <a:xfrm>
              <a:off x="2738347" y="3840285"/>
              <a:ext cx="50687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chemeClr val="bg1"/>
                  </a:solidFill>
                </a:rPr>
                <a:t>2 µm</a:t>
              </a:r>
            </a:p>
          </p:txBody>
        </p:sp>
      </p:grpSp>
      <p:pic>
        <p:nvPicPr>
          <p:cNvPr id="6" name="그림 5"/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7222" t="56355" r="26750" b="4075"/>
          <a:stretch/>
        </p:blipFill>
        <p:spPr>
          <a:xfrm>
            <a:off x="3336011" y="1119493"/>
            <a:ext cx="433440" cy="813816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7222" t="13333" r="26244" b="44691"/>
          <a:stretch/>
        </p:blipFill>
        <p:spPr>
          <a:xfrm>
            <a:off x="6405315" y="1114247"/>
            <a:ext cx="449095" cy="86709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2967090" y="711672"/>
            <a:ext cx="71365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2192" y="5533026"/>
            <a:ext cx="12179808" cy="8540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9. Microscopic observation of </a:t>
            </a:r>
            <a:r>
              <a:rPr lang="en-US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TMe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b-</a:t>
            </a:r>
            <a:r>
              <a:rPr lang="en-US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TMe</a:t>
            </a:r>
            <a:r>
              <a:rPr lang="en-US" altLang="ko-K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uorescence microscopic images of </a:t>
            </a:r>
            <a:r>
              <a:rPr lang="en-US" altLang="ko-KR" sz="1100" dirty="0" err="1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pTMe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) and b-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TMe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) were shown with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xioskop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Zeiss, Germany). Fluorescence by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l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en-US" altLang="ko-KR" sz="1100" dirty="0" err="1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pTMe</a:t>
            </a:r>
            <a:r>
              <a:rPr lang="en-US" altLang="ko-KR" sz="1100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 reveals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overall distribution of individual </a:t>
            </a:r>
            <a:r>
              <a:rPr lang="en-US" altLang="ko-KR" sz="1100" dirty="0" err="1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pTMe</a:t>
            </a:r>
            <a:r>
              <a:rPr lang="en-US" altLang="ko-KR" sz="1100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 (A), whereas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uorescence by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l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b-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TMe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llustrates the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sence</a:t>
            </a:r>
            <a:r>
              <a:rPr lang="ko-KR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TMe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amorphous silica structure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a diameter in the range of 3 to 6 </a:t>
            </a:r>
            <a:r>
              <a:rPr lang="en-US" altLang="ko-K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. (C) Size distribution of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TMe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b-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TMe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ere determined by dynamic light scattering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Zetasizer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ano S (Malvern, UK).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dI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anges from 0 to 1; if its value is  ≥ 1, it indicates that the distribution is so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lydisperse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100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6073002" y="717768"/>
            <a:ext cx="71365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graphicFrame>
        <p:nvGraphicFramePr>
          <p:cNvPr id="20" name="표 1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14092156"/>
              </p:ext>
            </p:extLst>
          </p:nvPr>
        </p:nvGraphicFramePr>
        <p:xfrm>
          <a:off x="3400025" y="3923720"/>
          <a:ext cx="3930438" cy="792813"/>
        </p:xfrm>
        <a:graphic>
          <a:graphicData uri="http://schemas.openxmlformats.org/drawingml/2006/table">
            <a:tbl>
              <a:tblPr firstRow="1" bandRow="1">
                <a:tableStyleId>{EB344D84-9AFB-497E-A393-DC336BA19D2E}</a:tableStyleId>
              </a:tblPr>
              <a:tblGrid>
                <a:gridCol w="1310146">
                  <a:extLst>
                    <a:ext uri="{9D8B030D-6E8A-4147-A177-3AD203B41FA5}">
                      <a16:colId xmlns:a16="http://schemas.microsoft.com/office/drawing/2014/main" xmlns="" val="2547938270"/>
                    </a:ext>
                  </a:extLst>
                </a:gridCol>
                <a:gridCol w="1310146">
                  <a:extLst>
                    <a:ext uri="{9D8B030D-6E8A-4147-A177-3AD203B41FA5}">
                      <a16:colId xmlns:a16="http://schemas.microsoft.com/office/drawing/2014/main" xmlns="" val="1041065405"/>
                    </a:ext>
                  </a:extLst>
                </a:gridCol>
                <a:gridCol w="1310146">
                  <a:extLst>
                    <a:ext uri="{9D8B030D-6E8A-4147-A177-3AD203B41FA5}">
                      <a16:colId xmlns:a16="http://schemas.microsoft.com/office/drawing/2014/main" xmlns="" val="1258351464"/>
                    </a:ext>
                  </a:extLst>
                </a:gridCol>
              </a:tblGrid>
              <a:tr h="264271">
                <a:tc>
                  <a:txBody>
                    <a:bodyPr/>
                    <a:lstStyle/>
                    <a:p>
                      <a:pPr algn="ctr"/>
                      <a:endParaRPr lang="en-US" sz="11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-Average</a:t>
                      </a:r>
                      <a:r>
                        <a:rPr lang="en-US" sz="1100" b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nm)</a:t>
                      </a:r>
                      <a:r>
                        <a:rPr lang="en-US" sz="1100" b="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dI</a:t>
                      </a:r>
                      <a:r>
                        <a:rPr lang="en-US" sz="1100" b="0" baseline="3000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endParaRPr lang="en-US" sz="1100" b="0" baseline="30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013063013"/>
                  </a:ext>
                </a:extLst>
              </a:tr>
              <a:tr h="264271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TMe</a:t>
                      </a:r>
                      <a:endParaRPr 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0.0 ± 1.2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2 ± 0.04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626770716"/>
                  </a:ext>
                </a:extLst>
              </a:tr>
              <a:tr h="264271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-</a:t>
                      </a:r>
                      <a:r>
                        <a:rPr lang="en-US" altLang="zh-CN" sz="11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TMe</a:t>
                      </a:r>
                      <a:endParaRPr 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517.0 </a:t>
                      </a:r>
                      <a:r>
                        <a:rPr lang="en-US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327.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599271118"/>
                  </a:ext>
                </a:extLst>
              </a:tr>
            </a:tbl>
          </a:graphicData>
        </a:graphic>
      </p:graphicFrame>
      <p:sp>
        <p:nvSpPr>
          <p:cNvPr id="21" name="TextBox 20"/>
          <p:cNvSpPr txBox="1"/>
          <p:nvPr/>
        </p:nvSpPr>
        <p:spPr>
          <a:xfrm>
            <a:off x="2923043" y="3398118"/>
            <a:ext cx="71365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22" name="직사각형 21"/>
          <p:cNvSpPr/>
          <p:nvPr/>
        </p:nvSpPr>
        <p:spPr>
          <a:xfrm>
            <a:off x="3323756" y="3589616"/>
            <a:ext cx="262604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1200" dirty="0">
                <a:latin typeface="Times New Roman" panose="02020603050405020304" pitchFamily="18" charset="0"/>
                <a:ea typeface="바탕" panose="02030600000101010101" pitchFamily="18" charset="-127"/>
              </a:rPr>
              <a:t>Size distribution of </a:t>
            </a:r>
            <a:r>
              <a:rPr lang="en-US" altLang="ko-KR" sz="1200" dirty="0" err="1">
                <a:latin typeface="Times New Roman" panose="02020603050405020304" pitchFamily="18" charset="0"/>
                <a:ea typeface="바탕" panose="02030600000101010101" pitchFamily="18" charset="-127"/>
              </a:rPr>
              <a:t>pTMe</a:t>
            </a:r>
            <a:r>
              <a:rPr lang="en-US" altLang="ko-KR" sz="1200" dirty="0">
                <a:latin typeface="Times New Roman" panose="02020603050405020304" pitchFamily="18" charset="0"/>
                <a:ea typeface="바탕" panose="02030600000101010101" pitchFamily="18" charset="-127"/>
              </a:rPr>
              <a:t> and b-</a:t>
            </a:r>
            <a:r>
              <a:rPr lang="en-US" altLang="ko-KR" sz="1200" dirty="0" err="1">
                <a:latin typeface="Times New Roman" panose="02020603050405020304" pitchFamily="18" charset="0"/>
                <a:ea typeface="바탕" panose="02030600000101010101" pitchFamily="18" charset="-127"/>
              </a:rPr>
              <a:t>pTMe</a:t>
            </a:r>
            <a:r>
              <a:rPr lang="en-US" altLang="ko-KR" sz="1200" dirty="0">
                <a:latin typeface="Times New Roman" panose="02020603050405020304" pitchFamily="18" charset="0"/>
                <a:ea typeface="바탕" panose="02030600000101010101" pitchFamily="18" charset="-127"/>
              </a:rPr>
              <a:t>.</a:t>
            </a:r>
            <a:endParaRPr lang="ko-KR" altLang="en-US" sz="1200" dirty="0"/>
          </a:p>
        </p:txBody>
      </p:sp>
      <p:sp>
        <p:nvSpPr>
          <p:cNvPr id="23" name="직사각형 22"/>
          <p:cNvSpPr/>
          <p:nvPr/>
        </p:nvSpPr>
        <p:spPr>
          <a:xfrm>
            <a:off x="3336011" y="4751284"/>
            <a:ext cx="5369077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100" baseline="300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ko-K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verage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ize of a particle size distribution.</a:t>
            </a:r>
          </a:p>
          <a:p>
            <a:pPr algn="just"/>
            <a:r>
              <a:rPr lang="en-US" altLang="ko-KR" sz="1100" baseline="300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ko-K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lydispersity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dex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estimate of the width of the distribution. </a:t>
            </a:r>
            <a:endParaRPr lang="ko-KR" altLang="ko-KR" sz="11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9366466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" name="차트 12"/>
          <p:cNvGraphicFramePr>
            <a:graphicFrameLocks/>
          </p:cNvGraphicFramePr>
          <p:nvPr/>
        </p:nvGraphicFramePr>
        <p:xfrm>
          <a:off x="4605528" y="1605211"/>
          <a:ext cx="2755392" cy="29832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4" name="TextBox 13"/>
          <p:cNvSpPr txBox="1"/>
          <p:nvPr/>
        </p:nvSpPr>
        <p:spPr>
          <a:xfrm rot="18287355">
            <a:off x="5182557" y="1385366"/>
            <a:ext cx="55335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TMe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 rot="16200000">
            <a:off x="3758206" y="2958326"/>
            <a:ext cx="14847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Zeta potential (mV)</a:t>
            </a:r>
          </a:p>
        </p:txBody>
      </p:sp>
      <p:sp>
        <p:nvSpPr>
          <p:cNvPr id="16" name="TextBox 15"/>
          <p:cNvSpPr txBox="1"/>
          <p:nvPr/>
        </p:nvSpPr>
        <p:spPr>
          <a:xfrm rot="18287355">
            <a:off x="5744502" y="1071155"/>
            <a:ext cx="135325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5 adsorbed </a:t>
            </a:r>
            <a:r>
              <a:rPr lang="en-US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TMe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 rot="18287355">
            <a:off x="6602927" y="1348790"/>
            <a:ext cx="71365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-</a:t>
            </a:r>
            <a:r>
              <a:rPr lang="en-US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TMe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64" name="TextBox 63"/>
          <p:cNvSpPr txBox="1"/>
          <p:nvPr/>
        </p:nvSpPr>
        <p:spPr>
          <a:xfrm>
            <a:off x="125198" y="4961666"/>
            <a:ext cx="12066802" cy="8540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just">
              <a:lnSpc>
                <a:spcPct val="150000"/>
              </a:lnSpc>
            </a:pP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0. Zeta potentials of </a:t>
            </a:r>
            <a:r>
              <a:rPr lang="en-US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TMe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5-pretreated </a:t>
            </a:r>
            <a:r>
              <a:rPr lang="en-US" sz="11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TMe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b-</a:t>
            </a:r>
            <a:r>
              <a:rPr lang="en-US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TMe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Zeta potentials of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TMe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5-adsorbed </a:t>
            </a:r>
            <a:r>
              <a:rPr lang="en-US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TMe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b-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TMe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ere dete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mined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th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Zetasizer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ano S (Malvern, UK). Samples were adjusted to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me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l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vels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 µg ml</a:t>
            </a:r>
            <a:r>
              <a:rPr lang="en-US" altLang="ko-KR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US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TMe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eated with R5 was washed twice with TM buffer to remove free R5 peptide by ultracentrifugation (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50,000 g at 4℃  for 30 min)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fore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asurement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ko-KR" altLang="zh-CN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ll </a:t>
            </a:r>
            <a:r>
              <a:rPr lang="ko-KR" altLang="zh-CN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he</a:t>
            </a:r>
            <a:r>
              <a:rPr lang="ko-KR" altLang="zh-CN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ko-KR" altLang="zh-CN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quantif</a:t>
            </a:r>
            <a:r>
              <a:rPr lang="en-US" altLang="ko-KR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i</a:t>
            </a:r>
            <a:r>
              <a:rPr lang="ko-KR" altLang="zh-CN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ations</a:t>
            </a:r>
            <a:r>
              <a:rPr lang="ko-KR" altLang="zh-CN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ko-KR" altLang="zh-CN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were</a:t>
            </a:r>
            <a:r>
              <a:rPr lang="ko-KR" altLang="zh-CN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ko-KR" altLang="zh-CN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indep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e</a:t>
            </a:r>
            <a:r>
              <a:rPr lang="ko-KR" altLang="zh-CN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ndently</a:t>
            </a:r>
            <a:r>
              <a:rPr lang="ko-KR" altLang="zh-CN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ko-KR" altLang="zh-CN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repeated</a:t>
            </a:r>
            <a:r>
              <a:rPr lang="ko-KR" altLang="zh-CN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ko-KR" altLang="zh-CN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hree</a:t>
            </a:r>
            <a:r>
              <a:rPr lang="ko-KR" altLang="zh-CN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ko-KR" altLang="zh-CN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imes</a:t>
            </a:r>
            <a:r>
              <a:rPr lang="ko-KR" altLang="zh-CN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and </a:t>
            </a:r>
            <a:r>
              <a:rPr lang="ko-KR" altLang="zh-CN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data</a:t>
            </a:r>
            <a:r>
              <a:rPr lang="ko-KR" altLang="zh-CN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were</a:t>
            </a:r>
            <a:r>
              <a:rPr lang="ko-KR" altLang="zh-CN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ko-KR" altLang="zh-CN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hown</a:t>
            </a:r>
            <a:r>
              <a:rPr lang="ko-KR" altLang="zh-CN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ko-KR" altLang="zh-CN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s</a:t>
            </a:r>
            <a:r>
              <a:rPr lang="ko-KR" altLang="zh-CN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ko-KR" altLang="zh-CN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he</a:t>
            </a:r>
            <a:r>
              <a:rPr lang="ko-KR" altLang="zh-CN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ko-KR" altLang="zh-CN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ean</a:t>
            </a:r>
            <a:r>
              <a:rPr lang="ko-KR" altLang="zh-CN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± </a:t>
            </a:r>
            <a:r>
              <a:rPr lang="ko-KR" altLang="zh-CN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tandard</a:t>
            </a:r>
            <a:r>
              <a:rPr lang="ko-KR" altLang="zh-CN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ko-KR" altLang="zh-CN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deviation</a:t>
            </a:r>
            <a:r>
              <a:rPr lang="ko-KR" altLang="zh-CN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(SD).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92084048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581593" y="1904521"/>
            <a:ext cx="25698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0           1          3            5         7      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4557508" y="1667242"/>
            <a:ext cx="5004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s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6834787" y="1903391"/>
            <a:ext cx="2210361" cy="2822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0          1          3          5         7      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2826802" y="1478175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6285564" y="148074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pic>
        <p:nvPicPr>
          <p:cNvPr id="13" name="그림 12"/>
          <p:cNvPicPr>
            <a:picLocks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0"/>
                    </a14:imgEffect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0344" t="48980" r="25866" b="43610"/>
          <a:stretch/>
        </p:blipFill>
        <p:spPr>
          <a:xfrm>
            <a:off x="6772291" y="2161186"/>
            <a:ext cx="2395728" cy="347472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4" name="그림 13"/>
          <p:cNvPicPr>
            <a:picLocks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aturation sat="0"/>
                    </a14:imgEffect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523" t="29950" r="62192" b="48311"/>
          <a:stretch/>
        </p:blipFill>
        <p:spPr>
          <a:xfrm rot="5400000">
            <a:off x="7793913" y="1632647"/>
            <a:ext cx="347472" cy="239572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5" name="그림 14"/>
          <p:cNvPicPr>
            <a:picLocks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0606" t="33703" r="54444" b="43703"/>
          <a:stretch/>
        </p:blipFill>
        <p:spPr>
          <a:xfrm rot="5400000">
            <a:off x="7795216" y="2133359"/>
            <a:ext cx="347472" cy="239572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6" name="그림 15"/>
          <p:cNvPicPr>
            <a:picLocks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aturation sat="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3868" t="26296" r="41994" b="51438"/>
          <a:stretch/>
        </p:blipFill>
        <p:spPr>
          <a:xfrm rot="16200000">
            <a:off x="7799767" y="2635127"/>
            <a:ext cx="347472" cy="239572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17" name="TextBox 16"/>
          <p:cNvSpPr txBox="1"/>
          <p:nvPr/>
        </p:nvSpPr>
        <p:spPr>
          <a:xfrm>
            <a:off x="3058873" y="2693978"/>
            <a:ext cx="5164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sbO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067689" y="3216737"/>
            <a:ext cx="5004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saC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3058873" y="2211555"/>
            <a:ext cx="5164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sbA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146012" y="3684275"/>
            <a:ext cx="372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</a:t>
            </a:r>
          </a:p>
        </p:txBody>
      </p:sp>
      <p:pic>
        <p:nvPicPr>
          <p:cNvPr id="21" name="그림 20"/>
          <p:cNvPicPr>
            <a:picLocks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0279" t="61601" r="50504" b="16595"/>
          <a:stretch/>
        </p:blipFill>
        <p:spPr>
          <a:xfrm rot="16200000">
            <a:off x="4607188" y="1136369"/>
            <a:ext cx="347472" cy="239572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22" name="그림 21"/>
          <p:cNvPicPr>
            <a:picLocks/>
          </p:cNvPicPr>
          <p:nvPr/>
        </p:nvPicPr>
        <p:blipFill rotWithShape="1"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saturation sat="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083" t="58841" r="62236" b="21416"/>
          <a:stretch/>
        </p:blipFill>
        <p:spPr>
          <a:xfrm rot="5400000">
            <a:off x="4605662" y="1627187"/>
            <a:ext cx="347472" cy="239572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23" name="그림 22"/>
          <p:cNvPicPr>
            <a:picLocks/>
          </p:cNvPicPr>
          <p:nvPr/>
        </p:nvPicPr>
        <p:blipFill rotWithShape="1"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9590" t="57593" r="56172" b="19259"/>
          <a:stretch/>
        </p:blipFill>
        <p:spPr>
          <a:xfrm rot="16200000">
            <a:off x="4605202" y="2137597"/>
            <a:ext cx="347472" cy="239572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24" name="그림 23"/>
          <p:cNvPicPr>
            <a:picLocks/>
          </p:cNvPicPr>
          <p:nvPr/>
        </p:nvPicPr>
        <p:blipFill rotWithShape="1">
          <a:blip r:embed="rId16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aturation sat="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4043" t="51495" r="40621" b="26075"/>
          <a:stretch/>
        </p:blipFill>
        <p:spPr>
          <a:xfrm rot="16200000">
            <a:off x="4607920" y="2629373"/>
            <a:ext cx="347472" cy="239572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41" name="TextBox 40"/>
          <p:cNvSpPr txBox="1"/>
          <p:nvPr/>
        </p:nvSpPr>
        <p:spPr>
          <a:xfrm>
            <a:off x="3698749" y="2449699"/>
            <a:ext cx="23326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0         1.0          0.9            0.0          0.0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3642888" y="2958120"/>
            <a:ext cx="23006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.0         0.4           0.2         0.03         0.0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3668040" y="3457637"/>
            <a:ext cx="21723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0           0.9        0.7         0.4         0.2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3672650" y="3954063"/>
            <a:ext cx="22365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0          0.5          0.1         0.1          0.0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6917846" y="2456968"/>
            <a:ext cx="21403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0         0.9         0.4         0.4         0.4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6871530" y="2954862"/>
            <a:ext cx="22044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0          1.1          0.5         0.8         0.6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6846874" y="3459843"/>
            <a:ext cx="22044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1.0         1.1         0.9        0.6          0.6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6831907" y="3948648"/>
            <a:ext cx="22365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1.0         0.4           0.4        0.4         0.4</a:t>
            </a:r>
          </a:p>
        </p:txBody>
      </p:sp>
      <p:sp>
        <p:nvSpPr>
          <p:cNvPr id="50" name="직사각형 49"/>
          <p:cNvSpPr/>
          <p:nvPr/>
        </p:nvSpPr>
        <p:spPr>
          <a:xfrm>
            <a:off x="67056" y="5262066"/>
            <a:ext cx="12124944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1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. S11. Stability of the </a:t>
            </a:r>
            <a:r>
              <a:rPr lang="en-US" altLang="ko-KR" sz="11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our major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otosynthetic </a:t>
            </a:r>
            <a:r>
              <a:rPr lang="en-US" altLang="ko-K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ins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sz="1100" b="1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TMe</a:t>
            </a:r>
            <a:r>
              <a:rPr lang="en-US" sz="11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nd b-</a:t>
            </a:r>
            <a:r>
              <a:rPr lang="en-US" sz="1100" b="1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TMe</a:t>
            </a:r>
            <a:r>
              <a:rPr lang="en-US" sz="11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during incubation at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r>
              <a:rPr lang="zh-CN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℃ </a:t>
            </a:r>
            <a:r>
              <a:rPr lang="en-US" altLang="zh-CN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the dark</a:t>
            </a:r>
            <a:r>
              <a:rPr lang="en-US" sz="11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100" dirty="0" err="1">
                <a:latin typeface="Times New Roman" panose="02020603050405020304" pitchFamily="18" charset="0"/>
                <a:ea typeface="Batang" panose="02030600000101010101" pitchFamily="18" charset="-127"/>
                <a:cs typeface="Times New Roman" panose="02020603050405020304" pitchFamily="18" charset="0"/>
              </a:rPr>
              <a:t>pTMe</a:t>
            </a:r>
            <a:r>
              <a:rPr lang="en-US" altLang="ko-KR" sz="1100" dirty="0">
                <a:latin typeface="Times New Roman" panose="02020603050405020304" pitchFamily="18" charset="0"/>
                <a:ea typeface="Batang" panose="02030600000101010101" pitchFamily="18" charset="-127"/>
                <a:cs typeface="Times New Roman" panose="02020603050405020304" pitchFamily="18" charset="0"/>
              </a:rPr>
              <a:t> (A) and b-</a:t>
            </a:r>
            <a:r>
              <a:rPr lang="en-US" altLang="ko-KR" sz="1100" dirty="0" err="1">
                <a:latin typeface="Times New Roman" panose="02020603050405020304" pitchFamily="18" charset="0"/>
                <a:ea typeface="Batang" panose="02030600000101010101" pitchFamily="18" charset="-127"/>
                <a:cs typeface="Times New Roman" panose="02020603050405020304" pitchFamily="18" charset="0"/>
              </a:rPr>
              <a:t>pTMe</a:t>
            </a:r>
            <a:r>
              <a:rPr lang="en-US" altLang="ko-KR" sz="1100" dirty="0">
                <a:latin typeface="Times New Roman" panose="02020603050405020304" pitchFamily="18" charset="0"/>
                <a:ea typeface="Batang" panose="02030600000101010101" pitchFamily="18" charset="-127"/>
                <a:cs typeface="Times New Roman" panose="02020603050405020304" pitchFamily="18" charset="0"/>
              </a:rPr>
              <a:t> (B) were incubated in</a:t>
            </a:r>
            <a:r>
              <a:rPr lang="en-US" altLang="ko-KR" sz="1100" dirty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 TM-NADP</a:t>
            </a:r>
            <a:r>
              <a:rPr lang="en-US" altLang="ko-KR" sz="1100" baseline="30000" dirty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+</a:t>
            </a:r>
            <a:r>
              <a:rPr lang="en-US" altLang="ko-KR" sz="1100" dirty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 buffer at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℃ 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the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rk for one week. Aliquots were withdrawn at time points indicated, and the contents of the f</a:t>
            </a:r>
            <a:r>
              <a:rPr lang="en-US" sz="1100" dirty="0">
                <a:latin typeface="Times New Roman" panose="02020603050405020304" pitchFamily="18" charset="0"/>
                <a:ea typeface="Batang" panose="02030600000101010101" pitchFamily="18" charset="-127"/>
                <a:cs typeface="Times New Roman" panose="02020603050405020304" pitchFamily="18" charset="0"/>
              </a:rPr>
              <a:t>our main </a:t>
            </a:r>
            <a:r>
              <a:rPr lang="en-US" altLang="ko-KR" sz="1100" dirty="0">
                <a:latin typeface="Times New Roman" panose="02020603050405020304" pitchFamily="18" charset="0"/>
                <a:ea typeface="Batang" panose="02030600000101010101" pitchFamily="18" charset="-127"/>
                <a:cs typeface="Times New Roman" panose="02020603050405020304" pitchFamily="18" charset="0"/>
              </a:rPr>
              <a:t>proteins </a:t>
            </a:r>
            <a:r>
              <a:rPr lang="en-US" sz="1100" dirty="0">
                <a:latin typeface="Times New Roman" panose="02020603050405020304" pitchFamily="18" charset="0"/>
                <a:ea typeface="Batang" panose="02030600000101010101" pitchFamily="18" charset="-127"/>
                <a:cs typeface="Times New Roman" panose="02020603050405020304" pitchFamily="18" charset="0"/>
              </a:rPr>
              <a:t>were examined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by 15% SDS-PAGE</a:t>
            </a:r>
            <a:r>
              <a:rPr lang="ko-KR" alt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nd</a:t>
            </a:r>
            <a:r>
              <a:rPr lang="en-US" sz="1100" dirty="0">
                <a:latin typeface="Times New Roman" panose="02020603050405020304" pitchFamily="18" charset="0"/>
                <a:ea typeface="Batang" panose="02030600000101010101" pitchFamily="18" charset="-127"/>
                <a:cs typeface="Times New Roman" panose="02020603050405020304" pitchFamily="18" charset="0"/>
              </a:rPr>
              <a:t> western </a:t>
            </a:r>
            <a:r>
              <a:rPr lang="en-US" altLang="ko-KR" sz="1100" dirty="0">
                <a:latin typeface="Times New Roman" panose="02020603050405020304" pitchFamily="18" charset="0"/>
                <a:ea typeface="Batang" panose="02030600000101010101" pitchFamily="18" charset="-127"/>
                <a:cs typeface="Times New Roman" panose="02020603050405020304" pitchFamily="18" charset="0"/>
              </a:rPr>
              <a:t>immuno</a:t>
            </a:r>
            <a:r>
              <a:rPr lang="en-US" sz="1100" dirty="0">
                <a:latin typeface="Times New Roman" panose="02020603050405020304" pitchFamily="18" charset="0"/>
                <a:ea typeface="Batang" panose="02030600000101010101" pitchFamily="18" charset="-127"/>
                <a:cs typeface="Times New Roman" panose="02020603050405020304" pitchFamily="18" charset="0"/>
              </a:rPr>
              <a:t>blot </a:t>
            </a:r>
            <a:r>
              <a:rPr lang="en-US" altLang="ko-KR" sz="1100" dirty="0">
                <a:latin typeface="Times New Roman" panose="02020603050405020304" pitchFamily="18" charset="0"/>
                <a:ea typeface="Batang" panose="02030600000101010101" pitchFamily="18" charset="-127"/>
                <a:cs typeface="Times New Roman" panose="02020603050405020304" pitchFamily="18" charset="0"/>
              </a:rPr>
              <a:t>analysis </a:t>
            </a:r>
            <a:r>
              <a:rPr lang="en-US" sz="1100" dirty="0">
                <a:latin typeface="Times New Roman" panose="02020603050405020304" pitchFamily="18" charset="0"/>
                <a:ea typeface="Batang" panose="02030600000101010101" pitchFamily="18" charset="-127"/>
                <a:cs typeface="Times New Roman" panose="02020603050405020304" pitchFamily="18" charset="0"/>
              </a:rPr>
              <a:t>using antibodies for individual proteins; </a:t>
            </a:r>
            <a:r>
              <a:rPr lang="en-US" altLang="ko-KR" sz="1100" dirty="0">
                <a:latin typeface="Times New Roman" panose="02020603050405020304" pitchFamily="18" charset="0"/>
                <a:ea typeface="Batang" panose="02030600000101010101" pitchFamily="18" charset="-127"/>
                <a:cs typeface="Times New Roman" panose="02020603050405020304" pitchFamily="18" charset="0"/>
              </a:rPr>
              <a:t>protein D1 of photosystem II (</a:t>
            </a:r>
            <a:r>
              <a:rPr lang="en-US" altLang="ko-KR" sz="1100" dirty="0" err="1">
                <a:latin typeface="Times New Roman" panose="02020603050405020304" pitchFamily="18" charset="0"/>
                <a:ea typeface="Batang" panose="02030600000101010101" pitchFamily="18" charset="-127"/>
                <a:cs typeface="Times New Roman" panose="02020603050405020304" pitchFamily="18" charset="0"/>
              </a:rPr>
              <a:t>PsbA</a:t>
            </a:r>
            <a:r>
              <a:rPr lang="en-US" altLang="ko-KR" sz="1100" dirty="0">
                <a:latin typeface="Times New Roman" panose="02020603050405020304" pitchFamily="18" charset="0"/>
                <a:ea typeface="Batang" panose="02030600000101010101" pitchFamily="18" charset="-127"/>
                <a:cs typeface="Times New Roman" panose="02020603050405020304" pitchFamily="18" charset="0"/>
              </a:rPr>
              <a:t>), 39.7 </a:t>
            </a:r>
            <a:r>
              <a:rPr lang="en-US" altLang="ko-KR" sz="1100" dirty="0" err="1" smtClean="0">
                <a:latin typeface="Times New Roman" panose="02020603050405020304" pitchFamily="18" charset="0"/>
                <a:ea typeface="Batang" panose="02030600000101010101" pitchFamily="18" charset="-127"/>
                <a:cs typeface="Times New Roman" panose="02020603050405020304" pitchFamily="18" charset="0"/>
              </a:rPr>
              <a:t>kDa</a:t>
            </a:r>
            <a:r>
              <a:rPr lang="en-US" altLang="ko-KR" sz="1100" dirty="0" smtClean="0">
                <a:latin typeface="Times New Roman" panose="02020603050405020304" pitchFamily="18" charset="0"/>
                <a:ea typeface="Batang" panose="02030600000101010101" pitchFamily="18" charset="-127"/>
                <a:cs typeface="Times New Roman" panose="02020603050405020304" pitchFamily="18" charset="0"/>
              </a:rPr>
              <a:t>; </a:t>
            </a:r>
            <a:r>
              <a:rPr lang="en-US" sz="1100" dirty="0" smtClean="0">
                <a:latin typeface="Times New Roman" panose="02020603050405020304" pitchFamily="18" charset="0"/>
                <a:ea typeface="Batang" panose="02030600000101010101" pitchFamily="18" charset="-127"/>
                <a:cs typeface="Times New Roman" panose="02020603050405020304" pitchFamily="18" charset="0"/>
              </a:rPr>
              <a:t>a </a:t>
            </a:r>
            <a:r>
              <a:rPr lang="en-US" sz="1100" dirty="0">
                <a:latin typeface="Times New Roman" panose="02020603050405020304" pitchFamily="18" charset="0"/>
                <a:ea typeface="Batang" panose="02030600000101010101" pitchFamily="18" charset="-127"/>
                <a:cs typeface="Times New Roman" panose="02020603050405020304" pitchFamily="18" charset="0"/>
              </a:rPr>
              <a:t>subunit of </a:t>
            </a:r>
            <a:r>
              <a:rPr lang="en-US" altLang="ko-KR" sz="1100" dirty="0">
                <a:latin typeface="Times New Roman" panose="02020603050405020304" pitchFamily="18" charset="0"/>
                <a:ea typeface="Batang" panose="02030600000101010101" pitchFamily="18" charset="-127"/>
                <a:cs typeface="Times New Roman" panose="02020603050405020304" pitchFamily="18" charset="0"/>
              </a:rPr>
              <a:t>water-splitting complex </a:t>
            </a:r>
            <a:r>
              <a:rPr lang="en-US" altLang="ko-KR" sz="1100" dirty="0" smtClean="0">
                <a:latin typeface="Times New Roman" panose="02020603050405020304" pitchFamily="18" charset="0"/>
                <a:ea typeface="Batang" panose="02030600000101010101" pitchFamily="18" charset="-127"/>
                <a:cs typeface="Times New Roman" panose="02020603050405020304" pitchFamily="18" charset="0"/>
              </a:rPr>
              <a:t>(</a:t>
            </a:r>
            <a:r>
              <a:rPr lang="en-US" altLang="ko-KR" sz="1100" dirty="0" err="1" smtClean="0">
                <a:latin typeface="Times New Roman" panose="02020603050405020304" pitchFamily="18" charset="0"/>
                <a:ea typeface="Batang" panose="02030600000101010101" pitchFamily="18" charset="-127"/>
                <a:cs typeface="Times New Roman" panose="02020603050405020304" pitchFamily="18" charset="0"/>
              </a:rPr>
              <a:t>PsbO</a:t>
            </a:r>
            <a:r>
              <a:rPr lang="en-US" altLang="ko-KR" sz="1100" dirty="0" smtClean="0">
                <a:latin typeface="Times New Roman" panose="02020603050405020304" pitchFamily="18" charset="0"/>
                <a:ea typeface="Batang" panose="02030600000101010101" pitchFamily="18" charset="-127"/>
                <a:cs typeface="Times New Roman" panose="02020603050405020304" pitchFamily="18" charset="0"/>
              </a:rPr>
              <a:t>), </a:t>
            </a:r>
            <a:r>
              <a:rPr lang="en-US" altLang="ko-KR" sz="1100" dirty="0">
                <a:latin typeface="Times New Roman" panose="02020603050405020304" pitchFamily="18" charset="0"/>
                <a:ea typeface="Batang" panose="02030600000101010101" pitchFamily="18" charset="-127"/>
                <a:cs typeface="Times New Roman" panose="02020603050405020304" pitchFamily="18" charset="0"/>
              </a:rPr>
              <a:t>29.9 </a:t>
            </a:r>
            <a:r>
              <a:rPr lang="en-US" altLang="ko-KR" sz="1100" dirty="0" err="1" smtClean="0">
                <a:latin typeface="Times New Roman" panose="02020603050405020304" pitchFamily="18" charset="0"/>
                <a:ea typeface="Batang" panose="02030600000101010101" pitchFamily="18" charset="-127"/>
                <a:cs typeface="Times New Roman" panose="02020603050405020304" pitchFamily="18" charset="0"/>
              </a:rPr>
              <a:t>kDa</a:t>
            </a:r>
            <a:r>
              <a:rPr lang="en-US" sz="1100" dirty="0" smtClean="0">
                <a:latin typeface="Times New Roman" panose="02020603050405020304" pitchFamily="18" charset="0"/>
                <a:ea typeface="Batang" panose="02030600000101010101" pitchFamily="18" charset="-127"/>
                <a:cs typeface="Times New Roman" panose="02020603050405020304" pitchFamily="18" charset="0"/>
              </a:rPr>
              <a:t>; </a:t>
            </a:r>
            <a:r>
              <a:rPr lang="en-US" sz="1100" dirty="0">
                <a:latin typeface="Times New Roman" panose="02020603050405020304" pitchFamily="18" charset="0"/>
                <a:ea typeface="Gulim" panose="020B0600000101010101" pitchFamily="34" charset="-127"/>
                <a:cs typeface="Times New Roman" panose="02020603050405020304" pitchFamily="18" charset="0"/>
              </a:rPr>
              <a:t>stromal subunit of photosystem I </a:t>
            </a:r>
            <a:r>
              <a:rPr lang="en-US" sz="1100" dirty="0">
                <a:latin typeface="Times New Roman" panose="02020603050405020304" pitchFamily="18" charset="0"/>
                <a:ea typeface="Batang" panose="02030600000101010101" pitchFamily="18" charset="-127"/>
                <a:cs typeface="Times New Roman" panose="02020603050405020304" pitchFamily="18" charset="0"/>
              </a:rPr>
              <a:t>(</a:t>
            </a:r>
            <a:r>
              <a:rPr lang="en-US" sz="1100" dirty="0" err="1" smtClean="0">
                <a:latin typeface="Times New Roman" panose="02020603050405020304" pitchFamily="18" charset="0"/>
                <a:ea typeface="Batang" panose="02030600000101010101" pitchFamily="18" charset="-127"/>
                <a:cs typeface="Times New Roman" panose="02020603050405020304" pitchFamily="18" charset="0"/>
              </a:rPr>
              <a:t>PsaC</a:t>
            </a:r>
            <a:r>
              <a:rPr lang="en-US" sz="1100" dirty="0" smtClean="0">
                <a:latin typeface="Times New Roman" panose="02020603050405020304" pitchFamily="18" charset="0"/>
                <a:ea typeface="Batang" panose="02030600000101010101" pitchFamily="18" charset="-127"/>
                <a:cs typeface="Times New Roman" panose="02020603050405020304" pitchFamily="18" charset="0"/>
              </a:rPr>
              <a:t>), 9.0 </a:t>
            </a:r>
            <a:r>
              <a:rPr lang="en-US" sz="1100" dirty="0" err="1" smtClean="0">
                <a:latin typeface="Times New Roman" panose="02020603050405020304" pitchFamily="18" charset="0"/>
                <a:ea typeface="Batang" panose="02030600000101010101" pitchFamily="18" charset="-127"/>
                <a:cs typeface="Times New Roman" panose="02020603050405020304" pitchFamily="18" charset="0"/>
              </a:rPr>
              <a:t>kDa</a:t>
            </a:r>
            <a:r>
              <a:rPr lang="en-US" sz="1100" dirty="0" smtClean="0">
                <a:latin typeface="Times New Roman" panose="02020603050405020304" pitchFamily="18" charset="0"/>
                <a:ea typeface="Batang" panose="02030600000101010101" pitchFamily="18" charset="-127"/>
                <a:cs typeface="Times New Roman" panose="02020603050405020304" pitchFamily="18" charset="0"/>
              </a:rPr>
              <a:t>; </a:t>
            </a:r>
            <a:r>
              <a:rPr lang="en-US" sz="1100" dirty="0">
                <a:latin typeface="Times New Roman" panose="02020603050405020304" pitchFamily="18" charset="0"/>
                <a:ea typeface="Batang" panose="02030600000101010101" pitchFamily="18" charset="-127"/>
                <a:cs typeface="Times New Roman" panose="02020603050405020304" pitchFamily="18" charset="0"/>
              </a:rPr>
              <a:t>luminal electron carrier (</a:t>
            </a:r>
            <a:r>
              <a:rPr lang="en-US" sz="1100" dirty="0" smtClean="0">
                <a:latin typeface="Times New Roman" panose="02020603050405020304" pitchFamily="18" charset="0"/>
                <a:ea typeface="Batang" panose="02030600000101010101" pitchFamily="18" charset="-127"/>
                <a:cs typeface="Times New Roman" panose="02020603050405020304" pitchFamily="18" charset="0"/>
              </a:rPr>
              <a:t>PC), 13.1 </a:t>
            </a:r>
            <a:r>
              <a:rPr lang="en-US" sz="1100" dirty="0" err="1" smtClean="0">
                <a:latin typeface="Times New Roman" panose="02020603050405020304" pitchFamily="18" charset="0"/>
                <a:ea typeface="Batang" panose="02030600000101010101" pitchFamily="18" charset="-127"/>
                <a:cs typeface="Times New Roman" panose="02020603050405020304" pitchFamily="18" charset="0"/>
              </a:rPr>
              <a:t>kDa</a:t>
            </a:r>
            <a:r>
              <a:rPr lang="en-US" sz="1100" dirty="0" smtClean="0">
                <a:latin typeface="Times New Roman" panose="02020603050405020304" pitchFamily="18" charset="0"/>
                <a:ea typeface="Batang" panose="02030600000101010101" pitchFamily="18" charset="-127"/>
                <a:cs typeface="Times New Roman" panose="02020603050405020304" pitchFamily="18" charset="0"/>
              </a:rPr>
              <a:t>. 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he relative band intensities of each component were quantified using </a:t>
            </a:r>
            <a:r>
              <a:rPr lang="en-US" altLang="ko-KR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ImageJ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nd </a:t>
            </a:r>
            <a:r>
              <a:rPr lang="en-US" altLang="ko-KR" sz="1100" dirty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shown under leach lane in comparison with those at day zero. </a:t>
            </a:r>
            <a:endParaRPr lang="en-US" altLang="ko-KR" sz="1100" dirty="0">
              <a:latin typeface="Gulim" panose="020B0600000101010101" pitchFamily="34" charset="-127"/>
              <a:ea typeface="Gulim" panose="020B0600000101010101" pitchFamily="34" charset="-127"/>
              <a:cs typeface="Gulim" panose="020B0600000101010101" pitchFamily="34" charset="-127"/>
            </a:endParaRPr>
          </a:p>
        </p:txBody>
      </p:sp>
      <p:cxnSp>
        <p:nvCxnSpPr>
          <p:cNvPr id="3" name="직선 연결선 2"/>
          <p:cNvCxnSpPr/>
          <p:nvPr/>
        </p:nvCxnSpPr>
        <p:spPr>
          <a:xfrm>
            <a:off x="3589020" y="1930252"/>
            <a:ext cx="237744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2" name="직선 연결선 51"/>
          <p:cNvCxnSpPr/>
          <p:nvPr/>
        </p:nvCxnSpPr>
        <p:spPr>
          <a:xfrm>
            <a:off x="6779321" y="1927204"/>
            <a:ext cx="237744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>
            <a:off x="7711233" y="1664194"/>
            <a:ext cx="5004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s</a:t>
            </a:r>
          </a:p>
        </p:txBody>
      </p:sp>
    </p:spTree>
    <p:extLst>
      <p:ext uri="{BB962C8B-B14F-4D97-AF65-F5344CB8AC3E}">
        <p14:creationId xmlns:p14="http://schemas.microsoft.com/office/powerpoint/2010/main" val="1000138577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TextBox 73"/>
          <p:cNvSpPr txBox="1"/>
          <p:nvPr/>
        </p:nvSpPr>
        <p:spPr>
          <a:xfrm>
            <a:off x="2693555" y="1473281"/>
            <a:ext cx="2702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6087742" y="1466105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78" name="TextBox 77"/>
          <p:cNvSpPr txBox="1"/>
          <p:nvPr/>
        </p:nvSpPr>
        <p:spPr>
          <a:xfrm>
            <a:off x="4206576" y="1665411"/>
            <a:ext cx="7243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(h)</a:t>
            </a:r>
          </a:p>
        </p:txBody>
      </p:sp>
      <p:sp>
        <p:nvSpPr>
          <p:cNvPr id="95" name="TextBox 94"/>
          <p:cNvSpPr txBox="1"/>
          <p:nvPr/>
        </p:nvSpPr>
        <p:spPr>
          <a:xfrm>
            <a:off x="6603724" y="1897542"/>
            <a:ext cx="26156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0       2      5      15     24     36    48      </a:t>
            </a:r>
          </a:p>
        </p:txBody>
      </p:sp>
      <p:pic>
        <p:nvPicPr>
          <p:cNvPr id="96" name="그림 95"/>
          <p:cNvPicPr>
            <a:picLocks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4828" t="43939" r="16113" b="49838"/>
          <a:stretch/>
        </p:blipFill>
        <p:spPr>
          <a:xfrm>
            <a:off x="6634967" y="2162867"/>
            <a:ext cx="2395886" cy="34527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7" name="그림 96"/>
          <p:cNvPicPr>
            <a:picLocks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1616" t="26686" r="42339" b="43581"/>
          <a:stretch/>
        </p:blipFill>
        <p:spPr>
          <a:xfrm rot="16200000">
            <a:off x="7656082" y="2178465"/>
            <a:ext cx="345271" cy="239588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8" name="그림 97"/>
          <p:cNvPicPr>
            <a:picLocks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aturation sat="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7500" t="23442" r="46350" b="45510"/>
          <a:stretch/>
        </p:blipFill>
        <p:spPr>
          <a:xfrm rot="16200000">
            <a:off x="7657278" y="1655509"/>
            <a:ext cx="345271" cy="239588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9" name="그림 98"/>
          <p:cNvPicPr>
            <a:picLocks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saturation sat="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685" t="56479" r="62813" b="15521"/>
          <a:stretch/>
        </p:blipFill>
        <p:spPr>
          <a:xfrm rot="16200000">
            <a:off x="7656804" y="2697526"/>
            <a:ext cx="345271" cy="239195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0" name="TextBox 99"/>
          <p:cNvSpPr txBox="1"/>
          <p:nvPr/>
        </p:nvSpPr>
        <p:spPr>
          <a:xfrm>
            <a:off x="3324079" y="1897811"/>
            <a:ext cx="26156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0       2       5      15     24     36    48      </a:t>
            </a:r>
          </a:p>
        </p:txBody>
      </p:sp>
      <p:sp>
        <p:nvSpPr>
          <p:cNvPr id="101" name="TextBox 100"/>
          <p:cNvSpPr txBox="1"/>
          <p:nvPr/>
        </p:nvSpPr>
        <p:spPr>
          <a:xfrm>
            <a:off x="2860187" y="2214391"/>
            <a:ext cx="5464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s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</a:t>
            </a:r>
          </a:p>
        </p:txBody>
      </p:sp>
      <p:sp>
        <p:nvSpPr>
          <p:cNvPr id="102" name="TextBox 101"/>
          <p:cNvSpPr txBox="1"/>
          <p:nvPr/>
        </p:nvSpPr>
        <p:spPr>
          <a:xfrm>
            <a:off x="2852182" y="2720058"/>
            <a:ext cx="5549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s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</a:t>
            </a:r>
          </a:p>
        </p:txBody>
      </p:sp>
      <p:sp>
        <p:nvSpPr>
          <p:cNvPr id="103" name="TextBox 102"/>
          <p:cNvSpPr txBox="1"/>
          <p:nvPr/>
        </p:nvSpPr>
        <p:spPr>
          <a:xfrm>
            <a:off x="2858885" y="3233481"/>
            <a:ext cx="5389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s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</a:t>
            </a:r>
          </a:p>
        </p:txBody>
      </p:sp>
      <p:sp>
        <p:nvSpPr>
          <p:cNvPr id="104" name="TextBox 103"/>
          <p:cNvSpPr txBox="1"/>
          <p:nvPr/>
        </p:nvSpPr>
        <p:spPr>
          <a:xfrm>
            <a:off x="2951186" y="3785908"/>
            <a:ext cx="372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</a:t>
            </a:r>
          </a:p>
        </p:txBody>
      </p:sp>
      <p:pic>
        <p:nvPicPr>
          <p:cNvPr id="105" name="그림 104"/>
          <p:cNvPicPr>
            <a:picLocks/>
          </p:cNvPicPr>
          <p:nvPr/>
        </p:nvPicPr>
        <p:blipFill rotWithShape="1"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4828" t="72994" r="15850" b="20961"/>
          <a:stretch/>
        </p:blipFill>
        <p:spPr>
          <a:xfrm>
            <a:off x="3391705" y="2163577"/>
            <a:ext cx="2395885" cy="34527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6" name="그림 105"/>
          <p:cNvPicPr>
            <a:picLocks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saturation sat="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736" t="25807" r="62649" b="43133"/>
          <a:stretch/>
        </p:blipFill>
        <p:spPr>
          <a:xfrm rot="16200000">
            <a:off x="4416909" y="2688566"/>
            <a:ext cx="345271" cy="239588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7" name="그림 106"/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2624" t="55930" r="42042" b="15054"/>
          <a:stretch/>
        </p:blipFill>
        <p:spPr>
          <a:xfrm rot="16200000">
            <a:off x="4416237" y="2173880"/>
            <a:ext cx="346823" cy="239588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8" name="그림 107"/>
          <p:cNvPicPr>
            <a:picLocks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aturation sat="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7212" t="54335" r="46758" b="17104"/>
          <a:stretch/>
        </p:blipFill>
        <p:spPr>
          <a:xfrm rot="16200000">
            <a:off x="4417011" y="1659737"/>
            <a:ext cx="345271" cy="239588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9" name="TextBox 108"/>
          <p:cNvSpPr txBox="1"/>
          <p:nvPr/>
        </p:nvSpPr>
        <p:spPr>
          <a:xfrm>
            <a:off x="3387412" y="2478387"/>
            <a:ext cx="25250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0      0.7      0.9      0.7      0.1    0.06    0.03</a:t>
            </a:r>
          </a:p>
        </p:txBody>
      </p:sp>
      <p:sp>
        <p:nvSpPr>
          <p:cNvPr id="110" name="TextBox 109"/>
          <p:cNvSpPr txBox="1"/>
          <p:nvPr/>
        </p:nvSpPr>
        <p:spPr>
          <a:xfrm>
            <a:off x="3402361" y="2998176"/>
            <a:ext cx="25571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.0      0.8       0.7      0.4      0.3     0.1    0.05</a:t>
            </a:r>
          </a:p>
        </p:txBody>
      </p:sp>
      <p:sp>
        <p:nvSpPr>
          <p:cNvPr id="111" name="TextBox 110"/>
          <p:cNvSpPr txBox="1"/>
          <p:nvPr/>
        </p:nvSpPr>
        <p:spPr>
          <a:xfrm>
            <a:off x="3403816" y="3519909"/>
            <a:ext cx="23968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0      0.8      0.6      0.8      0.5     0.2     0.1</a:t>
            </a:r>
          </a:p>
        </p:txBody>
      </p:sp>
      <p:sp>
        <p:nvSpPr>
          <p:cNvPr id="112" name="TextBox 111"/>
          <p:cNvSpPr txBox="1"/>
          <p:nvPr/>
        </p:nvSpPr>
        <p:spPr>
          <a:xfrm>
            <a:off x="3386943" y="4023946"/>
            <a:ext cx="24609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.0      0.8     0.6       0.2      0.0      0.0     0.0</a:t>
            </a:r>
          </a:p>
        </p:txBody>
      </p:sp>
      <p:sp>
        <p:nvSpPr>
          <p:cNvPr id="113" name="TextBox 112"/>
          <p:cNvSpPr txBox="1"/>
          <p:nvPr/>
        </p:nvSpPr>
        <p:spPr>
          <a:xfrm>
            <a:off x="6670718" y="2471081"/>
            <a:ext cx="23647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0     1.0      0.9      0.8      0.6      0.3    0.3</a:t>
            </a:r>
          </a:p>
        </p:txBody>
      </p:sp>
      <p:sp>
        <p:nvSpPr>
          <p:cNvPr id="114" name="TextBox 113"/>
          <p:cNvSpPr txBox="1"/>
          <p:nvPr/>
        </p:nvSpPr>
        <p:spPr>
          <a:xfrm>
            <a:off x="6664984" y="2998090"/>
            <a:ext cx="23968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0     1.0       0.8      0.8     0.7     0.5     0.3</a:t>
            </a:r>
          </a:p>
        </p:txBody>
      </p:sp>
      <p:sp>
        <p:nvSpPr>
          <p:cNvPr id="115" name="TextBox 114"/>
          <p:cNvSpPr txBox="1"/>
          <p:nvPr/>
        </p:nvSpPr>
        <p:spPr>
          <a:xfrm>
            <a:off x="6662372" y="3504038"/>
            <a:ext cx="23647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0     0.9      0.9     0.8      0.8      0.9     0.6</a:t>
            </a:r>
          </a:p>
        </p:txBody>
      </p:sp>
      <p:sp>
        <p:nvSpPr>
          <p:cNvPr id="116" name="TextBox 115"/>
          <p:cNvSpPr txBox="1"/>
          <p:nvPr/>
        </p:nvSpPr>
        <p:spPr>
          <a:xfrm>
            <a:off x="6658354" y="4027509"/>
            <a:ext cx="24288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0      0.9      1.0       1.0      0.8    0.5     0.3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7431210" y="1661009"/>
            <a:ext cx="7243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(h)</a:t>
            </a:r>
          </a:p>
        </p:txBody>
      </p:sp>
      <p:cxnSp>
        <p:nvCxnSpPr>
          <p:cNvPr id="3" name="직선 연결선 2"/>
          <p:cNvCxnSpPr/>
          <p:nvPr/>
        </p:nvCxnSpPr>
        <p:spPr>
          <a:xfrm>
            <a:off x="3407327" y="1898890"/>
            <a:ext cx="237744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2" name="직선 연결선 51"/>
          <p:cNvCxnSpPr/>
          <p:nvPr/>
        </p:nvCxnSpPr>
        <p:spPr>
          <a:xfrm>
            <a:off x="6626792" y="1904986"/>
            <a:ext cx="237744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직사각형 49"/>
          <p:cNvSpPr/>
          <p:nvPr/>
        </p:nvSpPr>
        <p:spPr>
          <a:xfrm>
            <a:off x="67056" y="5190321"/>
            <a:ext cx="12124944" cy="85408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1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. S12. </a:t>
            </a:r>
            <a:r>
              <a:rPr lang="en-US" altLang="ko-KR" sz="11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tability of the four major </a:t>
            </a:r>
            <a:r>
              <a:rPr lang="en-US" altLang="ko-K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otosynthetic proteins of </a:t>
            </a:r>
            <a:r>
              <a:rPr lang="en-US" altLang="ko-KR" sz="1100" b="1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TMe</a:t>
            </a:r>
            <a:r>
              <a:rPr lang="en-US" altLang="ko-KR" sz="11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nd b-</a:t>
            </a:r>
            <a:r>
              <a:rPr lang="en-US" altLang="ko-KR" sz="1100" b="1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TMe</a:t>
            </a:r>
            <a:r>
              <a:rPr lang="en-US" altLang="ko-KR" sz="11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during incubation at </a:t>
            </a:r>
            <a:r>
              <a:rPr lang="en-US" altLang="ko-K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r>
              <a:rPr lang="zh-CN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℃ </a:t>
            </a:r>
            <a:r>
              <a:rPr lang="en-US" altLang="zh-C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altLang="ko-K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ght</a:t>
            </a:r>
            <a:r>
              <a:rPr lang="en-US" altLang="ko-KR" sz="11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same f</a:t>
            </a:r>
            <a:r>
              <a:rPr lang="en-US" sz="1100" dirty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our </a:t>
            </a:r>
            <a:r>
              <a:rPr lang="en-US" altLang="ko-KR" sz="1100" dirty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proteins </a:t>
            </a:r>
            <a:r>
              <a:rPr lang="en-US" sz="1100" dirty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of </a:t>
            </a:r>
            <a:r>
              <a:rPr lang="en-US" sz="1100" dirty="0" err="1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pTMe</a:t>
            </a:r>
            <a:r>
              <a:rPr lang="en-US" sz="1100" dirty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 (A) and b-</a:t>
            </a:r>
            <a:r>
              <a:rPr lang="en-US" sz="1100" dirty="0" err="1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pTMe</a:t>
            </a:r>
            <a:r>
              <a:rPr lang="en-US" sz="1100" dirty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 (B) </a:t>
            </a:r>
            <a:r>
              <a:rPr lang="en-US" altLang="ko-KR" sz="1100" dirty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as observed in Fig. S11 were examined during incubation in TM-NADP</a:t>
            </a:r>
            <a:r>
              <a:rPr lang="en-US" altLang="ko-KR" sz="1100" baseline="30000" dirty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+</a:t>
            </a:r>
            <a:r>
              <a:rPr lang="en-US" altLang="ko-KR" sz="1100" dirty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 buffer at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℃ in light for 48 h by </a:t>
            </a:r>
            <a:r>
              <a:rPr lang="en-US" altLang="ko-KR" sz="1100" dirty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western immunoblot </a:t>
            </a:r>
            <a:r>
              <a:rPr lang="en-US" altLang="ko-KR" sz="1100" dirty="0" smtClean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analysis</a:t>
            </a:r>
            <a:r>
              <a:rPr lang="en-US" sz="1100" dirty="0" smtClean="0">
                <a:latin typeface="Times New Roman" panose="02020603050405020304" pitchFamily="18" charset="0"/>
                <a:ea typeface="Batang" panose="02030600000101010101" pitchFamily="18" charset="-127"/>
                <a:cs typeface="Times New Roman" panose="02020603050405020304" pitchFamily="18" charset="0"/>
              </a:rPr>
              <a:t>.</a:t>
            </a:r>
            <a:r>
              <a:rPr lang="en-US" sz="1100" dirty="0" smtClean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 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he relative band intensities of each component were quantified using </a:t>
            </a:r>
            <a:r>
              <a:rPr lang="en-US" altLang="ko-KR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ImageJ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nd </a:t>
            </a:r>
            <a:r>
              <a:rPr lang="en-US" altLang="ko-KR" sz="1100" dirty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shown under leach lane in comparison with those at day zero. </a:t>
            </a:r>
            <a:endParaRPr lang="en-US" altLang="ko-KR" sz="1100" dirty="0">
              <a:latin typeface="Gulim" panose="020B0600000101010101" pitchFamily="34" charset="-127"/>
              <a:ea typeface="Gulim" panose="020B0600000101010101" pitchFamily="34" charset="-127"/>
              <a:cs typeface="Gulim" panose="020B0600000101010101" pitchFamily="34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2918707934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5" name="차트 24"/>
          <p:cNvGraphicFramePr>
            <a:graphicFrameLocks/>
          </p:cNvGraphicFramePr>
          <p:nvPr/>
        </p:nvGraphicFramePr>
        <p:xfrm>
          <a:off x="6479596" y="96756"/>
          <a:ext cx="2570336" cy="248290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차트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1378223"/>
              </p:ext>
            </p:extLst>
          </p:nvPr>
        </p:nvGraphicFramePr>
        <p:xfrm>
          <a:off x="6150106" y="2766102"/>
          <a:ext cx="2976496" cy="25450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차트 5"/>
          <p:cNvGraphicFramePr>
            <a:graphicFrameLocks/>
          </p:cNvGraphicFramePr>
          <p:nvPr/>
        </p:nvGraphicFramePr>
        <p:xfrm>
          <a:off x="3132525" y="113373"/>
          <a:ext cx="2812462" cy="24123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4230349" y="2461965"/>
            <a:ext cx="9028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US" sz="12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sz="12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µM)</a:t>
            </a:r>
          </a:p>
        </p:txBody>
      </p:sp>
      <p:sp>
        <p:nvSpPr>
          <p:cNvPr id="8" name="TextBox 7"/>
          <p:cNvSpPr txBox="1"/>
          <p:nvPr/>
        </p:nvSpPr>
        <p:spPr>
          <a:xfrm rot="16200000">
            <a:off x="2222740" y="1078194"/>
            <a:ext cx="1642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uorescence intensity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2640142" y="-5804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6077229" y="-56235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7549378" y="2461619"/>
            <a:ext cx="6955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µg)</a:t>
            </a:r>
          </a:p>
        </p:txBody>
      </p:sp>
      <p:graphicFrame>
        <p:nvGraphicFramePr>
          <p:cNvPr id="12" name="차트 11"/>
          <p:cNvGraphicFramePr>
            <a:graphicFrameLocks/>
          </p:cNvGraphicFramePr>
          <p:nvPr/>
        </p:nvGraphicFramePr>
        <p:xfrm>
          <a:off x="3231374" y="2827090"/>
          <a:ext cx="2604312" cy="23693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3" name="TextBox 12"/>
          <p:cNvSpPr txBox="1"/>
          <p:nvPr/>
        </p:nvSpPr>
        <p:spPr>
          <a:xfrm rot="16200000">
            <a:off x="2280371" y="3665480"/>
            <a:ext cx="148630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NADPH 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ration rate (%)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219306" y="5093307"/>
            <a:ext cx="8803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Cl</a:t>
            </a:r>
            <a:r>
              <a:rPr lang="en-US" sz="12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µl)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2631662" y="257965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6065184" y="2582092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7453463" y="5095942"/>
            <a:ext cx="8803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Cl</a:t>
            </a:r>
            <a:r>
              <a:rPr lang="en-US" sz="12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µl)</a:t>
            </a:r>
          </a:p>
        </p:txBody>
      </p:sp>
      <p:sp>
        <p:nvSpPr>
          <p:cNvPr id="18" name="TextBox 17"/>
          <p:cNvSpPr txBox="1"/>
          <p:nvPr/>
        </p:nvSpPr>
        <p:spPr>
          <a:xfrm rot="16200000">
            <a:off x="5325440" y="1023036"/>
            <a:ext cx="21295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uorescence intensity (x 10</a:t>
            </a:r>
            <a:r>
              <a:rPr lang="en-US" sz="12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19" name="TextBox 18"/>
          <p:cNvSpPr txBox="1"/>
          <p:nvPr/>
        </p:nvSpPr>
        <p:spPr>
          <a:xfrm rot="16200000">
            <a:off x="5340556" y="3685859"/>
            <a:ext cx="21295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uorescence intensity (x 10</a:t>
            </a:r>
            <a:r>
              <a:rPr lang="en-US" sz="12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1946480260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75470" y="3333644"/>
            <a:ext cx="12011706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3. Use of </a:t>
            </a:r>
            <a:r>
              <a:rPr lang="en-US" sz="11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ynechocystis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lysate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esterase activity and chloroform for lysis of </a:t>
            </a:r>
            <a:r>
              <a:rPr lang="en-US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TMe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b-</a:t>
            </a:r>
            <a:r>
              <a:rPr lang="en-US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TMe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Varying levels of hydrogen peroxide w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e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xed with </a:t>
            </a:r>
            <a:r>
              <a:rPr lang="en-US" altLang="ko-KR" sz="1100" i="1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ynechocystis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cell lysate (CL) (32 and 64 </a:t>
            </a:r>
            <a:r>
              <a:rPr lang="el-GR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g) and H</a:t>
            </a:r>
            <a:r>
              <a:rPr lang="en-US" altLang="ko-KR" sz="1100" baseline="-25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DCFDA (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0.1 </a:t>
            </a:r>
            <a:r>
              <a:rPr lang="en-US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M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, 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ollowed</a:t>
            </a:r>
            <a:r>
              <a:rPr lang="ko-KR" alt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by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cubation at 30°C for 10 min. Fluorescence at 525 nm was detected after excitation at 488 nm.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luorescence from H</a:t>
            </a:r>
            <a:r>
              <a:rPr lang="en-US" sz="1100" baseline="-25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DCFDA without </a:t>
            </a:r>
            <a:r>
              <a:rPr lang="en-US" sz="110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L 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was used as control.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) </a:t>
            </a:r>
            <a:r>
              <a:rPr lang="en-US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TMe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(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 µg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l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l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was mixed with TM-NADP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uffer and incubated at 30℃ for 2 h. Aliquot (0.2 ml) was withdrawn and mixed with 0.1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</a:t>
            </a:r>
            <a:r>
              <a:rPr lang="en-US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CFDA and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32 </a:t>
            </a:r>
            <a:r>
              <a:rPr lang="el-GR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 and 64 </a:t>
            </a:r>
            <a:r>
              <a:rPr lang="el-GR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Sample without CL 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was used as </a:t>
            </a:r>
            <a:r>
              <a:rPr lang="en-US" altLang="ko-KR" sz="110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ontrol. The mixtures were 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cubated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 30℃ for 10 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n, and fluorescence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 525 nm was detected after excitation at 488 nm. Difference in</a:t>
            </a:r>
            <a:r>
              <a:rPr lang="ko-KR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uorescence between </a:t>
            </a:r>
            <a:r>
              <a:rPr lang="en-US" altLang="ko-K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TMe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with CL)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 itself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s illustrated.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 Varying levels of 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hloroform were added to </a:t>
            </a:r>
            <a:r>
              <a:rPr lang="en-US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TMe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(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 µg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l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l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in 0.2 ml TM-NADP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uffer, followed by vigorous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ortexing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NADPH generation rate was determined and represented as percentage of that without addition of chloroform. (D)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TMe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b-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T</a:t>
            </a:r>
            <a:r>
              <a:rPr lang="en-US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e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t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 µg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l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l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ere mixed with TM-NADP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uffer and incubated at 30℃ for 2 h for NADPH generation. Aliquot (0.2 ml) was withdrawn and mixed with chloroform as indicated, followed by vigorous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ortexing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Subsequently, 0.1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</a:t>
            </a:r>
            <a:r>
              <a:rPr lang="en-US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CFDA and 32 µg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added, and the mixture was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cubated at 30℃ for 10 min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determine general ROS.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uorescence at 525 nm was measured after excitation at 488 nm.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luorescence from H</a:t>
            </a:r>
            <a:r>
              <a:rPr lang="en-US" sz="1100" baseline="-25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DCFDA without chloroform was used as control.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59658432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직사각형 2"/>
          <p:cNvSpPr/>
          <p:nvPr/>
        </p:nvSpPr>
        <p:spPr>
          <a:xfrm>
            <a:off x="0" y="4661604"/>
            <a:ext cx="12120282" cy="136191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1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. S14. Determination of ROS generated </a:t>
            </a:r>
            <a:r>
              <a:rPr lang="en-US" altLang="ko-KR" sz="11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by </a:t>
            </a:r>
            <a:r>
              <a:rPr lang="en-US" sz="1100" b="1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TMe</a:t>
            </a:r>
            <a:r>
              <a:rPr lang="en-US" sz="11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nd b-</a:t>
            </a:r>
            <a:r>
              <a:rPr lang="en-US" sz="1100" b="1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TMe</a:t>
            </a:r>
            <a:r>
              <a:rPr lang="en-US" sz="11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A)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inglet oxygen was detected by incubation of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TMe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b-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TMe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5 µg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l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l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in TM-NADP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uffer supplemented with 50 µM SOSG. Reaction mixture was incubated at 30°C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30 min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der white light (50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ol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2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in a total volume of 0.2 ml. Fluorescence was detected at 525 nm after excitation at 504 nm. (B) General ROS was detected with 0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2 ml aliquot withdrawn from reaction mixture of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TMe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b-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TMe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5 µg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l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l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in TM-NADP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uffer, which had been incubated at 30°C for 2 h under white light (50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ol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2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TMe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b-</a:t>
            </a:r>
            <a:r>
              <a:rPr lang="en-US" altLang="zh-CN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TMe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ere lysed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 </a:t>
            </a:r>
            <a:r>
              <a:rPr lang="el-GR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 chloroform, and 0.1 </a:t>
            </a:r>
            <a:r>
              <a:rPr lang="en-US" altLang="zh-CN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100" dirty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 H</a:t>
            </a:r>
            <a:r>
              <a:rPr lang="en-US" sz="1100" baseline="-25000" dirty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2</a:t>
            </a:r>
            <a:r>
              <a:rPr lang="en-US" sz="1100" dirty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DCFDA was added to the reaction mixture with 32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µg </a:t>
            </a:r>
            <a:r>
              <a:rPr lang="en-US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ynechocystis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mixture was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n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cubated at 30</a:t>
            </a:r>
            <a:r>
              <a:rPr lang="zh-CN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℃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10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n,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llowed by detection of fluorescence at 525 nm after excitation at 488 nm. </a:t>
            </a:r>
            <a:endParaRPr lang="en-US" sz="1100" dirty="0">
              <a:latin typeface="Gulim" panose="020B0600000101010101" pitchFamily="34" charset="-127"/>
              <a:ea typeface="Gulim" panose="020B0600000101010101" pitchFamily="34" charset="-127"/>
              <a:cs typeface="Gulim" panose="020B0600000101010101" pitchFamily="34" charset="-127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056336" y="932274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6193967" y="932274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graphicFrame>
        <p:nvGraphicFramePr>
          <p:cNvPr id="10" name="차트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51462437"/>
              </p:ext>
            </p:extLst>
          </p:nvPr>
        </p:nvGraphicFramePr>
        <p:xfrm>
          <a:off x="6410001" y="1090785"/>
          <a:ext cx="3118047" cy="36127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차트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09087538"/>
              </p:ext>
            </p:extLst>
          </p:nvPr>
        </p:nvGraphicFramePr>
        <p:xfrm>
          <a:off x="3263438" y="1090267"/>
          <a:ext cx="2939462" cy="29535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7" name="TextBox 16"/>
          <p:cNvSpPr txBox="1"/>
          <p:nvPr/>
        </p:nvSpPr>
        <p:spPr>
          <a:xfrm rot="16200000">
            <a:off x="2372239" y="2197107"/>
            <a:ext cx="21295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uorescence intensity (x 10</a:t>
            </a:r>
            <a:r>
              <a:rPr lang="en-US" sz="12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18" name="TextBox 17"/>
          <p:cNvSpPr txBox="1"/>
          <p:nvPr/>
        </p:nvSpPr>
        <p:spPr>
          <a:xfrm rot="16200000">
            <a:off x="5518712" y="2168414"/>
            <a:ext cx="21295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uorescence intensity (x 10</a:t>
            </a:r>
            <a:r>
              <a:rPr lang="en-US" sz="12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1531836972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차트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4830206"/>
              </p:ext>
            </p:extLst>
          </p:nvPr>
        </p:nvGraphicFramePr>
        <p:xfrm>
          <a:off x="1571211" y="440881"/>
          <a:ext cx="2896670" cy="30193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차트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60394094"/>
              </p:ext>
            </p:extLst>
          </p:nvPr>
        </p:nvGraphicFramePr>
        <p:xfrm>
          <a:off x="4595102" y="440881"/>
          <a:ext cx="2816254" cy="28085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10" name="직선 연결선 9"/>
          <p:cNvCxnSpPr/>
          <p:nvPr/>
        </p:nvCxnSpPr>
        <p:spPr>
          <a:xfrm>
            <a:off x="2487902" y="3124600"/>
            <a:ext cx="128016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2636560" y="3124600"/>
            <a:ext cx="9733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5 (µg ml</a:t>
            </a:r>
            <a:r>
              <a:rPr lang="en-US" sz="12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cxnSp>
        <p:nvCxnSpPr>
          <p:cNvPr id="12" name="직선 연결선 11"/>
          <p:cNvCxnSpPr/>
          <p:nvPr/>
        </p:nvCxnSpPr>
        <p:spPr>
          <a:xfrm>
            <a:off x="5335936" y="3135739"/>
            <a:ext cx="155448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5727738" y="3120679"/>
            <a:ext cx="9733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5 (µg ml</a:t>
            </a:r>
            <a:r>
              <a:rPr lang="en-US" sz="12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2" name="직사각형 1"/>
          <p:cNvSpPr/>
          <p:nvPr/>
        </p:nvSpPr>
        <p:spPr>
          <a:xfrm>
            <a:off x="77297" y="3921989"/>
            <a:ext cx="12071758" cy="186974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1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. S15. Determination of antioxidant activity of R5.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) Varying levels of R5 (1,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,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25 µg ml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were examined for the quenching ability of singlet oxygen generated with 50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inoleic acid and 0.1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ethylene blue in front of fluorescent lamp for 1 h. The resulting peroxides were detected at A</a:t>
            </a:r>
            <a:r>
              <a:rPr lang="en-US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0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ing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erric thiocyanate method [48]. Histidine (3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was used as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sitive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.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uenching of singlet oxygen was calculated as inhibition % of the equation described in Materials and Methods.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Superoxide scavenger activity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5 (1-200 µg ml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was measured with xanthine and xanthine oxidase in the presence of NBT. The oxidized formazan was detected at A</a:t>
            </a:r>
            <a:r>
              <a:rPr lang="en-US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60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action was performed at room temperature for 20 min, and superoxide scavenging activity was calculated as inhibition % of the equation described in Materials and Methods. Superoxide scavenging in the presence of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D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 5 U ml</a:t>
            </a:r>
            <a:r>
              <a:rPr lang="en-US" altLang="ko-KR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s regarded as positive control. (C)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pt-BR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ydrogen peroxide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veng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g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vity of R5 (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-200 µg ml</a:t>
            </a:r>
            <a:r>
              <a:rPr lang="en-US" altLang="ko-KR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s examined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</a:t>
            </a:r>
            <a:r>
              <a:rPr lang="pt-BR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mM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US" altLang="ko-KR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altLang="ko-KR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fter incubation of the mixture in 10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odium phosphate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uffer (pH 7.5)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 30°C for 5 min. Catalase (30 µg ml</a:t>
            </a:r>
            <a:r>
              <a:rPr lang="en-US" altLang="ko-KR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was used as positive control. After reaction, the absorption at 230 nm was monitored to detect hydrogen peroxide. The scavenger activity of hydrogen peroxide was calculated as inhibition % of the equation described in Materials and Methods. </a:t>
            </a:r>
            <a:endParaRPr lang="en-US" sz="11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524012" y="209907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4510115" y="209907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7506299" y="206859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graphicFrame>
        <p:nvGraphicFramePr>
          <p:cNvPr id="23" name="차트 2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35918085"/>
              </p:ext>
            </p:extLst>
          </p:nvPr>
        </p:nvGraphicFramePr>
        <p:xfrm>
          <a:off x="7837809" y="475027"/>
          <a:ext cx="2609701" cy="29862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cxnSp>
        <p:nvCxnSpPr>
          <p:cNvPr id="24" name="직선 연결선 23"/>
          <p:cNvCxnSpPr/>
          <p:nvPr/>
        </p:nvCxnSpPr>
        <p:spPr>
          <a:xfrm>
            <a:off x="8271633" y="3139222"/>
            <a:ext cx="155448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8654291" y="3124162"/>
            <a:ext cx="9733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5 (µg ml</a:t>
            </a:r>
            <a:r>
              <a:rPr lang="en-US" sz="12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22" name="TextBox 21"/>
          <p:cNvSpPr txBox="1"/>
          <p:nvPr/>
        </p:nvSpPr>
        <p:spPr>
          <a:xfrm rot="16200000">
            <a:off x="7232808" y="1504554"/>
            <a:ext cx="1136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hibition (%)</a:t>
            </a:r>
          </a:p>
        </p:txBody>
      </p:sp>
    </p:spTree>
    <p:extLst>
      <p:ext uri="{BB962C8B-B14F-4D97-AF65-F5344CB8AC3E}">
        <p14:creationId xmlns:p14="http://schemas.microsoft.com/office/powerpoint/2010/main" val="11511871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774031" y="299785"/>
            <a:ext cx="27547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. PCR primers used in this study 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표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64535585"/>
              </p:ext>
            </p:extLst>
          </p:nvPr>
        </p:nvGraphicFramePr>
        <p:xfrm>
          <a:off x="841247" y="576784"/>
          <a:ext cx="10632716" cy="5761934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052839">
                  <a:extLst>
                    <a:ext uri="{9D8B030D-6E8A-4147-A177-3AD203B41FA5}">
                      <a16:colId xmlns:a16="http://schemas.microsoft.com/office/drawing/2014/main" xmlns="" val="889255114"/>
                    </a:ext>
                  </a:extLst>
                </a:gridCol>
                <a:gridCol w="6035638">
                  <a:extLst>
                    <a:ext uri="{9D8B030D-6E8A-4147-A177-3AD203B41FA5}">
                      <a16:colId xmlns:a16="http://schemas.microsoft.com/office/drawing/2014/main" xmlns="" val="1616738554"/>
                    </a:ext>
                  </a:extLst>
                </a:gridCol>
                <a:gridCol w="3544239">
                  <a:extLst>
                    <a:ext uri="{9D8B030D-6E8A-4147-A177-3AD203B41FA5}">
                      <a16:colId xmlns:a16="http://schemas.microsoft.com/office/drawing/2014/main" xmlns="" val="156932148"/>
                    </a:ext>
                  </a:extLst>
                </a:gridCol>
              </a:tblGrid>
              <a:tr h="254378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rimers </a:t>
                      </a:r>
                    </a:p>
                  </a:txBody>
                  <a:tcPr marL="68580" marR="6858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quence (5'-3')</a:t>
                      </a:r>
                    </a:p>
                  </a:txBody>
                  <a:tcPr marL="68580" marR="6858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Notes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</a:p>
                  </a:txBody>
                  <a:tcPr marL="68580" marR="6858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893529670"/>
                  </a:ext>
                </a:extLst>
              </a:tr>
              <a:tr h="375143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pB-F1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TT </a:t>
                      </a:r>
                      <a:r>
                        <a:rPr lang="en-US" sz="10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TT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 </a:t>
                      </a:r>
                      <a:r>
                        <a:rPr lang="en-US" sz="10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A TCC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ATA AAC AAA TTC CTA GAC AAT CAG CAT G</a:t>
                      </a:r>
                      <a:r>
                        <a:rPr lang="en-US" sz="1000" u="sng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 TCA </a:t>
                      </a:r>
                      <a:r>
                        <a:rPr lang="en-US" sz="1000" u="sng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CA</a:t>
                      </a:r>
                      <a:r>
                        <a:rPr lang="en-US" sz="1000" u="sng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00" u="sng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CA</a:t>
                      </a:r>
                      <a:r>
                        <a:rPr lang="en-US" sz="1000" u="sng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00" u="sng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CA</a:t>
                      </a:r>
                      <a:r>
                        <a:rPr lang="en-US" sz="1000" u="sng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00" u="sng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CA</a:t>
                      </a:r>
                      <a:r>
                        <a:rPr lang="en-US" sz="1000" u="sng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T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T AGC CGT AAA AG 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i="1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m</a:t>
                      </a:r>
                      <a:r>
                        <a:rPr lang="en-US" sz="1000" i="0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</a:t>
                      </a:r>
                      <a:r>
                        <a:rPr lang="en-US" altLang="zh-CN" sz="1000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en-US" altLang="zh-CN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 boldface, and </a:t>
                      </a:r>
                      <a:r>
                        <a:rPr lang="en-US" altLang="zh-CN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</a:t>
                      </a:r>
                      <a:r>
                        <a:rPr lang="en-US" sz="10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uence </a:t>
                      </a:r>
                      <a:r>
                        <a:rPr lang="en-US" sz="10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coding his</a:t>
                      </a:r>
                      <a:r>
                        <a:rPr lang="en-US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r>
                        <a:rPr lang="en-US" sz="10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tag is underlined</a:t>
                      </a:r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519841300"/>
                  </a:ext>
                </a:extLst>
              </a:tr>
              <a:tr h="375143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pB-R1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u="none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TT </a:t>
                      </a:r>
                      <a:r>
                        <a:rPr lang="en-US" sz="1000" u="none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TT</a:t>
                      </a:r>
                      <a:r>
                        <a:rPr lang="en-US" sz="1000" u="none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00" b="1" u="none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AA TTC</a:t>
                      </a:r>
                      <a:r>
                        <a:rPr lang="en-US" sz="1000" u="none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TTA ACC CTC TTT GAG CTT GGC AC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co</a:t>
                      </a:r>
                      <a:r>
                        <a:rPr lang="en-US" sz="1000" i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  <a:r>
                        <a:rPr lang="en-US" altLang="zh-CN" sz="1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boldface</a:t>
                      </a:r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3610595579"/>
                  </a:ext>
                </a:extLst>
              </a:tr>
              <a:tr h="375143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pH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F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u="none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TT </a:t>
                      </a:r>
                      <a:r>
                        <a:rPr lang="en-US" sz="1000" u="none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TT</a:t>
                      </a:r>
                      <a:r>
                        <a:rPr lang="en-US" sz="1000" u="none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00" b="1" u="none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A TCC</a:t>
                      </a:r>
                      <a:r>
                        <a:rPr lang="en-US" sz="1000" u="none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ATG </a:t>
                      </a:r>
                      <a:r>
                        <a:rPr lang="en-US" sz="1000" u="sng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GG AGC CAC CCG CAG TTC GAA AAA</a:t>
                      </a:r>
                      <a:r>
                        <a:rPr lang="en-US" sz="1000" u="none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GAT TCT ACC G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i="1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m</a:t>
                      </a:r>
                      <a:r>
                        <a:rPr lang="en-US" sz="1000" i="0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</a:t>
                      </a:r>
                      <a:r>
                        <a:rPr lang="en-US" altLang="zh-CN" sz="1000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en-US" altLang="zh-CN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 boldface, and s</a:t>
                      </a:r>
                      <a:r>
                        <a:rPr lang="en-US" sz="10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quence encoding strep-tag is underlined</a:t>
                      </a:r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782726060"/>
                  </a:ext>
                </a:extLst>
              </a:tr>
              <a:tr h="375143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pH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R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A </a:t>
                      </a:r>
                      <a:r>
                        <a:rPr lang="en-US" sz="10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A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AA TTC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TTA CGC AAA GGG GTT GGC GAA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co</a:t>
                      </a:r>
                      <a:r>
                        <a:rPr lang="en-US" sz="1000" i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  <a:r>
                        <a:rPr lang="en-US" altLang="zh-CN" sz="1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boldface</a:t>
                      </a:r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293500358"/>
                  </a:ext>
                </a:extLst>
              </a:tr>
              <a:tr h="375143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pA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F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u="none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A </a:t>
                      </a:r>
                      <a:r>
                        <a:rPr lang="en-US" sz="1000" u="none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A</a:t>
                      </a:r>
                      <a:r>
                        <a:rPr lang="en-US" sz="1000" u="none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00" b="1" u="none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T CTC </a:t>
                      </a:r>
                      <a:r>
                        <a:rPr lang="en-US" sz="1000" u="none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A TGG TAA GCA TTA GAC CCG A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sa</a:t>
                      </a:r>
                      <a:r>
                        <a:rPr lang="en-US" altLang="zh-CN" sz="1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boldface</a:t>
                      </a:r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44884581"/>
                  </a:ext>
                </a:extLst>
              </a:tr>
              <a:tr h="375143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pA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R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A </a:t>
                      </a:r>
                      <a:r>
                        <a:rPr lang="en-US" sz="10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A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T CTC 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GC GCT GGC </a:t>
                      </a:r>
                      <a:r>
                        <a:rPr lang="en-US" sz="10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C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AAA ACC TTG G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sa</a:t>
                      </a:r>
                      <a:r>
                        <a:rPr lang="en-US" altLang="zh-CN" sz="1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boldface</a:t>
                      </a:r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44650799"/>
                  </a:ext>
                </a:extLst>
              </a:tr>
              <a:tr h="375143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pB-F2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A </a:t>
                      </a:r>
                      <a:r>
                        <a:rPr lang="en-US" sz="10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A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T CTC 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A TGG TAG CCG TAA AAG </a:t>
                      </a:r>
                      <a:r>
                        <a:rPr lang="en-US" sz="10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G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CAA C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sa</a:t>
                      </a:r>
                      <a:r>
                        <a:rPr lang="en-US" altLang="zh-CN" sz="1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boldface</a:t>
                      </a:r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709605962"/>
                  </a:ext>
                </a:extLst>
              </a:tr>
              <a:tr h="375143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pB-R2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A </a:t>
                      </a:r>
                      <a:r>
                        <a:rPr lang="en-US" sz="10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A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T CTC 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GC GCT ACC CTC TTT GAG CTT GGC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sa</a:t>
                      </a:r>
                      <a:r>
                        <a:rPr lang="en-US" altLang="zh-CN" sz="1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boldface</a:t>
                      </a:r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344187706"/>
                  </a:ext>
                </a:extLst>
              </a:tr>
              <a:tr h="375143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pC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F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A </a:t>
                      </a:r>
                      <a:r>
                        <a:rPr lang="en-US" sz="10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A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AA TTC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ATG CCT AAC CTT AAA GCG ATT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co</a:t>
                      </a:r>
                      <a:r>
                        <a:rPr lang="en-US" sz="1000" i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  <a:r>
                        <a:rPr lang="en-US" altLang="zh-CN" sz="1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boldface</a:t>
                      </a:r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408530301"/>
                  </a:ext>
                </a:extLst>
              </a:tr>
              <a:tr h="375143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pC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R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A </a:t>
                      </a:r>
                      <a:r>
                        <a:rPr lang="en-US" sz="10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A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TC GAG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TTA GAG GGA ATT AGC CCC TGC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ho</a:t>
                      </a:r>
                      <a:r>
                        <a:rPr lang="en-US" altLang="zh-CN" sz="1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boldface</a:t>
                      </a:r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3969157926"/>
                  </a:ext>
                </a:extLst>
              </a:tr>
              <a:tr h="375143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pD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F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A </a:t>
                      </a:r>
                      <a:r>
                        <a:rPr lang="en-US" sz="10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A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T CTC 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A TGA AAG GTT CCT TAT ACA GT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sa</a:t>
                      </a:r>
                      <a:r>
                        <a:rPr lang="en-US" altLang="zh-CN" sz="1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boldface</a:t>
                      </a:r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307980431"/>
                  </a:ext>
                </a:extLst>
              </a:tr>
              <a:tr h="375143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pD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R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A </a:t>
                      </a:r>
                      <a:r>
                        <a:rPr lang="en-US" sz="10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A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T CTC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CGC GCT GAG GGC GGT CCC AAG AC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sa</a:t>
                      </a:r>
                      <a:r>
                        <a:rPr lang="en-US" altLang="zh-CN" sz="1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boldface</a:t>
                      </a:r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637523745"/>
                  </a:ext>
                </a:extLst>
              </a:tr>
              <a:tr h="375143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pE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F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A </a:t>
                      </a:r>
                      <a:r>
                        <a:rPr lang="en-US" sz="10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A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T CTC 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A TGA CGT TAA CAG TAC GGG TAA TC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sa</a:t>
                      </a:r>
                      <a:r>
                        <a:rPr lang="en-US" altLang="zh-CN" sz="1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boldface</a:t>
                      </a:r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525937775"/>
                  </a:ext>
                </a:extLst>
              </a:tr>
              <a:tr h="375143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pE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R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A </a:t>
                      </a:r>
                      <a:r>
                        <a:rPr lang="en-US" sz="10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A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T CTC 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GC GCT GAC GGC TCC ACC GGC CGC TTG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sa</a:t>
                      </a:r>
                      <a:r>
                        <a:rPr lang="en-US" altLang="zh-CN" sz="1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boldface</a:t>
                      </a:r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373580186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24728999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4" name="차트 2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94893212"/>
              </p:ext>
            </p:extLst>
          </p:nvPr>
        </p:nvGraphicFramePr>
        <p:xfrm>
          <a:off x="4145214" y="1224768"/>
          <a:ext cx="3401906" cy="28572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6245312" y="2569596"/>
            <a:ext cx="242245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r>
              <a:rPr lang="en-US" sz="1200" i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51.0 ± 2.6 µM</a:t>
            </a:r>
          </a:p>
          <a:p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r>
              <a:rPr lang="en-US" sz="120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x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18.1 ± 0.9 µmole min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g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r>
              <a:rPr lang="en-US" sz="1200" i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59.5 ± 4.1 s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−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5606446" y="3725169"/>
            <a:ext cx="12266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/NADPH (µM)</a:t>
            </a:r>
          </a:p>
        </p:txBody>
      </p:sp>
      <p:sp>
        <p:nvSpPr>
          <p:cNvPr id="38" name="직사각형 37"/>
          <p:cNvSpPr/>
          <p:nvPr/>
        </p:nvSpPr>
        <p:spPr>
          <a:xfrm rot="16200000">
            <a:off x="3738943" y="2304725"/>
            <a:ext cx="168828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/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r>
              <a:rPr lang="en-US" sz="1200" b="1" i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µmole</a:t>
            </a:r>
            <a:r>
              <a:rPr lang="en-US" sz="12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n</a:t>
            </a:r>
            <a:r>
              <a:rPr lang="en-US" sz="12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g</a:t>
            </a:r>
            <a:r>
              <a:rPr lang="en-US" sz="12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20" name="직사각형 19"/>
          <p:cNvSpPr/>
          <p:nvPr/>
        </p:nvSpPr>
        <p:spPr>
          <a:xfrm>
            <a:off x="121435" y="5669501"/>
            <a:ext cx="11822176" cy="56977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sz="11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. S16. </a:t>
            </a:r>
            <a:r>
              <a:rPr lang="en-US" altLang="ko-KR" sz="1100" b="1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Lineweaver</a:t>
            </a:r>
            <a:r>
              <a:rPr lang="en-US" altLang="ko-KR" sz="11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Burk plot (</a:t>
            </a:r>
            <a:r>
              <a:rPr lang="en-US" altLang="ko-KR" sz="1100" b="1" i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v</a:t>
            </a:r>
            <a:r>
              <a:rPr lang="en-US" altLang="ko-KR" sz="1100" b="1" i="1" baseline="-25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o</a:t>
            </a:r>
            <a:r>
              <a:rPr lang="en-US" altLang="ko-KR" sz="1100" b="1" baseline="30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1</a:t>
            </a:r>
            <a:r>
              <a:rPr lang="en-US" altLang="ko-KR" sz="11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ko-KR" sz="1100" b="1" i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vs.</a:t>
            </a:r>
            <a:r>
              <a:rPr lang="en-US" altLang="ko-KR" sz="11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[NADPH]</a:t>
            </a:r>
            <a:r>
              <a:rPr lang="en-US" altLang="ko-KR" sz="1100" b="1" baseline="30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1</a:t>
            </a:r>
            <a:r>
              <a:rPr lang="en-US" altLang="ko-KR" sz="11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 illustrating the kinetic parameters of </a:t>
            </a:r>
            <a:r>
              <a:rPr lang="en-US" altLang="ko-KR" sz="1100" b="1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Nox</a:t>
            </a:r>
            <a:r>
              <a:rPr lang="en-US" altLang="ko-KR" sz="1100" b="1" baseline="300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</a:t>
            </a:r>
            <a:r>
              <a:rPr lang="en-US" altLang="ko-KR" sz="11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utations of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178R and L179R [34] were introduced into </a:t>
            </a:r>
            <a:r>
              <a:rPr lang="en-US" altLang="ko-K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ox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 form </a:t>
            </a:r>
            <a:r>
              <a:rPr lang="en-US" altLang="ko-K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ox</a:t>
            </a:r>
            <a:r>
              <a:rPr lang="en-US" altLang="ko-KR" sz="11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see Materials and Methods). </a:t>
            </a:r>
            <a:endParaRPr lang="en-US" sz="11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56913646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차트 6"/>
          <p:cNvGraphicFramePr>
            <a:graphicFrameLocks/>
          </p:cNvGraphicFramePr>
          <p:nvPr/>
        </p:nvGraphicFramePr>
        <p:xfrm>
          <a:off x="4724200" y="1307592"/>
          <a:ext cx="3278900" cy="30906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직사각형 3"/>
          <p:cNvSpPr/>
          <p:nvPr/>
        </p:nvSpPr>
        <p:spPr>
          <a:xfrm>
            <a:off x="100584" y="4981820"/>
            <a:ext cx="11822176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sz="11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. S17. General ROS generated from b-</a:t>
            </a:r>
            <a:r>
              <a:rPr lang="en-US" sz="1100" b="1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TMe</a:t>
            </a:r>
            <a:r>
              <a:rPr lang="en-US" sz="11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t 30℃ in light in the presence of SOD and catalase</a:t>
            </a:r>
            <a:r>
              <a:rPr lang="en-US" sz="1100" b="1" dirty="0"/>
              <a:t>. </a:t>
            </a:r>
            <a:r>
              <a:rPr lang="en-US" sz="1100" dirty="0"/>
              <a:t>b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</a:t>
            </a:r>
            <a:r>
              <a:rPr lang="en-US" altLang="ko-KR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TMe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(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5 µg </a:t>
            </a:r>
            <a:r>
              <a:rPr lang="en-US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hl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100" i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ml</a:t>
            </a:r>
            <a:r>
              <a:rPr lang="en-US" sz="1100" baseline="30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1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 was mixed with TM-NADP</a:t>
            </a:r>
            <a:r>
              <a:rPr lang="en-US" sz="1100" baseline="30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buffer and incubated at 30℃ for 2 h under 50 </a:t>
            </a:r>
            <a:r>
              <a:rPr lang="en-US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μmol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m</a:t>
            </a:r>
            <a:r>
              <a:rPr lang="en-US" sz="1100" baseline="30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2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s</a:t>
            </a:r>
            <a:r>
              <a:rPr lang="en-US" sz="1100" baseline="30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1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white light. Aliquot (0.2 ml) was withdrawn and lysed by vigorous </a:t>
            </a:r>
            <a:r>
              <a:rPr lang="en-US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vortexing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with 4 µl chloroform. Subsequently, 0.1 </a:t>
            </a:r>
            <a:r>
              <a:rPr lang="en-US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M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H</a:t>
            </a:r>
            <a:r>
              <a:rPr lang="en-US" sz="1100" baseline="-25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DCFDA and 32 µg </a:t>
            </a:r>
            <a:r>
              <a:rPr lang="en-US" sz="1100" i="1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ynechocystis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10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L</a:t>
            </a:r>
            <a:r>
              <a:rPr lang="en-US" altLang="ko-KR" sz="110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were added to the mixture, followed by incubation 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t 30℃ for 10 </a:t>
            </a:r>
            <a:r>
              <a:rPr lang="en-US" altLang="ko-KR" sz="110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in. 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luorescence was detected at 525 nm after excitation at 488 nm. Reaction without bovine SOD and catalase (</a:t>
            </a:r>
            <a:r>
              <a:rPr lang="en-US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KatE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 were regarded as control </a:t>
            </a:r>
            <a:r>
              <a:rPr lang="en-US" sz="110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None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. S, bovine </a:t>
            </a:r>
            <a:r>
              <a:rPr lang="en-US" sz="110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OD: 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S (50 U ml</a:t>
            </a:r>
            <a:r>
              <a:rPr lang="en-US" sz="1100" baseline="30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1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; 2S, (100 U ml</a:t>
            </a:r>
            <a:r>
              <a:rPr lang="en-US" sz="1100" baseline="30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1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. C, catalase (</a:t>
            </a:r>
            <a:r>
              <a:rPr lang="en-US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KatE</a:t>
            </a:r>
            <a:r>
              <a:rPr lang="en-US" sz="110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: 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C (37.5 µg ml</a:t>
            </a:r>
            <a:r>
              <a:rPr lang="en-US" sz="1100" baseline="30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1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; 2C (75 µg ml</a:t>
            </a:r>
            <a:r>
              <a:rPr lang="en-US" sz="1100" baseline="30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1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.</a:t>
            </a:r>
          </a:p>
        </p:txBody>
      </p:sp>
      <p:sp>
        <p:nvSpPr>
          <p:cNvPr id="6" name="TextBox 5"/>
          <p:cNvSpPr txBox="1"/>
          <p:nvPr/>
        </p:nvSpPr>
        <p:spPr>
          <a:xfrm rot="16200000">
            <a:off x="3528937" y="2630933"/>
            <a:ext cx="21295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uorescence intensity (x 10</a:t>
            </a:r>
            <a:r>
              <a:rPr lang="en-US" sz="12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28884150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표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86516649"/>
              </p:ext>
            </p:extLst>
          </p:nvPr>
        </p:nvGraphicFramePr>
        <p:xfrm>
          <a:off x="941832" y="369824"/>
          <a:ext cx="10533888" cy="59588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996696">
                  <a:extLst>
                    <a:ext uri="{9D8B030D-6E8A-4147-A177-3AD203B41FA5}">
                      <a16:colId xmlns:a16="http://schemas.microsoft.com/office/drawing/2014/main" xmlns="" val="889255114"/>
                    </a:ext>
                  </a:extLst>
                </a:gridCol>
                <a:gridCol w="6025896">
                  <a:extLst>
                    <a:ext uri="{9D8B030D-6E8A-4147-A177-3AD203B41FA5}">
                      <a16:colId xmlns:a16="http://schemas.microsoft.com/office/drawing/2014/main" xmlns="" val="1616738554"/>
                    </a:ext>
                  </a:extLst>
                </a:gridCol>
                <a:gridCol w="3511296">
                  <a:extLst>
                    <a:ext uri="{9D8B030D-6E8A-4147-A177-3AD203B41FA5}">
                      <a16:colId xmlns:a16="http://schemas.microsoft.com/office/drawing/2014/main" xmlns="" val="156932148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NR-F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b="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A </a:t>
                      </a:r>
                      <a:r>
                        <a:rPr lang="en-US" sz="1000" b="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A</a:t>
                      </a:r>
                      <a:r>
                        <a:rPr lang="en-US" sz="1000" b="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A TCC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ATG TAC AGT CCC GGT TAC GTA </a:t>
                      </a:r>
                      <a:endParaRPr lang="en-US" sz="1000" b="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m</a:t>
                      </a:r>
                      <a:r>
                        <a:rPr lang="en-US" altLang="zh-CN" sz="1000" i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</a:t>
                      </a:r>
                      <a:r>
                        <a:rPr lang="en-US" altLang="zh-CN" sz="1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boldface</a:t>
                      </a:r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9970929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NR-R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u="none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A </a:t>
                      </a:r>
                      <a:r>
                        <a:rPr lang="en-US" sz="1000" u="none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A</a:t>
                      </a:r>
                      <a:r>
                        <a:rPr lang="en-US" sz="1000" u="none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00" b="1" u="none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TG CAG</a:t>
                      </a:r>
                      <a:r>
                        <a:rPr lang="en-US" sz="1000" u="none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TA GTA GGT TTC CAC GTG CCA GC </a:t>
                      </a:r>
                      <a:endParaRPr lang="en-US" sz="1000" u="none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t</a:t>
                      </a:r>
                      <a:r>
                        <a:rPr lang="en-US" altLang="zh-CN" sz="1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boldface</a:t>
                      </a:r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41713728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d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F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  <a:defRPr/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A </a:t>
                      </a:r>
                      <a:r>
                        <a:rPr lang="en-US" sz="10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A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AA TTC </a:t>
                      </a:r>
                      <a:r>
                        <a:rPr lang="en-US" sz="1000" b="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G GCA TCC TAT ACC GTT AA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co</a:t>
                      </a:r>
                      <a:r>
                        <a:rPr lang="en-US" sz="1000" i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  <a:r>
                        <a:rPr lang="en-US" altLang="zh-CN" sz="1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boldface </a:t>
                      </a:r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3152539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d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R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  <a:defRPr/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A </a:t>
                      </a:r>
                      <a:r>
                        <a:rPr lang="en-US" sz="10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A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TG CAG </a:t>
                      </a:r>
                      <a:r>
                        <a:rPr lang="en-US" sz="1000" u="none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TA GTA GAG GTC TTC </a:t>
                      </a:r>
                      <a:r>
                        <a:rPr lang="en-US" sz="1000" u="none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TC</a:t>
                      </a:r>
                      <a:r>
                        <a:rPr lang="en-US" sz="1000" u="none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TTT G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t</a:t>
                      </a:r>
                      <a:r>
                        <a:rPr lang="en-US" altLang="zh-CN" sz="1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boldface</a:t>
                      </a:r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59720983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pcA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F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A </a:t>
                      </a:r>
                      <a:r>
                        <a:rPr lang="en-US" sz="10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A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A TCC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ATG AGT ATC GTC ACG AAA TCA ATC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0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m</a:t>
                      </a:r>
                      <a:r>
                        <a:rPr lang="en-US" altLang="zh-CN" sz="1000" i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</a:t>
                      </a:r>
                      <a:r>
                        <a:rPr lang="en-US" altLang="zh-CN" sz="1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boldface</a:t>
                      </a:r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3803088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pcA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R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A </a:t>
                      </a:r>
                      <a:r>
                        <a:rPr lang="en-US" sz="10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A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TG CAG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CTA GCT CAT TTT TCC GAT AAC GAA G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t</a:t>
                      </a:r>
                      <a:r>
                        <a:rPr lang="en-US" altLang="zh-CN" sz="1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boldface</a:t>
                      </a:r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408772477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pcA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F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A </a:t>
                      </a:r>
                      <a:r>
                        <a:rPr lang="en-US" sz="10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A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A TCC 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G AAA ACC CCT TTA ACT GAA GCC GT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0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m</a:t>
                      </a:r>
                      <a:r>
                        <a:rPr lang="en-US" altLang="zh-CN" sz="1000" i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</a:t>
                      </a:r>
                      <a:r>
                        <a:rPr lang="en-US" altLang="zh-CN" sz="1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boldface</a:t>
                      </a:r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04150805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pcA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R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A </a:t>
                      </a:r>
                      <a:r>
                        <a:rPr lang="en-US" sz="10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A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TG CAG 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TA GCT CAG AGC ATT GAT GGC GTA A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t</a:t>
                      </a:r>
                      <a:r>
                        <a:rPr lang="en-US" altLang="zh-CN" sz="1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boldface</a:t>
                      </a:r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427293910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US" altLang="ko-KR" sz="10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x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F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A </a:t>
                      </a:r>
                      <a:r>
                        <a:rPr lang="en-US" sz="10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A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A TCC 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G AAA GTT ATT GTA ATT GGT TG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0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m</a:t>
                      </a:r>
                      <a:r>
                        <a:rPr lang="en-US" altLang="zh-CN" sz="1000" i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</a:t>
                      </a:r>
                      <a:r>
                        <a:rPr lang="en-US" altLang="zh-CN" sz="1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boldface</a:t>
                      </a:r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421795605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just" defTabSz="9144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  <a:defRPr/>
                      </a:pPr>
                      <a:r>
                        <a:rPr lang="en-US" sz="10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US" altLang="ko-KR" sz="10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x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R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A </a:t>
                      </a:r>
                      <a:r>
                        <a:rPr lang="en-US" sz="10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A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TG CAG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TTA TTC AGT GAC AGC TTC GGC CGC A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t</a:t>
                      </a:r>
                      <a:r>
                        <a:rPr lang="en-US" altLang="zh-CN" sz="1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boldface</a:t>
                      </a:r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376188612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US" altLang="ko-KR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x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78-F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A AGT CAC ACT AAT TGA TCG GTT ACC ACG GAT TTT AAA TAA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401097690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just" defTabSz="9144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  <a:defRPr/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US" altLang="ko-KR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x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78-R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TA TTT AAA ATC CGT GGT AAC CGA TCA ATT AGT GTG ACT TCC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75765766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US" altLang="ko-KR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x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78179-F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AA GGA AGT CAC ACT AAT TGA TCG GCG GCC ACG GAT TTT AAA TAA ATA CTT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8636572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just" defTabSz="9144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  <a:defRPr/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US" altLang="ko-KR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x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78179-R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G TAT TTA TTT AAA ATC CGT GGC CGC CGA TCA ATT AGT GTG ACT TCC TTA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46805937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KatE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F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A </a:t>
                      </a:r>
                      <a:r>
                        <a:rPr lang="en-US" sz="10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A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A TCC 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G CAT ATG TCA AAA AGC TTT T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0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m</a:t>
                      </a:r>
                      <a:r>
                        <a:rPr lang="en-US" altLang="zh-CN" sz="1000" b="0" i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</a:t>
                      </a:r>
                      <a:r>
                        <a:rPr lang="en-US" altLang="zh-CN" sz="1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boldface</a:t>
                      </a:r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83954592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KatE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R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tabLst>
                          <a:tab pos="508000" algn="l"/>
                          <a:tab pos="1016000" algn="l"/>
                          <a:tab pos="1524000" algn="l"/>
                          <a:tab pos="2032000" algn="l"/>
                          <a:tab pos="2540000" algn="l"/>
                          <a:tab pos="3048000" algn="l"/>
                          <a:tab pos="3556000" algn="l"/>
                          <a:tab pos="4064000" algn="l"/>
                          <a:tab pos="4572000" algn="l"/>
                          <a:tab pos="5080000" algn="l"/>
                          <a:tab pos="5588000" algn="l"/>
                          <a:tab pos="6096000" algn="l"/>
                          <a:tab pos="6604000" algn="l"/>
                          <a:tab pos="7112000" algn="l"/>
                          <a:tab pos="7620000" algn="l"/>
                          <a:tab pos="8128000" algn="l"/>
                          <a:tab pos="8636000" algn="l"/>
                          <a:tab pos="9144000" algn="l"/>
                          <a:tab pos="9652000" algn="l"/>
                          <a:tab pos="10160000" algn="l"/>
                          <a:tab pos="10668000" algn="l"/>
                          <a:tab pos="11176000" algn="l"/>
                          <a:tab pos="11684000" algn="l"/>
                          <a:tab pos="12192000" algn="l"/>
                          <a:tab pos="12700000" algn="l"/>
                          <a:tab pos="13208000" algn="l"/>
                          <a:tab pos="13716000" algn="l"/>
                          <a:tab pos="14224000" algn="l"/>
                          <a:tab pos="14732000" algn="l"/>
                          <a:tab pos="15240000" algn="l"/>
                          <a:tab pos="15748000" algn="l"/>
                        </a:tabLs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A </a:t>
                      </a:r>
                      <a:r>
                        <a:rPr lang="en-US" sz="10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A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TG CAG 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T CGA AGC CAG TTT AGT GAC T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t</a:t>
                      </a:r>
                      <a:r>
                        <a:rPr lang="en-US" altLang="zh-CN" sz="1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boldface</a:t>
                      </a:r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382433757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26916919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6" name="차트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97495024"/>
              </p:ext>
            </p:extLst>
          </p:nvPr>
        </p:nvGraphicFramePr>
        <p:xfrm>
          <a:off x="2761488" y="1630756"/>
          <a:ext cx="3090672" cy="31332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3788041" y="4338751"/>
            <a:ext cx="13724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</a:t>
            </a:r>
            <a:r>
              <a:rPr lang="en-US" altLang="zh-CN" sz="12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his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µg </a:t>
            </a:r>
            <a:r>
              <a:rPr lang="en-US" sz="12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hl </a:t>
            </a:r>
            <a:r>
              <a:rPr lang="en-US" sz="1200" b="1" i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 rot="16200000">
            <a:off x="1798020" y="2744847"/>
            <a:ext cx="18405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</a:t>
            </a:r>
            <a:r>
              <a:rPr lang="en-US" altLang="zh-CN" sz="12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his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ound (µg </a:t>
            </a:r>
            <a:r>
              <a:rPr lang="en-US" sz="12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hl </a:t>
            </a:r>
            <a:r>
              <a:rPr lang="en-US" sz="1200" b="1" i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568947" y="3259194"/>
            <a:ext cx="13658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i-NTA resin (µl) </a:t>
            </a:r>
          </a:p>
        </p:txBody>
      </p:sp>
      <p:graphicFrame>
        <p:nvGraphicFramePr>
          <p:cNvPr id="9" name="차트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80347437"/>
              </p:ext>
            </p:extLst>
          </p:nvPr>
        </p:nvGraphicFramePr>
        <p:xfrm>
          <a:off x="6756355" y="1630757"/>
          <a:ext cx="3350547" cy="294285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7661047" y="4338013"/>
            <a:ext cx="14299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M</a:t>
            </a:r>
            <a:r>
              <a:rPr lang="en-US" altLang="zh-CN" sz="1200" b="1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zh-CN" sz="12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strep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µg </a:t>
            </a:r>
            <a:r>
              <a:rPr lang="en-US" sz="1200" b="1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hl</a:t>
            </a:r>
            <a:r>
              <a:rPr lang="en-US" sz="12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200" b="1" i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 rot="16200000">
            <a:off x="5647247" y="2758175"/>
            <a:ext cx="19236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M</a:t>
            </a:r>
            <a:r>
              <a:rPr lang="en-US" altLang="zh-CN" sz="1200" b="1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zh-CN" sz="12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strep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ound (µg </a:t>
            </a:r>
            <a:r>
              <a:rPr lang="en-US" sz="1200" b="1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hl</a:t>
            </a:r>
            <a:r>
              <a:rPr lang="en-US" sz="12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200" b="1" i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8426583" y="3259193"/>
            <a:ext cx="16747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eptavidin resin (µl) 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2284528" y="143575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6069332" y="1431610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3" name="직사각형 2"/>
          <p:cNvSpPr/>
          <p:nvPr/>
        </p:nvSpPr>
        <p:spPr>
          <a:xfrm>
            <a:off x="222827" y="5207195"/>
            <a:ext cx="11424014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sz="11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. S1. Determination of binding capacity of Ni-NTA and streptavidin resins for TM</a:t>
            </a:r>
            <a:r>
              <a:rPr lang="en-US" sz="1100" b="1" baseline="-25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β-his</a:t>
            </a:r>
            <a:r>
              <a:rPr lang="en-US" sz="11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nd </a:t>
            </a:r>
            <a:r>
              <a:rPr lang="en-US" sz="1100" b="1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M</a:t>
            </a:r>
            <a:r>
              <a:rPr lang="en-US" sz="1100" b="1" baseline="-250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US" sz="1100" b="1" baseline="-25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strep</a:t>
            </a:r>
            <a:r>
              <a:rPr lang="en-US" sz="11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M</a:t>
            </a:r>
            <a:r>
              <a:rPr lang="en-US" sz="1100" baseline="-25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β-his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nd </a:t>
            </a:r>
            <a:r>
              <a:rPr lang="en-US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M</a:t>
            </a:r>
            <a:r>
              <a:rPr lang="en-US" sz="1100" baseline="-250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US" sz="1100" baseline="-25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strep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were incubated with varying amounts of Ni-NTA resin (A) and  streptavidin resin (B), respectively. Free TM</a:t>
            </a:r>
            <a:r>
              <a:rPr lang="en-US" sz="1100" baseline="-25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β-his 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nd </a:t>
            </a:r>
            <a:r>
              <a:rPr lang="en-US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M</a:t>
            </a:r>
            <a:r>
              <a:rPr lang="en-US" sz="1100" baseline="-250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US" sz="1100" baseline="-25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strep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were removed through washing with TM buffer three times. </a:t>
            </a:r>
            <a:r>
              <a:rPr lang="en-US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hl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100" i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contents of TM</a:t>
            </a:r>
            <a:r>
              <a:rPr lang="en-US" sz="1100" baseline="-25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β-his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nd </a:t>
            </a:r>
            <a:r>
              <a:rPr lang="en-US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M</a:t>
            </a:r>
            <a:r>
              <a:rPr lang="en-US" sz="1100" baseline="-250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US" sz="1100" baseline="-25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strep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bound to resins were detected at OD</a:t>
            </a:r>
            <a:r>
              <a:rPr lang="en-US" sz="1100" baseline="-25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660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fter extraction with acetone/methanol (7/2, v/v) and calculated with an</a:t>
            </a:r>
            <a:r>
              <a:rPr lang="zh-CN" alt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extinction coefficient of ε</a:t>
            </a:r>
            <a:r>
              <a:rPr lang="en-US" sz="1100" baseline="-25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660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= 77.1 mM</a:t>
            </a:r>
            <a:r>
              <a:rPr lang="en-US" sz="1100" baseline="30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1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cm</a:t>
            </a:r>
            <a:r>
              <a:rPr lang="en-US" sz="1100" baseline="30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1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 The b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ing capacity of T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</a:t>
            </a:r>
            <a:r>
              <a:rPr lang="en-US" sz="1100" baseline="-25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β-his 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o Ni-NTA resin (A) and </a:t>
            </a:r>
            <a:r>
              <a:rPr lang="en-US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M</a:t>
            </a:r>
            <a:r>
              <a:rPr lang="en-US" sz="1100" baseline="-250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US" sz="1100" baseline="-25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strep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to streptavidin resin (B) were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.4 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µg </a:t>
            </a:r>
            <a:r>
              <a:rPr lang="en-US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hl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100" i="1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altLang="zh-CN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2 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µg 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hl </a:t>
            </a:r>
            <a:r>
              <a:rPr lang="en-US" sz="1100" i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er ml resins, respectively.</a:t>
            </a:r>
            <a:endParaRPr lang="en-US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1693047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442917" y="1224920"/>
            <a:ext cx="2702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6062347" y="1224920"/>
            <a:ext cx="30596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ko-KR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차트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32422792"/>
              </p:ext>
            </p:extLst>
          </p:nvPr>
        </p:nvGraphicFramePr>
        <p:xfrm>
          <a:off x="6203577" y="1453323"/>
          <a:ext cx="3562216" cy="30063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0" name="차트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21924906"/>
              </p:ext>
            </p:extLst>
          </p:nvPr>
        </p:nvGraphicFramePr>
        <p:xfrm>
          <a:off x="2508364" y="1453323"/>
          <a:ext cx="3416948" cy="33381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직사각형 1"/>
          <p:cNvSpPr/>
          <p:nvPr/>
        </p:nvSpPr>
        <p:spPr>
          <a:xfrm>
            <a:off x="183583" y="5335570"/>
            <a:ext cx="11483457" cy="136191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sz="11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. S2. NADPH and ATP generation activities of TM in light and dark. 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M (5 </a:t>
            </a:r>
            <a:r>
              <a:rPr lang="el-G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g </a:t>
            </a:r>
            <a:r>
              <a:rPr lang="en-US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hl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100" i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ml</a:t>
            </a:r>
            <a:r>
              <a:rPr lang="en-US" sz="1100" baseline="30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1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 was examined for generation of NADPH and ATP in TM buffer supplemented with </a:t>
            </a:r>
            <a:r>
              <a:rPr lang="el-G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 μ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 FNR, 5 </a:t>
            </a:r>
            <a:r>
              <a:rPr lang="el-G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 </a:t>
            </a:r>
            <a:r>
              <a:rPr lang="en-US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d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2 </a:t>
            </a:r>
            <a:r>
              <a:rPr lang="en-US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M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NADP</a:t>
            </a:r>
            <a:r>
              <a:rPr lang="en-US" sz="1100" baseline="3000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sz="110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and 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2 </a:t>
            </a:r>
            <a:r>
              <a:rPr lang="en-US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M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DP. Reaction mixtures were incubated at 30℃ under white light (5</a:t>
            </a:r>
            <a:r>
              <a:rPr lang="el-G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0 μ</a:t>
            </a:r>
            <a:r>
              <a:rPr lang="en-US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ol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m</a:t>
            </a:r>
            <a:r>
              <a:rPr lang="en-US" sz="1100" baseline="30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−2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 s</a:t>
            </a:r>
            <a:r>
              <a:rPr lang="en-US" sz="1100" baseline="30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−1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 or in </a:t>
            </a:r>
            <a:r>
              <a:rPr lang="en-US" sz="110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he dark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 Aliquots were taken at 30-min intervals. (A) NADPH was detected </a:t>
            </a:r>
            <a:r>
              <a:rPr lang="en-US" sz="110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rom the time-course changes in absorbance at 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340 nm and calculated with an</a:t>
            </a:r>
            <a:r>
              <a:rPr lang="zh-CN" alt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extinction coefficient of 6.22 mM</a:t>
            </a:r>
            <a:r>
              <a:rPr lang="en-US" sz="1100" baseline="30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1 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m</a:t>
            </a:r>
            <a:r>
              <a:rPr lang="en-US" sz="1100" baseline="30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1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 (B) ATP was quantified with ATP assay kit</a:t>
            </a:r>
            <a:r>
              <a:rPr lang="en-US" sz="110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100" dirty="0">
                <a:solidFill>
                  <a:srgbClr val="3333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ADPH production in dark may be ascribed to the intermittent exposure of reaction </a:t>
            </a:r>
            <a:r>
              <a:rPr lang="en-US" altLang="ko-KR" sz="1100" dirty="0" smtClean="0">
                <a:solidFill>
                  <a:srgbClr val="3333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ixture </a:t>
            </a:r>
            <a:r>
              <a:rPr lang="en-US" altLang="ko-KR" sz="1100" dirty="0">
                <a:solidFill>
                  <a:srgbClr val="3333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 </a:t>
            </a:r>
            <a:r>
              <a:rPr lang="en-US" altLang="ko-KR" sz="1100" dirty="0" smtClean="0">
                <a:solidFill>
                  <a:srgbClr val="3333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ght when </a:t>
            </a:r>
            <a:r>
              <a:rPr lang="en-US" altLang="ko-KR" sz="1100" dirty="0">
                <a:solidFill>
                  <a:srgbClr val="3333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liquots were removed from </a:t>
            </a:r>
            <a:r>
              <a:rPr lang="en-US" altLang="ko-KR" sz="1100" dirty="0" smtClean="0">
                <a:solidFill>
                  <a:srgbClr val="3333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 reaction </a:t>
            </a:r>
            <a:r>
              <a:rPr lang="en-US" altLang="ko-KR" sz="1100" dirty="0">
                <a:solidFill>
                  <a:srgbClr val="3333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essel for assay</a:t>
            </a:r>
            <a:r>
              <a:rPr lang="en-US" altLang="ko-KR" sz="1100" dirty="0" smtClean="0">
                <a:solidFill>
                  <a:srgbClr val="3333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ko-KR" sz="1100" dirty="0">
                <a:solidFill>
                  <a:srgbClr val="3333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TP production in dark </a:t>
            </a:r>
            <a:r>
              <a:rPr lang="en-US" altLang="ko-KR" sz="1100" dirty="0" smtClean="0">
                <a:solidFill>
                  <a:srgbClr val="3333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as explained </a:t>
            </a:r>
            <a:r>
              <a:rPr lang="en-US" altLang="ko-KR" sz="1100" dirty="0">
                <a:solidFill>
                  <a:srgbClr val="3333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y the membrane-associated adenylate kinase that can generate ATP regardless of </a:t>
            </a:r>
            <a:r>
              <a:rPr lang="en-US" altLang="ko-KR" sz="1100" dirty="0" smtClean="0">
                <a:solidFill>
                  <a:srgbClr val="3333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ght [11,12]. </a:t>
            </a:r>
            <a:endParaRPr lang="en-US" sz="1100" dirty="0">
              <a:solidFill>
                <a:srgbClr val="3333FF"/>
              </a:solidFill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961809" y="4171729"/>
            <a:ext cx="9224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(min)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7706393" y="4177473"/>
            <a:ext cx="9224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(min)</a:t>
            </a:r>
          </a:p>
        </p:txBody>
      </p:sp>
    </p:spTree>
    <p:extLst>
      <p:ext uri="{BB962C8B-B14F-4D97-AF65-F5344CB8AC3E}">
        <p14:creationId xmlns:p14="http://schemas.microsoft.com/office/powerpoint/2010/main" val="300844783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직사각형 31"/>
          <p:cNvSpPr/>
          <p:nvPr/>
        </p:nvSpPr>
        <p:spPr>
          <a:xfrm rot="16200000">
            <a:off x="7128837" y="2220779"/>
            <a:ext cx="1834156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ADPH generation rate</a:t>
            </a:r>
          </a:p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mole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n</a:t>
            </a:r>
            <a:r>
              <a:rPr lang="en-US" sz="12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 </a:t>
            </a:r>
            <a:r>
              <a:rPr lang="en-US" altLang="ko-K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l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g</a:t>
            </a:r>
            <a:r>
              <a:rPr lang="en-US" sz="12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31" name="직사각형 30"/>
          <p:cNvSpPr/>
          <p:nvPr/>
        </p:nvSpPr>
        <p:spPr>
          <a:xfrm rot="16200000">
            <a:off x="4196661" y="2214683"/>
            <a:ext cx="1834156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ADPH generation rate</a:t>
            </a:r>
          </a:p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mole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n</a:t>
            </a:r>
            <a:r>
              <a:rPr lang="en-US" sz="12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 </a:t>
            </a:r>
            <a:r>
              <a:rPr lang="en-US" altLang="ko-K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l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g</a:t>
            </a:r>
            <a:r>
              <a:rPr lang="en-US" sz="12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29" name="직사각형 28"/>
          <p:cNvSpPr/>
          <p:nvPr/>
        </p:nvSpPr>
        <p:spPr>
          <a:xfrm rot="16200000">
            <a:off x="825574" y="2217731"/>
            <a:ext cx="1834156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ADPH generation rate</a:t>
            </a:r>
          </a:p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mole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n</a:t>
            </a:r>
            <a:r>
              <a:rPr lang="en-US" sz="12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 </a:t>
            </a:r>
            <a:r>
              <a:rPr lang="en-US" altLang="ko-K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l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g</a:t>
            </a:r>
            <a:r>
              <a:rPr lang="en-US" sz="12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graphicFrame>
        <p:nvGraphicFramePr>
          <p:cNvPr id="40" name="차트 3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37753235"/>
              </p:ext>
            </p:extLst>
          </p:nvPr>
        </p:nvGraphicFramePr>
        <p:xfrm>
          <a:off x="1902746" y="1084982"/>
          <a:ext cx="2609827" cy="29059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8" name="차트 3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53055462"/>
              </p:ext>
            </p:extLst>
          </p:nvPr>
        </p:nvGraphicFramePr>
        <p:xfrm>
          <a:off x="5255747" y="1123974"/>
          <a:ext cx="2130431" cy="272681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7" name="차트 3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2461016"/>
              </p:ext>
            </p:extLst>
          </p:nvPr>
        </p:nvGraphicFramePr>
        <p:xfrm>
          <a:off x="8197042" y="1121752"/>
          <a:ext cx="2286000" cy="27846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5" name="이등변 삼각형 4"/>
          <p:cNvSpPr/>
          <p:nvPr/>
        </p:nvSpPr>
        <p:spPr>
          <a:xfrm>
            <a:off x="2723440" y="3850791"/>
            <a:ext cx="1554480" cy="192022"/>
          </a:xfrm>
          <a:prstGeom prst="triangle">
            <a:avLst>
              <a:gd name="adj" fmla="val 100000"/>
            </a:avLst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직사각형 5"/>
          <p:cNvSpPr/>
          <p:nvPr/>
        </p:nvSpPr>
        <p:spPr>
          <a:xfrm>
            <a:off x="2662817" y="4075943"/>
            <a:ext cx="1618488" cy="192024"/>
          </a:xfrm>
          <a:prstGeom prst="rect">
            <a:avLst/>
          </a:prstGeom>
          <a:solidFill>
            <a:schemeClr val="bg2">
              <a:lumMod val="9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/>
          <p:cNvSpPr txBox="1"/>
          <p:nvPr/>
        </p:nvSpPr>
        <p:spPr>
          <a:xfrm>
            <a:off x="3980267" y="3821433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d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직사각형 7"/>
          <p:cNvSpPr/>
          <p:nvPr/>
        </p:nvSpPr>
        <p:spPr>
          <a:xfrm>
            <a:off x="4281305" y="3562440"/>
            <a:ext cx="52129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µM)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272126" y="4026234"/>
            <a:ext cx="5004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NR</a:t>
            </a:r>
          </a:p>
        </p:txBody>
      </p:sp>
      <p:sp>
        <p:nvSpPr>
          <p:cNvPr id="12" name="이등변 삼각형 11"/>
          <p:cNvSpPr/>
          <p:nvPr/>
        </p:nvSpPr>
        <p:spPr>
          <a:xfrm>
            <a:off x="5708481" y="3860546"/>
            <a:ext cx="1517634" cy="178860"/>
          </a:xfrm>
          <a:prstGeom prst="triangle">
            <a:avLst>
              <a:gd name="adj" fmla="val 100000"/>
            </a:avLst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직사각형 12"/>
          <p:cNvSpPr/>
          <p:nvPr/>
        </p:nvSpPr>
        <p:spPr>
          <a:xfrm>
            <a:off x="5672669" y="4087805"/>
            <a:ext cx="1554480" cy="192024"/>
          </a:xfrm>
          <a:prstGeom prst="rect">
            <a:avLst/>
          </a:prstGeom>
          <a:solidFill>
            <a:schemeClr val="bg2">
              <a:lumMod val="9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TextBox 13"/>
          <p:cNvSpPr txBox="1"/>
          <p:nvPr/>
        </p:nvSpPr>
        <p:spPr>
          <a:xfrm flipH="1">
            <a:off x="6338540" y="4042269"/>
            <a:ext cx="5759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d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6800395" y="3839178"/>
            <a:ext cx="5004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NR</a:t>
            </a:r>
          </a:p>
        </p:txBody>
      </p:sp>
      <p:sp>
        <p:nvSpPr>
          <p:cNvPr id="16" name="직사각형 15"/>
          <p:cNvSpPr/>
          <p:nvPr/>
        </p:nvSpPr>
        <p:spPr>
          <a:xfrm>
            <a:off x="7172084" y="3561607"/>
            <a:ext cx="52129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µM)</a:t>
            </a:r>
          </a:p>
        </p:txBody>
      </p:sp>
      <p:sp>
        <p:nvSpPr>
          <p:cNvPr id="18" name="이등변 삼각형 17"/>
          <p:cNvSpPr/>
          <p:nvPr/>
        </p:nvSpPr>
        <p:spPr>
          <a:xfrm>
            <a:off x="8704665" y="3860880"/>
            <a:ext cx="1517634" cy="178860"/>
          </a:xfrm>
          <a:prstGeom prst="triangle">
            <a:avLst>
              <a:gd name="adj" fmla="val 100000"/>
            </a:avLst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직사각형 18"/>
          <p:cNvSpPr/>
          <p:nvPr/>
        </p:nvSpPr>
        <p:spPr>
          <a:xfrm>
            <a:off x="8668853" y="4075613"/>
            <a:ext cx="1554480" cy="192024"/>
          </a:xfrm>
          <a:prstGeom prst="rect">
            <a:avLst/>
          </a:prstGeom>
          <a:solidFill>
            <a:schemeClr val="bg2">
              <a:lumMod val="9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TextBox 19"/>
          <p:cNvSpPr txBox="1"/>
          <p:nvPr/>
        </p:nvSpPr>
        <p:spPr>
          <a:xfrm flipH="1">
            <a:off x="9224868" y="4044196"/>
            <a:ext cx="9834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d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FNR 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9796579" y="3839512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BS</a:t>
            </a:r>
          </a:p>
        </p:txBody>
      </p:sp>
      <p:sp>
        <p:nvSpPr>
          <p:cNvPr id="25" name="직사각형 24"/>
          <p:cNvSpPr/>
          <p:nvPr/>
        </p:nvSpPr>
        <p:spPr>
          <a:xfrm>
            <a:off x="10274744" y="3569698"/>
            <a:ext cx="51007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Q)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351476" y="913509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4727960" y="913509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7658382" y="912565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4" name="직사각형 3"/>
          <p:cNvSpPr/>
          <p:nvPr/>
        </p:nvSpPr>
        <p:spPr>
          <a:xfrm>
            <a:off x="120580" y="4815976"/>
            <a:ext cx="11656088" cy="136191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sz="11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. S3. Optimization of FNR, </a:t>
            </a:r>
            <a:r>
              <a:rPr lang="en-US" sz="1100" b="1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d</a:t>
            </a:r>
            <a:r>
              <a:rPr lang="en-US" sz="11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nd </a:t>
            </a:r>
            <a:r>
              <a:rPr lang="en-US" sz="1100" b="1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hycobilisome</a:t>
            </a:r>
            <a:r>
              <a:rPr lang="en-US" sz="11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(PBS) for the NADPH generation by TM. 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Varying levels of </a:t>
            </a:r>
            <a:r>
              <a:rPr lang="en-US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d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(A) and FNR (B) were added to the reaction mixture containing TM (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5 </a:t>
            </a:r>
            <a:r>
              <a:rPr lang="el-GR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g </a:t>
            </a:r>
            <a:r>
              <a:rPr lang="en-US" altLang="ko-KR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hl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ko-KR" sz="1100" i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ml</a:t>
            </a:r>
            <a:r>
              <a:rPr lang="en-US" altLang="ko-KR" sz="1100" baseline="30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1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, NADP</a:t>
            </a:r>
            <a:r>
              <a:rPr lang="en-US" altLang="ko-KR" sz="1100" baseline="30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(2 </a:t>
            </a:r>
            <a:r>
              <a:rPr lang="en-US" altLang="ko-KR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M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 and 2 </a:t>
            </a:r>
            <a:r>
              <a:rPr lang="en-US" altLang="ko-KR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M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DP i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n TM buffer, and the reaction mixtures were incubated 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t 30</a:t>
            </a:r>
            <a:r>
              <a:rPr lang="en-US" altLang="ko-KR" sz="1100" dirty="0">
                <a:latin typeface="Cambria Math" panose="02040503050406030204" pitchFamily="18" charset="0"/>
                <a:ea typeface="SimSun" panose="02010600030101010101" pitchFamily="2" charset="-122"/>
                <a:cs typeface="Cambria Math" panose="02040503050406030204" pitchFamily="18" charset="0"/>
              </a:rPr>
              <a:t>℃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under white light (5</a:t>
            </a:r>
            <a:r>
              <a:rPr lang="el-G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0 μ</a:t>
            </a:r>
            <a:r>
              <a:rPr lang="en-US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ol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m</a:t>
            </a:r>
            <a:r>
              <a:rPr lang="en-US" sz="1100" baseline="30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−2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 s</a:t>
            </a:r>
            <a:r>
              <a:rPr lang="en-US" sz="1100" baseline="30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−1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. 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NR was used at 1 µM in (A), whereas </a:t>
            </a:r>
            <a:r>
              <a:rPr lang="en-US" altLang="ko-KR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d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was used at 10 µM in (B). (C) NADPH generation ac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ivity of TM, which had been reconstituted for PBS with varying equivalents (EQ), was determined in TM buffer containing 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 µM FNR, 10 µM </a:t>
            </a:r>
            <a:r>
              <a:rPr lang="en-US" altLang="ko-KR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d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2 </a:t>
            </a:r>
            <a:r>
              <a:rPr lang="en-US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M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NADP</a:t>
            </a:r>
            <a:r>
              <a:rPr lang="en-US" sz="1100" baseline="3000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sz="110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and 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2 </a:t>
            </a:r>
            <a:r>
              <a:rPr lang="en-US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M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DP (TM-NADP</a:t>
            </a:r>
            <a:r>
              <a:rPr lang="en-US" sz="1100" baseline="30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ADP buffer). 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One </a:t>
            </a:r>
            <a:r>
              <a:rPr lang="en-US" altLang="ko-KR" sz="110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EQ 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of PBS consists of </a:t>
            </a:r>
            <a:r>
              <a:rPr lang="en-US" altLang="ko-KR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hycocyanin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t 3.6 µg ml</a:t>
            </a:r>
            <a:r>
              <a:rPr lang="en-US" altLang="ko-KR" sz="1100" baseline="30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1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nd </a:t>
            </a:r>
            <a:r>
              <a:rPr lang="en-US" altLang="ko-KR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llophycocyanin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t 1.8 µg ml</a:t>
            </a:r>
            <a:r>
              <a:rPr lang="en-US" altLang="ko-KR" sz="1100" baseline="30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1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NADPH was 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detected</a:t>
            </a:r>
            <a:r>
              <a:rPr lang="ko-KR" alt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t 340 nm and calculated with an</a:t>
            </a:r>
            <a:r>
              <a:rPr lang="zh-CN" alt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extinction coefficient of 6.22 mM</a:t>
            </a:r>
            <a:r>
              <a:rPr lang="en-US" sz="1100" baseline="30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1 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m</a:t>
            </a:r>
            <a:r>
              <a:rPr lang="en-US" sz="1100" baseline="30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1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 </a:t>
            </a:r>
            <a:endParaRPr lang="en-US" sz="11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2556339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/>
          <p:cNvPicPr>
            <a:picLocks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0"/>
                    </a14:imgEffect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t="18458" r="3527" b="20878"/>
          <a:stretch/>
        </p:blipFill>
        <p:spPr>
          <a:xfrm>
            <a:off x="5087879" y="3637169"/>
            <a:ext cx="2076135" cy="420624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8" name="TextBox 7"/>
          <p:cNvSpPr txBox="1"/>
          <p:nvPr/>
        </p:nvSpPr>
        <p:spPr>
          <a:xfrm rot="18900000">
            <a:off x="5070345" y="2218217"/>
            <a:ext cx="12701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-free extracts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 rot="18900000">
            <a:off x="5328327" y="2024561"/>
            <a:ext cx="18082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809478" y="2823866"/>
            <a:ext cx="13354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lophycocyanin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995571" y="3688711"/>
            <a:ext cx="12334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ycocyanin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 rot="18900000">
            <a:off x="5567365" y="1768341"/>
            <a:ext cx="25253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 (reconstituted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1 EQ of PBS)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9"/>
          <p:cNvSpPr txBox="1"/>
          <p:nvPr/>
        </p:nvSpPr>
        <p:spPr>
          <a:xfrm rot="18900000">
            <a:off x="5869500" y="1715743"/>
            <a:ext cx="26770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 (reconstituted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2.5 EQs of PBS)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9"/>
          <p:cNvSpPr txBox="1"/>
          <p:nvPr/>
        </p:nvSpPr>
        <p:spPr>
          <a:xfrm rot="18900000">
            <a:off x="6196282" y="1712681"/>
            <a:ext cx="2674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 (reconstituted with 5 EQs of PBS)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9"/>
          <p:cNvSpPr txBox="1"/>
          <p:nvPr/>
        </p:nvSpPr>
        <p:spPr>
          <a:xfrm rot="18900000">
            <a:off x="6542473" y="1725632"/>
            <a:ext cx="26458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 (reconstituted with 10 EQs of PBS)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2" name="그림 21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6929" t="72901" r="47732" b="18526"/>
          <a:stretch/>
        </p:blipFill>
        <p:spPr>
          <a:xfrm>
            <a:off x="5087879" y="2824353"/>
            <a:ext cx="2076136" cy="422387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25" name="TextBox 24"/>
          <p:cNvSpPr txBox="1"/>
          <p:nvPr/>
        </p:nvSpPr>
        <p:spPr>
          <a:xfrm>
            <a:off x="5048031" y="3237421"/>
            <a:ext cx="21723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1.0       0.2     0.4     0.6      0.8     0.8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5048031" y="4104774"/>
            <a:ext cx="21082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1.0    0.5   0.5       0.8        0.9      1.1</a:t>
            </a:r>
          </a:p>
        </p:txBody>
      </p:sp>
      <p:cxnSp>
        <p:nvCxnSpPr>
          <p:cNvPr id="27" name="직선 화살표 연결선 26"/>
          <p:cNvCxnSpPr/>
          <p:nvPr/>
        </p:nvCxnSpPr>
        <p:spPr>
          <a:xfrm rot="-600000" flipV="1">
            <a:off x="7187364" y="3797153"/>
            <a:ext cx="144000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" name="직선 화살표 연결선 27"/>
          <p:cNvCxnSpPr/>
          <p:nvPr/>
        </p:nvCxnSpPr>
        <p:spPr>
          <a:xfrm rot="600000" flipV="1">
            <a:off x="7191690" y="3894689"/>
            <a:ext cx="144000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>
            <a:off x="7298391" y="3773836"/>
            <a:ext cx="2584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7295343" y="3607672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직사각형 2"/>
          <p:cNvSpPr/>
          <p:nvPr/>
        </p:nvSpPr>
        <p:spPr>
          <a:xfrm>
            <a:off x="220255" y="5380926"/>
            <a:ext cx="11543359" cy="136191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sz="11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. S4. Determination of PBS contents of cell-free extract, </a:t>
            </a:r>
            <a:r>
              <a:rPr lang="en-US" sz="1100" b="1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M, </a:t>
            </a:r>
            <a:r>
              <a:rPr lang="en-US" sz="11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nd </a:t>
            </a:r>
            <a:r>
              <a:rPr lang="en-US" altLang="ko-KR" sz="11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BS-reconstituted TM (</a:t>
            </a:r>
            <a:r>
              <a:rPr lang="en-US" sz="1100" b="1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TM</a:t>
            </a:r>
            <a:r>
              <a:rPr lang="en-US" sz="11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. 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BS contents of cell-free extracts, </a:t>
            </a:r>
            <a:r>
              <a:rPr lang="en-US" sz="110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M, 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nd </a:t>
            </a:r>
            <a:r>
              <a:rPr lang="en-US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TM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were examined by western immunoblot analysis using antibodies against </a:t>
            </a:r>
            <a:r>
              <a:rPr lang="el-G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α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subunits of </a:t>
            </a:r>
            <a:r>
              <a:rPr lang="en-US" sz="1100" dirty="0" err="1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llophycocyanin</a:t>
            </a:r>
            <a:r>
              <a:rPr lang="en-US" sz="110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(17.4 </a:t>
            </a:r>
            <a:r>
              <a:rPr lang="en-US" sz="1100" dirty="0" err="1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kDa</a:t>
            </a:r>
            <a:r>
              <a:rPr lang="en-US" sz="110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 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nd </a:t>
            </a:r>
            <a:r>
              <a:rPr lang="en-US" sz="1100" dirty="0" err="1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hycocyanin</a:t>
            </a:r>
            <a:r>
              <a:rPr lang="en-US" sz="110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(17.6 </a:t>
            </a:r>
            <a:r>
              <a:rPr lang="en-US" sz="1100" dirty="0" err="1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kDa</a:t>
            </a:r>
            <a:r>
              <a:rPr lang="en-US" sz="110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, 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respectively. 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amples were adjusted to the same amounts of </a:t>
            </a:r>
            <a:r>
              <a:rPr lang="en-US" altLang="ko-KR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hl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ko-KR" sz="1100" i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(1 µg) before </a:t>
            </a:r>
            <a:r>
              <a:rPr lang="en-US" altLang="zh-CN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eparation by 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5% SDS-PAGE. The </a:t>
            </a:r>
            <a:r>
              <a:rPr lang="en-US" altLang="ko-KR" sz="110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utative </a:t>
            </a:r>
            <a:r>
              <a:rPr lang="el-GR" altLang="ko-KR" sz="110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β</a:t>
            </a:r>
            <a:r>
              <a:rPr lang="en-US" sz="110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bunit </a:t>
            </a:r>
            <a:r>
              <a:rPr lang="en-US" sz="110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18.1 </a:t>
            </a:r>
            <a:r>
              <a:rPr lang="en-US" sz="1100" dirty="0" err="1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kDa</a:t>
            </a:r>
            <a:r>
              <a:rPr lang="en-US" sz="110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 of </a:t>
            </a:r>
            <a:r>
              <a:rPr lang="en-US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hycocyanin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was also detected due to the cross reactivity of its </a:t>
            </a:r>
            <a:r>
              <a:rPr lang="el-GR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α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subunit </a:t>
            </a:r>
            <a:r>
              <a:rPr lang="en-US" sz="110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ntibody. T</a:t>
            </a:r>
            <a:r>
              <a:rPr lang="en-US" altLang="ko-KR" sz="110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he two subunits share </a:t>
            </a:r>
            <a:r>
              <a:rPr lang="en-US" altLang="zh-CN" sz="110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50</a:t>
            </a:r>
            <a:r>
              <a:rPr lang="en-US" altLang="zh-CN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% similarity (30% identity</a:t>
            </a:r>
            <a:r>
              <a:rPr lang="en-US" altLang="zh-CN" sz="110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, </a:t>
            </a:r>
            <a:r>
              <a:rPr lang="en-US" altLang="zh-CN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nd the upper band intensity </a:t>
            </a:r>
            <a:r>
              <a:rPr lang="en-US" altLang="zh-CN" sz="110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increased in proportion to the PBS used for reconstitution. </a:t>
            </a:r>
            <a:r>
              <a:rPr lang="en-US" sz="110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he </a:t>
            </a:r>
            <a:r>
              <a:rPr lang="en-US" sz="1100" dirty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relative band intensities of the western immunoblot analyses </a:t>
            </a:r>
            <a:r>
              <a:rPr lang="en-US" altLang="zh-CN" sz="1100" dirty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were</a:t>
            </a:r>
            <a:r>
              <a:rPr lang="en-US" sz="1100" dirty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 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quantified using </a:t>
            </a:r>
            <a:r>
              <a:rPr lang="en-US" altLang="ko-KR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ImageJ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nd </a:t>
            </a:r>
            <a:r>
              <a:rPr lang="en-US" sz="1100" dirty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shown under each lane in comparison with those of </a:t>
            </a:r>
            <a:r>
              <a:rPr lang="en-US" altLang="ko-KR" sz="1100" dirty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cell-free extracts.</a:t>
            </a:r>
            <a:endParaRPr lang="en-US" altLang="ko-KR" sz="11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8984917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차트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75051858"/>
              </p:ext>
            </p:extLst>
          </p:nvPr>
        </p:nvGraphicFramePr>
        <p:xfrm>
          <a:off x="4755610" y="1311403"/>
          <a:ext cx="2615877" cy="27273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0" name="직사각형 9"/>
          <p:cNvSpPr/>
          <p:nvPr/>
        </p:nvSpPr>
        <p:spPr>
          <a:xfrm rot="16200000">
            <a:off x="3652750" y="2401439"/>
            <a:ext cx="1842172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P 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ration</a:t>
            </a:r>
            <a:r>
              <a: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te</a:t>
            </a:r>
          </a:p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mole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n</a:t>
            </a:r>
            <a:r>
              <a:rPr lang="en-US" sz="12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l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g</a:t>
            </a:r>
            <a:r>
              <a:rPr lang="en-US" sz="12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17" name="직사각형 16"/>
          <p:cNvSpPr/>
          <p:nvPr/>
        </p:nvSpPr>
        <p:spPr>
          <a:xfrm>
            <a:off x="21572" y="5232462"/>
            <a:ext cx="12050355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sz="11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. S5. ATP generation rate of </a:t>
            </a:r>
            <a:r>
              <a:rPr lang="en-US" sz="1100" b="1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TM</a:t>
            </a:r>
            <a:r>
              <a:rPr lang="en-US" sz="11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in the presence of FCCP. </a:t>
            </a:r>
            <a:r>
              <a:rPr lang="en-US" sz="1100" dirty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ATP generation rate of </a:t>
            </a:r>
            <a:r>
              <a:rPr lang="en-US" sz="1100" dirty="0" err="1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pTM</a:t>
            </a:r>
            <a:r>
              <a:rPr lang="en-US" sz="1100" dirty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 (</a:t>
            </a:r>
            <a:r>
              <a:rPr lang="en-US" altLang="ko-KR" sz="1100" dirty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5 </a:t>
            </a:r>
            <a:r>
              <a:rPr lang="en-US" altLang="ko-KR" sz="1100" dirty="0" err="1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μg</a:t>
            </a:r>
            <a:r>
              <a:rPr lang="en-US" altLang="ko-KR" sz="1100" dirty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 </a:t>
            </a:r>
            <a:r>
              <a:rPr lang="en-US" altLang="ko-KR" sz="1100" dirty="0" err="1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Chl</a:t>
            </a:r>
            <a:r>
              <a:rPr lang="en-US" altLang="ko-KR" sz="1100" dirty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 </a:t>
            </a:r>
            <a:r>
              <a:rPr lang="en-US" altLang="ko-KR" sz="1100" i="1" dirty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a</a:t>
            </a:r>
            <a:r>
              <a:rPr lang="en-US" altLang="ko-KR" sz="1100" dirty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 ml</a:t>
            </a:r>
            <a:r>
              <a:rPr lang="en-US" altLang="ko-KR" sz="1100" baseline="30000" dirty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-1</a:t>
            </a:r>
            <a:r>
              <a:rPr lang="en-US" altLang="ko-KR" sz="1100" dirty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) </a:t>
            </a:r>
            <a:r>
              <a:rPr lang="en-US" sz="1100" dirty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was determined in TM-NADP</a:t>
            </a:r>
            <a:r>
              <a:rPr lang="en-US" sz="1100" baseline="30000" dirty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+</a:t>
            </a:r>
            <a:r>
              <a:rPr lang="en-US" sz="1100" dirty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-ADP buffer in the presence of varying concentrations of FCCP. Reaction mixtures were incubated 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t 30</a:t>
            </a:r>
            <a:r>
              <a:rPr lang="en-US" altLang="ko-KR" sz="1100" dirty="0">
                <a:latin typeface="Cambria Math" panose="02040503050406030204" pitchFamily="18" charset="0"/>
                <a:ea typeface="SimSun" panose="02010600030101010101" pitchFamily="2" charset="-122"/>
                <a:cs typeface="Cambria Math" panose="02040503050406030204" pitchFamily="18" charset="0"/>
              </a:rPr>
              <a:t>℃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under white light (5</a:t>
            </a:r>
            <a:r>
              <a:rPr lang="el-GR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0 μ</a:t>
            </a:r>
            <a:r>
              <a:rPr lang="en-US" altLang="ko-KR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ol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m</a:t>
            </a:r>
            <a:r>
              <a:rPr lang="en-US" altLang="ko-KR" sz="1100" baseline="30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−2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 s</a:t>
            </a:r>
            <a:r>
              <a:rPr lang="en-US" altLang="ko-KR" sz="1100" baseline="30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−1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. 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TP was detected with ATP assay kit. </a:t>
            </a:r>
            <a:endParaRPr lang="en-US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8" name="직사각형 7"/>
          <p:cNvSpPr/>
          <p:nvPr/>
        </p:nvSpPr>
        <p:spPr>
          <a:xfrm>
            <a:off x="5443553" y="3997938"/>
            <a:ext cx="147497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CCP (µM)</a:t>
            </a:r>
          </a:p>
        </p:txBody>
      </p:sp>
    </p:spTree>
    <p:extLst>
      <p:ext uri="{BB962C8B-B14F-4D97-AF65-F5344CB8AC3E}">
        <p14:creationId xmlns:p14="http://schemas.microsoft.com/office/powerpoint/2010/main" val="85710695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직사각형 49"/>
          <p:cNvSpPr/>
          <p:nvPr/>
        </p:nvSpPr>
        <p:spPr>
          <a:xfrm rot="16200000">
            <a:off x="7294682" y="2630902"/>
            <a:ext cx="1842172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P 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ration</a:t>
            </a:r>
            <a:r>
              <a: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te</a:t>
            </a:r>
          </a:p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mole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n</a:t>
            </a:r>
            <a:r>
              <a:rPr lang="en-US" sz="12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l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g</a:t>
            </a:r>
            <a:r>
              <a:rPr lang="en-US" sz="12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47" name="직사각형 46"/>
          <p:cNvSpPr/>
          <p:nvPr/>
        </p:nvSpPr>
        <p:spPr>
          <a:xfrm rot="16200000">
            <a:off x="580760" y="2645064"/>
            <a:ext cx="1834156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ADPH generation rate</a:t>
            </a:r>
          </a:p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mole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n</a:t>
            </a:r>
            <a:r>
              <a:rPr lang="en-US" sz="12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 </a:t>
            </a:r>
            <a:r>
              <a:rPr lang="en-US" altLang="ko-K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l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g</a:t>
            </a:r>
            <a:r>
              <a:rPr lang="en-US" sz="12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graphicFrame>
        <p:nvGraphicFramePr>
          <p:cNvPr id="3" name="차트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70396797"/>
              </p:ext>
            </p:extLst>
          </p:nvPr>
        </p:nvGraphicFramePr>
        <p:xfrm>
          <a:off x="1498552" y="1365174"/>
          <a:ext cx="3153868" cy="348145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1103179" y="1299143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grpSp>
        <p:nvGrpSpPr>
          <p:cNvPr id="7" name="그룹 6"/>
          <p:cNvGrpSpPr/>
          <p:nvPr/>
        </p:nvGrpSpPr>
        <p:grpSpPr>
          <a:xfrm>
            <a:off x="4404755" y="1555489"/>
            <a:ext cx="3051496" cy="2511694"/>
            <a:chOff x="6485489" y="2527445"/>
            <a:chExt cx="3629197" cy="2511694"/>
          </a:xfrm>
        </p:grpSpPr>
        <p:grpSp>
          <p:nvGrpSpPr>
            <p:cNvPr id="23" name="그룹 22"/>
            <p:cNvGrpSpPr/>
            <p:nvPr/>
          </p:nvGrpSpPr>
          <p:grpSpPr>
            <a:xfrm>
              <a:off x="7376608" y="2527445"/>
              <a:ext cx="2700000" cy="276999"/>
              <a:chOff x="4849729" y="1088195"/>
              <a:chExt cx="1170288" cy="276999"/>
            </a:xfrm>
          </p:grpSpPr>
          <p:cxnSp>
            <p:nvCxnSpPr>
              <p:cNvPr id="39" name="직선 연결선 38"/>
              <p:cNvCxnSpPr/>
              <p:nvPr/>
            </p:nvCxnSpPr>
            <p:spPr>
              <a:xfrm>
                <a:off x="4849729" y="1332179"/>
                <a:ext cx="1167409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0" name="TextBox 39"/>
              <p:cNvSpPr txBox="1"/>
              <p:nvPr/>
            </p:nvSpPr>
            <p:spPr>
              <a:xfrm>
                <a:off x="4849729" y="1088195"/>
                <a:ext cx="11702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EDTA </a:t>
                </a:r>
                <a:r>
                  <a:rPr lang="en-US" altLang="ko-KR" sz="1200" dirty="0">
                    <a:latin typeface="Times New Roman" panose="02020603050405020304" pitchFamily="18" charset="0"/>
                    <a:ea typeface="맑은 고딕" panose="020B0503020000020004" pitchFamily="50" charset="-127"/>
                    <a:cs typeface="Times New Roman" panose="02020603050405020304" pitchFamily="18" charset="0"/>
                  </a:rPr>
                  <a:t>(</a:t>
                </a:r>
                <a:r>
                  <a:rPr lang="en-US" altLang="ko-KR" sz="1200" dirty="0" err="1">
                    <a:latin typeface="Times New Roman" panose="02020603050405020304" pitchFamily="18" charset="0"/>
                    <a:ea typeface="맑은 고딕" panose="020B0503020000020004" pitchFamily="50" charset="-127"/>
                    <a:cs typeface="Times New Roman" panose="02020603050405020304" pitchFamily="18" charset="0"/>
                  </a:rPr>
                  <a:t>mM</a:t>
                </a:r>
                <a:r>
                  <a:rPr lang="en-US" altLang="ko-KR" sz="1200" dirty="0">
                    <a:latin typeface="Times New Roman" panose="02020603050405020304" pitchFamily="18" charset="0"/>
                    <a:ea typeface="맑은 고딕" panose="020B0503020000020004" pitchFamily="50" charset="-127"/>
                    <a:cs typeface="Times New Roman" panose="02020603050405020304" pitchFamily="18" charset="0"/>
                  </a:rPr>
                  <a:t>)</a:t>
                </a:r>
                <a:endParaRPr lang="ko-KR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4" name="TextBox 23"/>
            <p:cNvSpPr txBox="1"/>
            <p:nvPr/>
          </p:nvSpPr>
          <p:spPr>
            <a:xfrm>
              <a:off x="9120099" y="2813202"/>
              <a:ext cx="4781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7394603" y="2810282"/>
              <a:ext cx="4781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8030661" y="2810282"/>
              <a:ext cx="4311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8583244" y="2813202"/>
              <a:ext cx="4781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.5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9636558" y="2810282"/>
              <a:ext cx="4781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9" name="그림 28"/>
            <p:cNvPicPr>
              <a:picLocks/>
            </p:cNvPicPr>
            <p:nvPr/>
          </p:nvPicPr>
          <p:blipFill>
            <a:blip r:embed="rId3">
              <a:grayscl/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4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flipH="1">
              <a:off x="7382658" y="3065030"/>
              <a:ext cx="2700000" cy="270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0" name="그림 29"/>
            <p:cNvPicPr>
              <a:picLocks noChangeAspect="1"/>
            </p:cNvPicPr>
            <p:nvPr/>
          </p:nvPicPr>
          <p:blipFill>
            <a:blip r:embed="rId5">
              <a:grayscl/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4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flipH="1">
              <a:off x="7382658" y="3917757"/>
              <a:ext cx="2700000" cy="270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1" name="그림 30"/>
            <p:cNvPicPr preferRelativeResize="0">
              <a:picLocks/>
            </p:cNvPicPr>
            <p:nvPr/>
          </p:nvPicPr>
          <p:blipFill rotWithShape="1">
            <a:blip r:embed="rId7">
              <a:grayscl/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40000" contrast="40000"/>
                      </a14:imgEffect>
                    </a14:imgLayer>
                  </a14:imgProps>
                </a:ext>
              </a:extLst>
            </a:blip>
            <a:srcRect l="1821" t="328" r="-1" b="-1"/>
            <a:stretch/>
          </p:blipFill>
          <p:spPr>
            <a:xfrm flipH="1">
              <a:off x="7375943" y="3490721"/>
              <a:ext cx="2695451" cy="27134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2" name="그림 31"/>
            <p:cNvPicPr>
              <a:picLocks noChangeAspect="1"/>
            </p:cNvPicPr>
            <p:nvPr/>
          </p:nvPicPr>
          <p:blipFill>
            <a:blip r:embed="rId9">
              <a:grayscl/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4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flipH="1">
              <a:off x="7382658" y="4769139"/>
              <a:ext cx="2700000" cy="270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3" name="그림 32"/>
            <p:cNvPicPr>
              <a:picLocks noChangeAspect="1"/>
            </p:cNvPicPr>
            <p:nvPr/>
          </p:nvPicPr>
          <p:blipFill>
            <a:blip r:embed="rId11">
              <a:grayscl/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4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7378099" y="4343448"/>
              <a:ext cx="2700000" cy="270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4" name="TextBox 33"/>
            <p:cNvSpPr txBox="1"/>
            <p:nvPr/>
          </p:nvSpPr>
          <p:spPr>
            <a:xfrm>
              <a:off x="6497874" y="3087281"/>
              <a:ext cx="9565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altLang="ko-KR" sz="1200" dirty="0">
                  <a:latin typeface="Times New Roman" panose="02020603050405020304" pitchFamily="18" charset="0"/>
                  <a:ea typeface="HY신명조" panose="02030600000101010101" pitchFamily="18" charset="-127"/>
                  <a:cs typeface="Times New Roman" panose="02020603050405020304" pitchFamily="18" charset="0"/>
                </a:rPr>
                <a:t>α</a:t>
              </a:r>
              <a:r>
                <a:rPr lang="en-US" altLang="ko-KR" sz="1200" dirty="0">
                  <a:latin typeface="Times New Roman" panose="02020603050405020304" pitchFamily="18" charset="0"/>
                  <a:ea typeface="HY신명조" panose="02030600000101010101" pitchFamily="18" charset="-127"/>
                  <a:cs typeface="Times New Roman" panose="02020603050405020304" pitchFamily="18" charset="0"/>
                </a:rPr>
                <a:t> subunit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6487615" y="3469532"/>
              <a:ext cx="9565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altLang="ko-KR" sz="1200" dirty="0">
                  <a:latin typeface="Times New Roman" panose="02020603050405020304" pitchFamily="18" charset="0"/>
                  <a:ea typeface="HY신명조" panose="02030600000101010101" pitchFamily="18" charset="-127"/>
                  <a:cs typeface="Times New Roman" panose="02020603050405020304" pitchFamily="18" charset="0"/>
                </a:rPr>
                <a:t>β</a:t>
              </a:r>
              <a:r>
                <a:rPr lang="en-US" altLang="ko-KR" sz="1200" dirty="0">
                  <a:latin typeface="Times New Roman" panose="02020603050405020304" pitchFamily="18" charset="0"/>
                  <a:ea typeface="HY신명조" panose="02030600000101010101" pitchFamily="18" charset="-127"/>
                  <a:cs typeface="Times New Roman" panose="02020603050405020304" pitchFamily="18" charset="0"/>
                </a:rPr>
                <a:t> subunit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6485489" y="3914257"/>
              <a:ext cx="95391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altLang="ko-KR" sz="1200" dirty="0">
                  <a:latin typeface="Times New Roman" panose="02020603050405020304" pitchFamily="18" charset="0"/>
                  <a:ea typeface="HY신명조" panose="02030600000101010101" pitchFamily="18" charset="-127"/>
                  <a:cs typeface="Times New Roman" panose="02020603050405020304" pitchFamily="18" charset="0"/>
                </a:rPr>
                <a:t>γ</a:t>
              </a:r>
              <a:r>
                <a:rPr lang="en-US" altLang="ko-KR" sz="1200" dirty="0">
                  <a:latin typeface="Times New Roman" panose="02020603050405020304" pitchFamily="18" charset="0"/>
                  <a:ea typeface="HY신명조" panose="02030600000101010101" pitchFamily="18" charset="-127"/>
                  <a:cs typeface="Times New Roman" panose="02020603050405020304" pitchFamily="18" charset="0"/>
                </a:rPr>
                <a:t> subunit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6487615" y="4324812"/>
              <a:ext cx="956596" cy="287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altLang="ko-KR" sz="1200" dirty="0">
                  <a:latin typeface="Times New Roman" panose="02020603050405020304" pitchFamily="18" charset="0"/>
                  <a:ea typeface="HY신명조" panose="02030600000101010101" pitchFamily="18" charset="-127"/>
                  <a:cs typeface="Times New Roman" panose="02020603050405020304" pitchFamily="18" charset="0"/>
                </a:rPr>
                <a:t>δ</a:t>
              </a:r>
              <a:r>
                <a:rPr lang="en-US" altLang="ko-KR" sz="1200" dirty="0">
                  <a:latin typeface="Times New Roman" panose="02020603050405020304" pitchFamily="18" charset="0"/>
                  <a:ea typeface="HY신명조" panose="02030600000101010101" pitchFamily="18" charset="-127"/>
                  <a:cs typeface="Times New Roman" panose="02020603050405020304" pitchFamily="18" charset="0"/>
                </a:rPr>
                <a:t> subunit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6528652" y="4753127"/>
              <a:ext cx="89023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altLang="ko-KR" sz="1200" dirty="0">
                  <a:latin typeface="Times New Roman" panose="02020603050405020304" pitchFamily="18" charset="0"/>
                  <a:ea typeface="HY신명조" panose="02030600000101010101" pitchFamily="18" charset="-127"/>
                  <a:cs typeface="Times New Roman" panose="02020603050405020304" pitchFamily="18" charset="0"/>
                </a:rPr>
                <a:t>ε</a:t>
              </a:r>
              <a:r>
                <a:rPr lang="en-US" altLang="ko-KR" sz="1200" dirty="0">
                  <a:latin typeface="Times New Roman" panose="02020603050405020304" pitchFamily="18" charset="0"/>
                  <a:ea typeface="HY신명조" panose="02030600000101010101" pitchFamily="18" charset="-127"/>
                  <a:cs typeface="Times New Roman" panose="02020603050405020304" pitchFamily="18" charset="0"/>
                </a:rPr>
                <a:t> subunit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8" name="TextBox 17"/>
          <p:cNvSpPr txBox="1"/>
          <p:nvPr/>
        </p:nvSpPr>
        <p:spPr>
          <a:xfrm>
            <a:off x="5245804" y="2315772"/>
            <a:ext cx="22685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0            0.7        0.7          0.2        0.04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145820" y="2751095"/>
            <a:ext cx="23326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0           0.5           0.4           0.2          0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5224273" y="3160808"/>
            <a:ext cx="23006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0           0.7          0.6         0.5         0.5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5197273" y="3590251"/>
            <a:ext cx="22685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0           0.5           0.1          0.1         0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5226516" y="4031762"/>
            <a:ext cx="23326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0          0.7          0.4          0.5         0.05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4318538" y="1294963"/>
            <a:ext cx="2702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ko-KR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7828223" y="1298204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graphicFrame>
        <p:nvGraphicFramePr>
          <p:cNvPr id="44" name="차트 4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46751350"/>
              </p:ext>
            </p:extLst>
          </p:nvPr>
        </p:nvGraphicFramePr>
        <p:xfrm>
          <a:off x="8115825" y="1541022"/>
          <a:ext cx="2846654" cy="29469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sp>
        <p:nvSpPr>
          <p:cNvPr id="48" name="TextBox 47"/>
          <p:cNvSpPr txBox="1"/>
          <p:nvPr/>
        </p:nvSpPr>
        <p:spPr>
          <a:xfrm>
            <a:off x="1967540" y="4282615"/>
            <a:ext cx="22702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DTA </a:t>
            </a:r>
            <a:r>
              <a:rPr lang="en-US" altLang="ko-KR" sz="1200" b="1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(</a:t>
            </a:r>
            <a:r>
              <a:rPr lang="en-US" altLang="ko-KR" sz="1200" b="1" dirty="0" err="1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mM</a:t>
            </a:r>
            <a:r>
              <a:rPr lang="en-US" altLang="ko-KR" sz="1200" b="1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)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8643068" y="4279567"/>
            <a:ext cx="22702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DTA </a:t>
            </a:r>
            <a:r>
              <a:rPr lang="en-US" altLang="ko-KR" sz="1200" b="1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(</a:t>
            </a:r>
            <a:r>
              <a:rPr lang="en-US" altLang="ko-KR" sz="1200" b="1" dirty="0" err="1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mM</a:t>
            </a:r>
            <a:r>
              <a:rPr lang="en-US" altLang="ko-KR" sz="1200" b="1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)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직사각형 51"/>
          <p:cNvSpPr/>
          <p:nvPr/>
        </p:nvSpPr>
        <p:spPr>
          <a:xfrm>
            <a:off x="308194" y="4737205"/>
            <a:ext cx="11693298" cy="136191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sz="11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. S6. Characterization of TM treated with varying concentrations of EDTA. </a:t>
            </a:r>
            <a:r>
              <a:rPr lang="en-US" sz="1100" dirty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(A) NADPH generation rate of TM treated with varying concentrations of EDTA was determined 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t 30</a:t>
            </a:r>
            <a:r>
              <a:rPr lang="en-US" altLang="ko-KR" sz="1100" dirty="0">
                <a:latin typeface="Cambria Math" panose="02040503050406030204" pitchFamily="18" charset="0"/>
                <a:ea typeface="SimSun" panose="02010600030101010101" pitchFamily="2" charset="-122"/>
                <a:cs typeface="Cambria Math" panose="02040503050406030204" pitchFamily="18" charset="0"/>
              </a:rPr>
              <a:t>℃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under white light (5</a:t>
            </a:r>
            <a:r>
              <a:rPr lang="el-GR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0 μ</a:t>
            </a:r>
            <a:r>
              <a:rPr lang="en-US" altLang="ko-KR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ol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m</a:t>
            </a:r>
            <a:r>
              <a:rPr lang="en-US" altLang="ko-KR" sz="1100" baseline="30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−2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 s</a:t>
            </a:r>
            <a:r>
              <a:rPr lang="en-US" altLang="ko-KR" sz="1100" baseline="30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−1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</a:t>
            </a:r>
            <a:r>
              <a:rPr lang="en-US" sz="1100" dirty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. The reaction mixture consists of TM at 5 </a:t>
            </a:r>
            <a:r>
              <a:rPr lang="en-US" sz="1100" dirty="0" err="1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μg</a:t>
            </a:r>
            <a:r>
              <a:rPr lang="en-US" sz="1100" dirty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 </a:t>
            </a:r>
            <a:r>
              <a:rPr lang="en-US" sz="1100" dirty="0" err="1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Chl</a:t>
            </a:r>
            <a:r>
              <a:rPr lang="en-US" sz="1100" dirty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 </a:t>
            </a:r>
            <a:r>
              <a:rPr lang="en-US" sz="1100" i="1" dirty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a</a:t>
            </a:r>
            <a:r>
              <a:rPr lang="en-US" sz="1100" dirty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 ml</a:t>
            </a:r>
            <a:r>
              <a:rPr lang="en-US" sz="1100" baseline="30000" dirty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-1</a:t>
            </a:r>
            <a:r>
              <a:rPr lang="en-US" sz="1100" dirty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 in TM-NADP</a:t>
            </a:r>
            <a:r>
              <a:rPr lang="en-US" sz="1100" baseline="30000" dirty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+</a:t>
            </a:r>
            <a:r>
              <a:rPr lang="en-US" sz="1100" dirty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-ADP buffer. (B) 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he residual F</a:t>
            </a:r>
            <a:r>
              <a:rPr lang="en-US" sz="1100" baseline="-25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subunits of EDTA-treated TM at equal amount of </a:t>
            </a:r>
            <a:r>
              <a:rPr lang="en-US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hl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100" i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3 µg)  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were examined by 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5% SDS-PAGE</a:t>
            </a:r>
            <a:r>
              <a:rPr lang="ko-KR" alt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nd 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western immunoblot analysis using antibodies against individual </a:t>
            </a:r>
            <a:r>
              <a:rPr lang="en-US" sz="110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bunits; </a:t>
            </a:r>
            <a:r>
              <a:rPr lang="el-GR" altLang="ko-KR" sz="1100" dirty="0" smtClean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α</a:t>
            </a:r>
            <a:r>
              <a:rPr lang="en-US" altLang="ko-KR" sz="1100" dirty="0" smtClean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 subunit, 54.0 </a:t>
            </a:r>
            <a:r>
              <a:rPr lang="en-US" altLang="ko-KR" sz="1100" dirty="0" err="1" smtClean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kDa</a:t>
            </a:r>
            <a:r>
              <a:rPr lang="en-US" altLang="ko-KR" sz="1100" dirty="0" smtClean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;</a:t>
            </a:r>
            <a:r>
              <a:rPr lang="en-US" altLang="ko-KR" sz="1100" dirty="0" smtClean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 </a:t>
            </a:r>
            <a:r>
              <a:rPr lang="el-GR" altLang="ko-KR" sz="1100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β</a:t>
            </a:r>
            <a:r>
              <a:rPr lang="en-US" altLang="ko-KR" sz="1100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 </a:t>
            </a:r>
            <a:r>
              <a:rPr lang="en-US" altLang="ko-KR" sz="1100" dirty="0" smtClean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subunit, 51.7 </a:t>
            </a:r>
            <a:r>
              <a:rPr lang="en-US" altLang="ko-KR" sz="1100" dirty="0" err="1" smtClean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kDa</a:t>
            </a:r>
            <a:r>
              <a:rPr lang="en-US" altLang="ko-KR" sz="1100" dirty="0" smtClean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;</a:t>
            </a:r>
            <a:r>
              <a:rPr lang="el-GR" altLang="ko-KR" sz="1100" dirty="0" smtClean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 </a:t>
            </a:r>
            <a:r>
              <a:rPr lang="el-GR" altLang="ko-KR" sz="1100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γ</a:t>
            </a:r>
            <a:r>
              <a:rPr lang="en-US" altLang="ko-KR" sz="1100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 </a:t>
            </a:r>
            <a:r>
              <a:rPr lang="en-US" altLang="ko-KR" sz="1100" dirty="0" smtClean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subunit, 34.6 </a:t>
            </a:r>
            <a:r>
              <a:rPr lang="en-US" altLang="ko-KR" sz="1100" dirty="0" err="1" smtClean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kDa</a:t>
            </a:r>
            <a:r>
              <a:rPr lang="en-US" altLang="ko-KR" sz="1100" dirty="0" smtClean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;</a:t>
            </a:r>
            <a:r>
              <a:rPr lang="el-GR" altLang="ko-KR" sz="1100" dirty="0" smtClean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 </a:t>
            </a:r>
            <a:r>
              <a:rPr lang="el-GR" altLang="ko-KR" sz="1100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δ</a:t>
            </a:r>
            <a:r>
              <a:rPr lang="en-US" altLang="ko-KR" sz="1100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 </a:t>
            </a:r>
            <a:r>
              <a:rPr lang="en-US" altLang="ko-KR" sz="1100" dirty="0" smtClean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subunit, 20.1 </a:t>
            </a:r>
            <a:r>
              <a:rPr lang="en-US" altLang="ko-KR" sz="1100" dirty="0" err="1" smtClean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kDa</a:t>
            </a:r>
            <a:r>
              <a:rPr lang="en-US" altLang="ko-KR" sz="1100" dirty="0" smtClean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;</a:t>
            </a:r>
            <a:r>
              <a:rPr lang="el-GR" altLang="ko-KR" sz="1100" dirty="0" smtClean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 </a:t>
            </a:r>
            <a:r>
              <a:rPr lang="el-GR" altLang="ko-KR" sz="1100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ε</a:t>
            </a:r>
            <a:r>
              <a:rPr lang="en-US" altLang="ko-KR" sz="1100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 </a:t>
            </a:r>
            <a:r>
              <a:rPr lang="en-US" altLang="ko-KR" sz="1100" dirty="0" smtClean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subunit, 14.6 </a:t>
            </a:r>
            <a:r>
              <a:rPr lang="en-US" altLang="ko-KR" sz="1100" dirty="0" err="1" smtClean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kDa</a:t>
            </a:r>
            <a:r>
              <a:rPr lang="en-US" altLang="ko-KR" sz="1100" dirty="0" smtClean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.</a:t>
            </a:r>
            <a:r>
              <a:rPr lang="en-US" sz="110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he </a:t>
            </a:r>
            <a:r>
              <a:rPr lang="en-US" altLang="ko-KR" sz="1100" dirty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relative band intensities of the western immunoblot </a:t>
            </a:r>
            <a:r>
              <a:rPr lang="en-US" altLang="zh-CN" sz="1100" dirty="0" smtClean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were</a:t>
            </a:r>
            <a:r>
              <a:rPr lang="en-US" altLang="ko-KR" sz="1100" dirty="0" smtClean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 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quantified using </a:t>
            </a:r>
            <a:r>
              <a:rPr lang="en-US" altLang="ko-KR" sz="1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ImageJ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nd </a:t>
            </a:r>
            <a:r>
              <a:rPr lang="en-US" altLang="ko-KR" sz="1100" dirty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shown under each lane in comparison with those </a:t>
            </a:r>
            <a:r>
              <a:rPr lang="en-US" sz="1100" dirty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without EDTA treatment</a:t>
            </a:r>
            <a:r>
              <a:rPr lang="en-US" sz="1100" dirty="0" smtClean="0">
                <a:latin typeface="Times New Roman" panose="02020603050405020304" pitchFamily="18" charset="0"/>
                <a:ea typeface="Batang" panose="02030600000101010101" pitchFamily="18" charset="-127"/>
                <a:cs typeface="Gulim" panose="020B0600000101010101" pitchFamily="34" charset="-127"/>
              </a:rPr>
              <a:t>. </a:t>
            </a:r>
            <a:r>
              <a:rPr lang="en-US" sz="110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) ATP generation rate of </a:t>
            </a:r>
            <a:r>
              <a:rPr lang="en-US" altLang="ko-KR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EDTA-treated TM </a:t>
            </a:r>
            <a:r>
              <a:rPr lang="en-US" sz="1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was examined as described in (A).</a:t>
            </a:r>
            <a:endParaRPr lang="en-US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091807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052</TotalTime>
  <Words>3550</Words>
  <Application>Microsoft Office PowerPoint</Application>
  <PresentationFormat>Widescreen</PresentationFormat>
  <Paragraphs>295</Paragraphs>
  <Slides>21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1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1</vt:i4>
      </vt:variant>
    </vt:vector>
  </HeadingPairs>
  <TitlesOfParts>
    <vt:vector size="34" baseType="lpstr">
      <vt:lpstr>맑은 고딕</vt:lpstr>
      <vt:lpstr>SimSun</vt:lpstr>
      <vt:lpstr>Arial</vt:lpstr>
      <vt:lpstr>Batang</vt:lpstr>
      <vt:lpstr>Batang</vt:lpstr>
      <vt:lpstr>Calibri</vt:lpstr>
      <vt:lpstr>Calibri Light</vt:lpstr>
      <vt:lpstr>Cambria Math</vt:lpstr>
      <vt:lpstr>等线</vt:lpstr>
      <vt:lpstr>Gulim</vt:lpstr>
      <vt:lpstr>HY신명조</vt:lpstr>
      <vt:lpstr>Times New Roman</vt:lpstr>
      <vt:lpstr>Office 테마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xiaomeng88</dc:creator>
  <cp:lastModifiedBy>Jasmine Mohammed Hidayath</cp:lastModifiedBy>
  <cp:revision>920</cp:revision>
  <dcterms:created xsi:type="dcterms:W3CDTF">2021-11-30T10:26:42Z</dcterms:created>
  <dcterms:modified xsi:type="dcterms:W3CDTF">2022-05-21T10:47:14Z</dcterms:modified>
</cp:coreProperties>
</file>